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Default Extension="png" ContentType="image/png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84" r:id="rId1"/>
  </p:sldMasterIdLst>
  <p:sldIdLst>
    <p:sldId id="259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a="http://schemas.openxmlformats.org/drawingml/2006/main" xmlns:r="http://schemas.openxmlformats.org/officeDocument/2006/relationships" xmlns:p="http://schemas.openxmlformats.org/presentationml/2006/main" xmlns:p15="http://schemas.microsoft.com/office/powerpoint/2012/main" xmlns:mv="urn:schemas-microsoft-com:mac:vml" xmlns:mc="http://schemas.openxmlformats.org/markup-compatibility/2006">
        <p15:guide id="1" orient="horz" userDrawn="1">
          <p15:clr>
            <a:srgbClr val="A4A3A4"/>
          </p15:clr>
        </p15:guide>
        <p15:guide id="2" pos="1457" userDrawn="1">
          <p15:clr>
            <a:srgbClr val="A4A3A4"/>
          </p15:clr>
        </p15:guide>
        <p15:guide id="4" pos="236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extLst>
    <p:ext uri="{E76CE94A-603C-4142-B9EB-6D1370010A27}">
      <p14:discardImageEditData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0"/>
    </p:ext>
    <p:ext uri="{D31A062A-798A-4329-ABDD-BBA856620510}">
      <p14:defaultImageDpi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2767"/>
    </p:ext>
    <p:ext uri="{FD5EFAAD-0ECE-453E-9831-46B23BE46B34}">
      <p15:chartTrackingRefBased xmlns="" xmlns:a="http://schemas.openxmlformats.org/drawingml/2006/main" xmlns:r="http://schemas.openxmlformats.org/officeDocument/2006/relationships" xmlns:p="http://schemas.openxmlformats.org/presentationml/2006/main" xmlns:p15="http://schemas.microsoft.com/office/powerpoint/2012/main" xmlns:mv="urn:schemas-microsoft-com:mac:vml" xmlns:mc="http://schemas.openxmlformats.org/markup-compatibility/2006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 horzBarState="maximized">
    <p:restoredLeft sz="17267"/>
    <p:restoredTop sz="94674"/>
  </p:normalViewPr>
  <p:slideViewPr>
    <p:cSldViewPr snapToGrid="0" snapToObjects="1" showGuides="1">
      <p:cViewPr>
        <p:scale>
          <a:sx n="33" d="100"/>
          <a:sy n="33" d="100"/>
        </p:scale>
        <p:origin x="-2584" y="-800"/>
      </p:cViewPr>
      <p:guideLst>
        <p:guide orient="horz"/>
        <p:guide pos="1457"/>
        <p:guide pos="236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8C7D4-806F-ED46-B1EB-5BF889C518FD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A4BD58-33F7-EB4D-A164-6963A03C4C30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4912302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8C7D4-806F-ED46-B1EB-5BF889C518FD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A4BD58-33F7-EB4D-A164-6963A03C4C30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6783841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8C7D4-806F-ED46-B1EB-5BF889C518FD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A4BD58-33F7-EB4D-A164-6963A03C4C30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5821650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8C7D4-806F-ED46-B1EB-5BF889C518FD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A4BD58-33F7-EB4D-A164-6963A03C4C30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8853568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8C7D4-806F-ED46-B1EB-5BF889C518FD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A4BD58-33F7-EB4D-A164-6963A03C4C30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9302716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8C7D4-806F-ED46-B1EB-5BF889C518FD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A4BD58-33F7-EB4D-A164-6963A03C4C30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2838028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8C7D4-806F-ED46-B1EB-5BF889C518FD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A4BD58-33F7-EB4D-A164-6963A03C4C30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8662514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8C7D4-806F-ED46-B1EB-5BF889C518FD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A4BD58-33F7-EB4D-A164-6963A03C4C30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9617341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8C7D4-806F-ED46-B1EB-5BF889C518FD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A4BD58-33F7-EB4D-A164-6963A03C4C30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8970690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8C7D4-806F-ED46-B1EB-5BF889C518FD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A4BD58-33F7-EB4D-A164-6963A03C4C30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3304632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8C7D4-806F-ED46-B1EB-5BF889C518FD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A4BD58-33F7-EB4D-A164-6963A03C4C30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7520087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08C7D4-806F-ED46-B1EB-5BF889C518FD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A4BD58-33F7-EB4D-A164-6963A03C4C30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455076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jpeg"/><Relationship Id="rId5" Type="http://schemas.openxmlformats.org/officeDocument/2006/relationships/image" Target="../media/image4.jpeg"/><Relationship Id="rId6" Type="http://schemas.openxmlformats.org/officeDocument/2006/relationships/image" Target="../media/image5.jpeg"/><Relationship Id="rId7" Type="http://schemas.openxmlformats.org/officeDocument/2006/relationships/image" Target="../media/image6.jpeg"/><Relationship Id="rId8" Type="http://schemas.openxmlformats.org/officeDocument/2006/relationships/image" Target="../media/image7.jpe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3" name="Grouper 482"/>
          <p:cNvGrpSpPr/>
          <p:nvPr/>
        </p:nvGrpSpPr>
        <p:grpSpPr>
          <a:xfrm>
            <a:off x="157002" y="194768"/>
            <a:ext cx="6400886" cy="9558685"/>
            <a:chOff x="157002" y="194768"/>
            <a:chExt cx="6400886" cy="9558685"/>
          </a:xfrm>
        </p:grpSpPr>
        <p:sp>
          <p:nvSpPr>
            <p:cNvPr id="453" name="TextBox 104">
              <a:extLst>
                <a:ext uri="{FF2B5EF4-FFF2-40B4-BE49-F238E27FC236}">
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CD04F9B-C2D3-F846-A0D3-F6E52DA8EF45}"/>
                </a:ext>
              </a:extLst>
            </p:cNvPr>
            <p:cNvSpPr txBox="1"/>
            <p:nvPr/>
          </p:nvSpPr>
          <p:spPr>
            <a:xfrm>
              <a:off x="157002" y="9322566"/>
              <a:ext cx="6400885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1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6 Fig. 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Operon organization of the </a:t>
              </a:r>
              <a:r>
                <a:rPr lang="en-US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erR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controlled </a:t>
              </a:r>
              <a:r>
                <a:rPr lang="en-US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onB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dependent transporter system locus.</a:t>
              </a:r>
              <a:endParaRPr lang="fr-FR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81" name="Grouper 480"/>
            <p:cNvGrpSpPr/>
            <p:nvPr/>
          </p:nvGrpSpPr>
          <p:grpSpPr>
            <a:xfrm>
              <a:off x="243254" y="194768"/>
              <a:ext cx="6314634" cy="2331184"/>
              <a:chOff x="243254" y="194768"/>
              <a:chExt cx="6314634" cy="2331184"/>
            </a:xfrm>
          </p:grpSpPr>
          <p:grpSp>
            <p:nvGrpSpPr>
              <p:cNvPr id="15" name="Groupe 14">
                <a:extLst>
                  <a:ext uri="{FF2B5EF4-FFF2-40B4-BE49-F238E27FC236}">
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416D916-EEC7-5445-B2AB-B3FA7E845187}"/>
                  </a:ext>
                </a:extLst>
              </p:cNvPr>
              <p:cNvGrpSpPr/>
              <p:nvPr/>
            </p:nvGrpSpPr>
            <p:grpSpPr>
              <a:xfrm>
                <a:off x="362184" y="362296"/>
                <a:ext cx="6195704" cy="2163656"/>
                <a:chOff x="464148" y="1328481"/>
                <a:chExt cx="6195704" cy="2163656"/>
              </a:xfrm>
            </p:grpSpPr>
            <p:grpSp>
              <p:nvGrpSpPr>
                <p:cNvPr id="44" name="Grouper 43"/>
                <p:cNvGrpSpPr/>
                <p:nvPr/>
              </p:nvGrpSpPr>
              <p:grpSpPr>
                <a:xfrm>
                  <a:off x="1229039" y="1956672"/>
                  <a:ext cx="750477" cy="540065"/>
                  <a:chOff x="1365121" y="2232566"/>
                  <a:chExt cx="750477" cy="540065"/>
                </a:xfrm>
              </p:grpSpPr>
              <p:sp>
                <p:nvSpPr>
                  <p:cNvPr id="116" name="TextBox 104"/>
                  <p:cNvSpPr txBox="1"/>
                  <p:nvPr/>
                </p:nvSpPr>
                <p:spPr>
                  <a:xfrm>
                    <a:off x="1365121" y="2403299"/>
                    <a:ext cx="750477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LIMLP</a:t>
                    </a:r>
                  </a:p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_04240</a:t>
                    </a:r>
                  </a:p>
                </p:txBody>
              </p:sp>
              <p:sp>
                <p:nvSpPr>
                  <p:cNvPr id="117" name="TextBox 107"/>
                  <p:cNvSpPr txBox="1"/>
                  <p:nvPr/>
                </p:nvSpPr>
                <p:spPr>
                  <a:xfrm>
                    <a:off x="1429294" y="2232566"/>
                    <a:ext cx="622130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b="1" i="1" dirty="0" err="1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tonB</a:t>
                    </a:r>
                    <a:endParaRPr lang="en-US" sz="1000" b="1" i="1" dirty="0">
                      <a:solidFill>
                        <a:srgbClr val="000000"/>
                      </a:solidFill>
                      <a:latin typeface="Arial"/>
                      <a:cs typeface="Arial"/>
                    </a:endParaRPr>
                  </a:p>
                </p:txBody>
              </p:sp>
            </p:grpSp>
            <p:grpSp>
              <p:nvGrpSpPr>
                <p:cNvPr id="45" name="Grouper 44"/>
                <p:cNvGrpSpPr/>
                <p:nvPr/>
              </p:nvGrpSpPr>
              <p:grpSpPr>
                <a:xfrm>
                  <a:off x="1614722" y="1502051"/>
                  <a:ext cx="649867" cy="552271"/>
                  <a:chOff x="1750804" y="1735555"/>
                  <a:chExt cx="649867" cy="552271"/>
                </a:xfrm>
              </p:grpSpPr>
              <p:sp>
                <p:nvSpPr>
                  <p:cNvPr id="114" name="TextBox 108"/>
                  <p:cNvSpPr txBox="1"/>
                  <p:nvPr/>
                </p:nvSpPr>
                <p:spPr>
                  <a:xfrm>
                    <a:off x="1756895" y="1735555"/>
                    <a:ext cx="637685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b="1" i="1" dirty="0" err="1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exbD</a:t>
                    </a:r>
                    <a:endParaRPr lang="en-US" sz="1000" b="1" i="1" dirty="0">
                      <a:solidFill>
                        <a:srgbClr val="000000"/>
                      </a:solidFill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15" name="TextBox 104"/>
                  <p:cNvSpPr txBox="1"/>
                  <p:nvPr/>
                </p:nvSpPr>
                <p:spPr>
                  <a:xfrm>
                    <a:off x="1750804" y="1918494"/>
                    <a:ext cx="649867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LIMLP</a:t>
                    </a:r>
                  </a:p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_04245</a:t>
                    </a:r>
                  </a:p>
                </p:txBody>
              </p:sp>
            </p:grpSp>
            <p:grpSp>
              <p:nvGrpSpPr>
                <p:cNvPr id="46" name="Grouper 45"/>
                <p:cNvGrpSpPr/>
                <p:nvPr/>
              </p:nvGrpSpPr>
              <p:grpSpPr>
                <a:xfrm>
                  <a:off x="1983815" y="1951450"/>
                  <a:ext cx="642569" cy="545287"/>
                  <a:chOff x="2119897" y="2184175"/>
                  <a:chExt cx="642569" cy="545287"/>
                </a:xfrm>
              </p:grpSpPr>
              <p:sp>
                <p:nvSpPr>
                  <p:cNvPr id="112" name="TextBox 113"/>
                  <p:cNvSpPr txBox="1"/>
                  <p:nvPr/>
                </p:nvSpPr>
                <p:spPr>
                  <a:xfrm>
                    <a:off x="2119897" y="2184175"/>
                    <a:ext cx="642569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b="1" i="1" dirty="0" err="1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exbD</a:t>
                    </a:r>
                    <a:endParaRPr lang="en-US" sz="1000" b="1" i="1" dirty="0">
                      <a:solidFill>
                        <a:srgbClr val="000000"/>
                      </a:solidFill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13" name="TextBox 104"/>
                  <p:cNvSpPr txBox="1"/>
                  <p:nvPr/>
                </p:nvSpPr>
                <p:spPr>
                  <a:xfrm>
                    <a:off x="2133116" y="2360130"/>
                    <a:ext cx="617167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LIMLP</a:t>
                    </a:r>
                  </a:p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_04250</a:t>
                    </a:r>
                  </a:p>
                </p:txBody>
              </p:sp>
            </p:grpSp>
            <p:grpSp>
              <p:nvGrpSpPr>
                <p:cNvPr id="47" name="Grouper 46"/>
                <p:cNvGrpSpPr/>
                <p:nvPr/>
              </p:nvGrpSpPr>
              <p:grpSpPr>
                <a:xfrm>
                  <a:off x="2369239" y="1328481"/>
                  <a:ext cx="617167" cy="548123"/>
                  <a:chOff x="2505321" y="1561985"/>
                  <a:chExt cx="617167" cy="548123"/>
                </a:xfrm>
              </p:grpSpPr>
              <p:sp>
                <p:nvSpPr>
                  <p:cNvPr id="110" name="TextBox 114"/>
                  <p:cNvSpPr txBox="1"/>
                  <p:nvPr/>
                </p:nvSpPr>
                <p:spPr>
                  <a:xfrm>
                    <a:off x="2533938" y="1561985"/>
                    <a:ext cx="559932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b="1" i="1" dirty="0" err="1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exbB</a:t>
                    </a:r>
                    <a:endParaRPr lang="en-US" sz="1000" b="1" i="1" dirty="0">
                      <a:solidFill>
                        <a:srgbClr val="000000"/>
                      </a:solidFill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11" name="TextBox 104"/>
                  <p:cNvSpPr txBox="1"/>
                  <p:nvPr/>
                </p:nvSpPr>
                <p:spPr>
                  <a:xfrm>
                    <a:off x="2505321" y="1740776"/>
                    <a:ext cx="617167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LIMLP</a:t>
                    </a:r>
                  </a:p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_04255</a:t>
                    </a:r>
                  </a:p>
                </p:txBody>
              </p:sp>
            </p:grpSp>
            <p:sp>
              <p:nvSpPr>
                <p:cNvPr id="109" name="TextBox 104"/>
                <p:cNvSpPr txBox="1"/>
                <p:nvPr/>
              </p:nvSpPr>
              <p:spPr>
                <a:xfrm>
                  <a:off x="2793181" y="1919647"/>
                  <a:ext cx="61716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900" b="1" dirty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LIMLP</a:t>
                  </a:r>
                </a:p>
                <a:p>
                  <a:pPr algn="ctr"/>
                  <a:r>
                    <a:rPr lang="en-US" sz="900" b="1" dirty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_04260</a:t>
                  </a:r>
                </a:p>
              </p:txBody>
            </p:sp>
            <p:sp>
              <p:nvSpPr>
                <p:cNvPr id="107" name="TextBox 104"/>
                <p:cNvSpPr txBox="1"/>
                <p:nvPr/>
              </p:nvSpPr>
              <p:spPr>
                <a:xfrm>
                  <a:off x="3229571" y="1842429"/>
                  <a:ext cx="61716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900" b="1" dirty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LIMLP</a:t>
                  </a:r>
                </a:p>
                <a:p>
                  <a:pPr algn="ctr"/>
                  <a:r>
                    <a:rPr lang="en-US" sz="900" b="1" dirty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_04265</a:t>
                  </a:r>
                </a:p>
              </p:txBody>
            </p:sp>
            <p:sp>
              <p:nvSpPr>
                <p:cNvPr id="105" name="TextBox 104"/>
                <p:cNvSpPr txBox="1"/>
                <p:nvPr/>
              </p:nvSpPr>
              <p:spPr>
                <a:xfrm>
                  <a:off x="3908971" y="2127405"/>
                  <a:ext cx="61716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900" b="1" dirty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LIMLP</a:t>
                  </a:r>
                </a:p>
                <a:p>
                  <a:pPr algn="ctr"/>
                  <a:r>
                    <a:rPr lang="en-US" sz="900" b="1" dirty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_04270</a:t>
                  </a:r>
                </a:p>
              </p:txBody>
            </p:sp>
            <p:sp>
              <p:nvSpPr>
                <p:cNvPr id="103" name="TextBox 104"/>
                <p:cNvSpPr txBox="1"/>
                <p:nvPr/>
              </p:nvSpPr>
              <p:spPr>
                <a:xfrm>
                  <a:off x="4511512" y="2127405"/>
                  <a:ext cx="61716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900" b="1" dirty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LIMLP</a:t>
                  </a:r>
                </a:p>
                <a:p>
                  <a:pPr algn="ctr"/>
                  <a:r>
                    <a:rPr lang="en-US" sz="900" b="1" dirty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_04275</a:t>
                  </a:r>
                </a:p>
              </p:txBody>
            </p:sp>
            <p:grpSp>
              <p:nvGrpSpPr>
                <p:cNvPr id="52" name="Grouper 51"/>
                <p:cNvGrpSpPr/>
                <p:nvPr/>
              </p:nvGrpSpPr>
              <p:grpSpPr>
                <a:xfrm>
                  <a:off x="3738197" y="1808101"/>
                  <a:ext cx="1942481" cy="688636"/>
                  <a:chOff x="3825834" y="2009305"/>
                  <a:chExt cx="1942481" cy="688636"/>
                </a:xfrm>
              </p:grpSpPr>
              <p:sp>
                <p:nvSpPr>
                  <p:cNvPr id="100" name="TextBox 122"/>
                  <p:cNvSpPr txBox="1"/>
                  <p:nvPr/>
                </p:nvSpPr>
                <p:spPr>
                  <a:xfrm>
                    <a:off x="5103529" y="2150868"/>
                    <a:ext cx="664786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b="1" i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lipL48</a:t>
                    </a:r>
                  </a:p>
                </p:txBody>
              </p:sp>
              <p:sp>
                <p:nvSpPr>
                  <p:cNvPr id="101" name="TextBox 104"/>
                  <p:cNvSpPr txBox="1"/>
                  <p:nvPr/>
                </p:nvSpPr>
                <p:spPr>
                  <a:xfrm>
                    <a:off x="5127339" y="2328609"/>
                    <a:ext cx="617167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LIMLP</a:t>
                    </a:r>
                  </a:p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_04280</a:t>
                    </a:r>
                  </a:p>
                </p:txBody>
              </p:sp>
              <p:sp>
                <p:nvSpPr>
                  <p:cNvPr id="484" name="TextBox 122"/>
                  <p:cNvSpPr txBox="1"/>
                  <p:nvPr/>
                </p:nvSpPr>
                <p:spPr>
                  <a:xfrm>
                    <a:off x="3825834" y="2009305"/>
                    <a:ext cx="987467" cy="4001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b="1" i="1" dirty="0" err="1" smtClean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tonB-dpt</a:t>
                    </a:r>
                    <a:r>
                      <a:rPr lang="en-US" sz="1000" b="1" i="1" dirty="0" smtClean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 </a:t>
                    </a:r>
                    <a:r>
                      <a:rPr lang="en-US" sz="1000" b="1" i="1" dirty="0" smtClean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receptor</a:t>
                    </a:r>
                    <a:endParaRPr lang="en-US" sz="1000" b="1" i="1" dirty="0">
                      <a:solidFill>
                        <a:srgbClr val="000000"/>
                      </a:solidFill>
                      <a:latin typeface="Arial"/>
                      <a:cs typeface="Arial"/>
                    </a:endParaRPr>
                  </a:p>
                </p:txBody>
              </p:sp>
            </p:grpSp>
            <p:sp>
              <p:nvSpPr>
                <p:cNvPr id="99" name="TextBox 104"/>
                <p:cNvSpPr txBox="1"/>
                <p:nvPr/>
              </p:nvSpPr>
              <p:spPr>
                <a:xfrm>
                  <a:off x="5564692" y="2127405"/>
                  <a:ext cx="61716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900" b="1" dirty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LIMLP</a:t>
                  </a:r>
                </a:p>
                <a:p>
                  <a:pPr algn="ctr"/>
                  <a:r>
                    <a:rPr lang="en-US" sz="900" b="1" dirty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_04285</a:t>
                  </a:r>
                </a:p>
              </p:txBody>
            </p:sp>
            <p:sp>
              <p:nvSpPr>
                <p:cNvPr id="96" name="TextBox 104"/>
                <p:cNvSpPr txBox="1"/>
                <p:nvPr/>
              </p:nvSpPr>
              <p:spPr>
                <a:xfrm>
                  <a:off x="6042685" y="2127405"/>
                  <a:ext cx="61716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900" b="1" dirty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LIMLP</a:t>
                  </a:r>
                </a:p>
                <a:p>
                  <a:pPr algn="ctr"/>
                  <a:r>
                    <a:rPr lang="en-US" sz="900" b="1" dirty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_04290</a:t>
                  </a:r>
                </a:p>
              </p:txBody>
            </p:sp>
            <p:sp>
              <p:nvSpPr>
                <p:cNvPr id="93" name="TextBox 104"/>
                <p:cNvSpPr txBox="1"/>
                <p:nvPr/>
              </p:nvSpPr>
              <p:spPr>
                <a:xfrm>
                  <a:off x="500896" y="2127405"/>
                  <a:ext cx="75047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900" b="1" dirty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LIMLP</a:t>
                  </a:r>
                </a:p>
                <a:p>
                  <a:pPr algn="ctr"/>
                  <a:r>
                    <a:rPr lang="en-US" sz="900" b="1" dirty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_04235</a:t>
                  </a:r>
                </a:p>
              </p:txBody>
            </p:sp>
            <p:sp>
              <p:nvSpPr>
                <p:cNvPr id="95" name="TextBox 104"/>
                <p:cNvSpPr txBox="1"/>
                <p:nvPr/>
              </p:nvSpPr>
              <p:spPr>
                <a:xfrm>
                  <a:off x="2569433" y="2212808"/>
                  <a:ext cx="116842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900" b="1" dirty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LEPIMA_CI0931</a:t>
                  </a:r>
                </a:p>
              </p:txBody>
            </p:sp>
            <p:grpSp>
              <p:nvGrpSpPr>
                <p:cNvPr id="57" name="Grouper 56"/>
                <p:cNvGrpSpPr/>
                <p:nvPr/>
              </p:nvGrpSpPr>
              <p:grpSpPr>
                <a:xfrm>
                  <a:off x="464148" y="2407018"/>
                  <a:ext cx="6083989" cy="322171"/>
                  <a:chOff x="600230" y="2640522"/>
                  <a:chExt cx="6083989" cy="322171"/>
                </a:xfrm>
              </p:grpSpPr>
              <p:cxnSp>
                <p:nvCxnSpPr>
                  <p:cNvPr id="79" name="Straight Connector 125"/>
                  <p:cNvCxnSpPr/>
                  <p:nvPr/>
                </p:nvCxnSpPr>
                <p:spPr>
                  <a:xfrm flipV="1">
                    <a:off x="600230" y="2831617"/>
                    <a:ext cx="6083989" cy="2876"/>
                  </a:xfrm>
                  <a:prstGeom prst="line">
                    <a:avLst/>
                  </a:prstGeom>
                  <a:ln w="19050" cap="flat" cmpd="sng" algn="ctr">
                    <a:solidFill>
                      <a:schemeClr val="dk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80" name="Down Arrow 126"/>
                  <p:cNvSpPr>
                    <a:spLocks noChangeAspect="1"/>
                  </p:cNvSpPr>
                  <p:nvPr/>
                </p:nvSpPr>
                <p:spPr>
                  <a:xfrm rot="5400000">
                    <a:off x="2615527" y="2636813"/>
                    <a:ext cx="259273" cy="392483"/>
                  </a:xfrm>
                  <a:prstGeom prst="downArrow">
                    <a:avLst>
                      <a:gd name="adj1" fmla="val 56250"/>
                      <a:gd name="adj2" fmla="val 50000"/>
                    </a:avLst>
                  </a:prstGeom>
                  <a:solidFill>
                    <a:srgbClr val="0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endParaRPr lang="en-US">
                      <a:solidFill>
                        <a:srgbClr val="000000"/>
                      </a:solidFill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81" name="Down Arrow 127"/>
                  <p:cNvSpPr>
                    <a:spLocks/>
                  </p:cNvSpPr>
                  <p:nvPr/>
                </p:nvSpPr>
                <p:spPr>
                  <a:xfrm rot="5400000">
                    <a:off x="2216266" y="2689056"/>
                    <a:ext cx="259273" cy="287998"/>
                  </a:xfrm>
                  <a:prstGeom prst="downArrow">
                    <a:avLst/>
                  </a:prstGeom>
                  <a:solidFill>
                    <a:srgbClr val="0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endParaRPr lang="en-US">
                      <a:solidFill>
                        <a:srgbClr val="000000"/>
                      </a:solidFill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82" name="Down Arrow 128"/>
                  <p:cNvSpPr>
                    <a:spLocks/>
                  </p:cNvSpPr>
                  <p:nvPr/>
                </p:nvSpPr>
                <p:spPr>
                  <a:xfrm rot="5400000">
                    <a:off x="1921529" y="2689056"/>
                    <a:ext cx="259273" cy="287998"/>
                  </a:xfrm>
                  <a:prstGeom prst="downArrow">
                    <a:avLst/>
                  </a:prstGeom>
                  <a:solidFill>
                    <a:srgbClr val="0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endParaRPr lang="en-US" sz="600" b="1">
                      <a:solidFill>
                        <a:srgbClr val="000000"/>
                      </a:solidFill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83" name="Down Arrow 129"/>
                  <p:cNvSpPr>
                    <a:spLocks noChangeAspect="1"/>
                  </p:cNvSpPr>
                  <p:nvPr/>
                </p:nvSpPr>
                <p:spPr>
                  <a:xfrm rot="5400000">
                    <a:off x="1610894" y="2671769"/>
                    <a:ext cx="259273" cy="322573"/>
                  </a:xfrm>
                  <a:prstGeom prst="downArrow">
                    <a:avLst/>
                  </a:prstGeom>
                  <a:solidFill>
                    <a:srgbClr val="0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endParaRPr lang="en-US" sz="600" b="1" i="1">
                      <a:solidFill>
                        <a:srgbClr val="000000"/>
                      </a:solidFill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84" name="Down Arrow 130"/>
                  <p:cNvSpPr>
                    <a:spLocks/>
                  </p:cNvSpPr>
                  <p:nvPr/>
                </p:nvSpPr>
                <p:spPr>
                  <a:xfrm rot="5400000">
                    <a:off x="4830010" y="2653056"/>
                    <a:ext cx="259273" cy="359997"/>
                  </a:xfrm>
                  <a:prstGeom prst="downArrow">
                    <a:avLst>
                      <a:gd name="adj1" fmla="val 56250"/>
                      <a:gd name="adj2" fmla="val 50000"/>
                    </a:avLst>
                  </a:prstGeom>
                  <a:solidFill>
                    <a:srgbClr val="0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endParaRPr lang="en-US">
                      <a:solidFill>
                        <a:srgbClr val="000000"/>
                      </a:solidFill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85" name="Down Arrow 131"/>
                  <p:cNvSpPr>
                    <a:spLocks/>
                  </p:cNvSpPr>
                  <p:nvPr/>
                </p:nvSpPr>
                <p:spPr>
                  <a:xfrm rot="5400000">
                    <a:off x="3482679" y="2761058"/>
                    <a:ext cx="259273" cy="143998"/>
                  </a:xfrm>
                  <a:prstGeom prst="downArrow">
                    <a:avLst>
                      <a:gd name="adj1" fmla="val 56250"/>
                      <a:gd name="adj2" fmla="val 50000"/>
                    </a:avLst>
                  </a:prstGeom>
                  <a:solidFill>
                    <a:srgbClr val="0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endParaRPr lang="en-US">
                      <a:solidFill>
                        <a:srgbClr val="000000"/>
                      </a:solidFill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86" name="Down Arrow 132"/>
                  <p:cNvSpPr>
                    <a:spLocks noChangeAspect="1"/>
                  </p:cNvSpPr>
                  <p:nvPr/>
                </p:nvSpPr>
                <p:spPr>
                  <a:xfrm rot="5400000">
                    <a:off x="3102225" y="2696214"/>
                    <a:ext cx="259273" cy="273683"/>
                  </a:xfrm>
                  <a:prstGeom prst="downArrow">
                    <a:avLst>
                      <a:gd name="adj1" fmla="val 56250"/>
                      <a:gd name="adj2" fmla="val 50000"/>
                    </a:avLst>
                  </a:prstGeom>
                  <a:solidFill>
                    <a:srgbClr val="0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endParaRPr lang="en-US">
                      <a:solidFill>
                        <a:srgbClr val="000000"/>
                      </a:solidFill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87" name="Down Arrow 133"/>
                  <p:cNvSpPr>
                    <a:spLocks/>
                  </p:cNvSpPr>
                  <p:nvPr/>
                </p:nvSpPr>
                <p:spPr>
                  <a:xfrm rot="5400000">
                    <a:off x="4218471" y="2382323"/>
                    <a:ext cx="259273" cy="901466"/>
                  </a:xfrm>
                  <a:prstGeom prst="downArrow">
                    <a:avLst>
                      <a:gd name="adj1" fmla="val 56250"/>
                      <a:gd name="adj2" fmla="val 50000"/>
                    </a:avLst>
                  </a:prstGeom>
                  <a:solidFill>
                    <a:srgbClr val="0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endParaRPr lang="en-US">
                      <a:solidFill>
                        <a:srgbClr val="000000"/>
                      </a:solidFill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88" name="Down Arrow 134"/>
                  <p:cNvSpPr>
                    <a:spLocks/>
                  </p:cNvSpPr>
                  <p:nvPr/>
                </p:nvSpPr>
                <p:spPr>
                  <a:xfrm rot="5400000">
                    <a:off x="5354157" y="2581055"/>
                    <a:ext cx="259273" cy="503999"/>
                  </a:xfrm>
                  <a:prstGeom prst="downArrow">
                    <a:avLst>
                      <a:gd name="adj1" fmla="val 56250"/>
                      <a:gd name="adj2" fmla="val 50000"/>
                    </a:avLst>
                  </a:prstGeom>
                  <a:solidFill>
                    <a:srgbClr val="0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endParaRPr lang="en-US">
                      <a:solidFill>
                        <a:srgbClr val="000000"/>
                      </a:solidFill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89" name="Down Arrow 135"/>
                  <p:cNvSpPr>
                    <a:spLocks/>
                  </p:cNvSpPr>
                  <p:nvPr/>
                </p:nvSpPr>
                <p:spPr>
                  <a:xfrm rot="5400000">
                    <a:off x="5874645" y="2726687"/>
                    <a:ext cx="259273" cy="212734"/>
                  </a:xfrm>
                  <a:prstGeom prst="downArrow">
                    <a:avLst>
                      <a:gd name="adj1" fmla="val 56250"/>
                      <a:gd name="adj2" fmla="val 50000"/>
                    </a:avLst>
                  </a:prstGeom>
                  <a:solidFill>
                    <a:srgbClr val="0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endParaRPr lang="en-US">
                      <a:solidFill>
                        <a:srgbClr val="000000"/>
                      </a:solidFill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90" name="Down Arrow 135"/>
                  <p:cNvSpPr>
                    <a:spLocks/>
                  </p:cNvSpPr>
                  <p:nvPr/>
                </p:nvSpPr>
                <p:spPr>
                  <a:xfrm rot="5400000">
                    <a:off x="6329682" y="2752263"/>
                    <a:ext cx="259273" cy="140734"/>
                  </a:xfrm>
                  <a:prstGeom prst="downArrow">
                    <a:avLst>
                      <a:gd name="adj1" fmla="val 56250"/>
                      <a:gd name="adj2" fmla="val 50000"/>
                    </a:avLst>
                  </a:prstGeom>
                  <a:solidFill>
                    <a:srgbClr val="0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endParaRPr lang="en-US">
                      <a:solidFill>
                        <a:srgbClr val="000000"/>
                      </a:solidFill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91" name="Down Arrow 129"/>
                  <p:cNvSpPr>
                    <a:spLocks/>
                  </p:cNvSpPr>
                  <p:nvPr/>
                </p:nvSpPr>
                <p:spPr>
                  <a:xfrm rot="16200000" flipH="1">
                    <a:off x="930010" y="2491769"/>
                    <a:ext cx="259273" cy="682570"/>
                  </a:xfrm>
                  <a:prstGeom prst="downArrow">
                    <a:avLst/>
                  </a:prstGeom>
                  <a:solidFill>
                    <a:srgbClr val="0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endParaRPr lang="en-US" sz="600" b="1" i="1">
                      <a:solidFill>
                        <a:srgbClr val="000000"/>
                      </a:solidFill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92" name="Down Arrow 135"/>
                  <p:cNvSpPr>
                    <a:spLocks/>
                  </p:cNvSpPr>
                  <p:nvPr/>
                </p:nvSpPr>
                <p:spPr>
                  <a:xfrm rot="16200000" flipH="1">
                    <a:off x="3249095" y="2624154"/>
                    <a:ext cx="107998" cy="140734"/>
                  </a:xfrm>
                  <a:prstGeom prst="downArrow">
                    <a:avLst>
                      <a:gd name="adj1" fmla="val 56250"/>
                      <a:gd name="adj2" fmla="val 50000"/>
                    </a:avLst>
                  </a:prstGeom>
                  <a:solidFill>
                    <a:srgbClr val="0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endParaRPr lang="en-US">
                      <a:solidFill>
                        <a:srgbClr val="000000"/>
                      </a:solidFill>
                      <a:latin typeface="Arial"/>
                      <a:cs typeface="Arial"/>
                    </a:endParaRPr>
                  </a:p>
                </p:txBody>
              </p:sp>
            </p:grpSp>
            <p:sp>
              <p:nvSpPr>
                <p:cNvPr id="58" name="TextBox 25"/>
                <p:cNvSpPr txBox="1"/>
                <p:nvPr/>
              </p:nvSpPr>
              <p:spPr>
                <a:xfrm>
                  <a:off x="2015320" y="2641481"/>
                  <a:ext cx="135171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Arial"/>
                      <a:cs typeface="Arial"/>
                    </a:rPr>
                    <a:t>3</a:t>
                  </a:r>
                </a:p>
              </p:txBody>
            </p:sp>
            <p:sp>
              <p:nvSpPr>
                <p:cNvPr id="59" name="TextBox 25"/>
                <p:cNvSpPr txBox="1"/>
                <p:nvPr/>
              </p:nvSpPr>
              <p:spPr>
                <a:xfrm>
                  <a:off x="1229038" y="2641481"/>
                  <a:ext cx="255770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Arial"/>
                      <a:cs typeface="Arial"/>
                    </a:rPr>
                    <a:t>666</a:t>
                  </a:r>
                </a:p>
              </p:txBody>
            </p:sp>
            <p:sp>
              <p:nvSpPr>
                <p:cNvPr id="60" name="TextBox 25"/>
                <p:cNvSpPr txBox="1"/>
                <p:nvPr/>
              </p:nvSpPr>
              <p:spPr>
                <a:xfrm flipH="1">
                  <a:off x="1693424" y="2641481"/>
                  <a:ext cx="152400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Arial"/>
                      <a:cs typeface="Arial"/>
                    </a:rPr>
                    <a:t>4</a:t>
                  </a:r>
                </a:p>
              </p:txBody>
            </p:sp>
            <p:sp>
              <p:nvSpPr>
                <p:cNvPr id="61" name="TextBox 25"/>
                <p:cNvSpPr txBox="1"/>
                <p:nvPr/>
              </p:nvSpPr>
              <p:spPr>
                <a:xfrm>
                  <a:off x="2328271" y="2641481"/>
                  <a:ext cx="135171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Arial"/>
                      <a:cs typeface="Arial"/>
                    </a:rPr>
                    <a:t>27</a:t>
                  </a:r>
                </a:p>
              </p:txBody>
            </p:sp>
            <p:sp>
              <p:nvSpPr>
                <p:cNvPr id="62" name="TextBox 25"/>
                <p:cNvSpPr txBox="1"/>
                <p:nvPr/>
              </p:nvSpPr>
              <p:spPr>
                <a:xfrm>
                  <a:off x="2771937" y="2641481"/>
                  <a:ext cx="255770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Arial"/>
                      <a:cs typeface="Arial"/>
                    </a:rPr>
                    <a:t>362</a:t>
                  </a:r>
                </a:p>
              </p:txBody>
            </p:sp>
            <p:sp>
              <p:nvSpPr>
                <p:cNvPr id="63" name="TextBox 25"/>
                <p:cNvSpPr txBox="1"/>
                <p:nvPr/>
              </p:nvSpPr>
              <p:spPr>
                <a:xfrm>
                  <a:off x="3197027" y="2641481"/>
                  <a:ext cx="255770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Arial"/>
                      <a:cs typeface="Arial"/>
                    </a:rPr>
                    <a:t>224</a:t>
                  </a:r>
                </a:p>
              </p:txBody>
            </p:sp>
            <p:sp>
              <p:nvSpPr>
                <p:cNvPr id="64" name="TextBox 25"/>
                <p:cNvSpPr txBox="1"/>
                <p:nvPr/>
              </p:nvSpPr>
              <p:spPr>
                <a:xfrm>
                  <a:off x="3538155" y="2641481"/>
                  <a:ext cx="255770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Arial"/>
                      <a:cs typeface="Arial"/>
                    </a:rPr>
                    <a:t>322</a:t>
                  </a:r>
                </a:p>
              </p:txBody>
            </p:sp>
            <p:sp>
              <p:nvSpPr>
                <p:cNvPr id="65" name="TextBox 25"/>
                <p:cNvSpPr txBox="1"/>
                <p:nvPr/>
              </p:nvSpPr>
              <p:spPr>
                <a:xfrm>
                  <a:off x="5013365" y="2641481"/>
                  <a:ext cx="135171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Arial"/>
                      <a:cs typeface="Arial"/>
                    </a:rPr>
                    <a:t>74</a:t>
                  </a:r>
                </a:p>
              </p:txBody>
            </p:sp>
            <p:sp>
              <p:nvSpPr>
                <p:cNvPr id="66" name="TextBox 25"/>
                <p:cNvSpPr txBox="1"/>
                <p:nvPr/>
              </p:nvSpPr>
              <p:spPr>
                <a:xfrm>
                  <a:off x="5574608" y="2641481"/>
                  <a:ext cx="260608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Arial"/>
                      <a:cs typeface="Arial"/>
                    </a:rPr>
                    <a:t>157</a:t>
                  </a:r>
                </a:p>
              </p:txBody>
            </p:sp>
            <p:sp>
              <p:nvSpPr>
                <p:cNvPr id="67" name="TextBox 25"/>
                <p:cNvSpPr txBox="1"/>
                <p:nvPr/>
              </p:nvSpPr>
              <p:spPr>
                <a:xfrm>
                  <a:off x="5998589" y="2641481"/>
                  <a:ext cx="255770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Arial"/>
                      <a:cs typeface="Arial"/>
                    </a:rPr>
                    <a:t>677</a:t>
                  </a:r>
                </a:p>
              </p:txBody>
            </p:sp>
            <p:grpSp>
              <p:nvGrpSpPr>
                <p:cNvPr id="3" name="Groupe 2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70CC68E-3B5B-2042-9692-EEE1A69EBE27}"/>
                    </a:ext>
                  </a:extLst>
                </p:cNvPr>
                <p:cNvGrpSpPr/>
                <p:nvPr/>
              </p:nvGrpSpPr>
              <p:grpSpPr>
                <a:xfrm>
                  <a:off x="1193825" y="2849876"/>
                  <a:ext cx="380114" cy="291244"/>
                  <a:chOff x="1193825" y="2849876"/>
                  <a:chExt cx="380114" cy="291244"/>
                </a:xfrm>
              </p:grpSpPr>
              <p:sp>
                <p:nvSpPr>
                  <p:cNvPr id="145" name="TextBox 25"/>
                  <p:cNvSpPr txBox="1"/>
                  <p:nvPr/>
                </p:nvSpPr>
                <p:spPr>
                  <a:xfrm>
                    <a:off x="1274795" y="2878651"/>
                    <a:ext cx="218174" cy="12311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1</a:t>
                    </a:r>
                  </a:p>
                </p:txBody>
              </p:sp>
              <p:sp>
                <p:nvSpPr>
                  <p:cNvPr id="68" name="TextBox 25"/>
                  <p:cNvSpPr txBox="1"/>
                  <p:nvPr/>
                </p:nvSpPr>
                <p:spPr>
                  <a:xfrm>
                    <a:off x="1224719" y="3002621"/>
                    <a:ext cx="318327" cy="13849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(303)</a:t>
                    </a:r>
                  </a:p>
                </p:txBody>
              </p:sp>
              <p:cxnSp>
                <p:nvCxnSpPr>
                  <p:cNvPr id="146" name="Connecteur droit 145"/>
                  <p:cNvCxnSpPr/>
                  <p:nvPr/>
                </p:nvCxnSpPr>
                <p:spPr>
                  <a:xfrm>
                    <a:off x="1193825" y="2849876"/>
                    <a:ext cx="380114" cy="0"/>
                  </a:xfrm>
                  <a:prstGeom prst="line">
                    <a:avLst/>
                  </a:prstGeom>
                  <a:ln>
                    <a:solidFill>
                      <a:srgbClr val="00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6" name="Groupe 5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D534F90-5178-FC42-9564-4F63BD6D96AF}"/>
                    </a:ext>
                  </a:extLst>
                </p:cNvPr>
                <p:cNvGrpSpPr/>
                <p:nvPr/>
              </p:nvGrpSpPr>
              <p:grpSpPr>
                <a:xfrm>
                  <a:off x="1640759" y="2849876"/>
                  <a:ext cx="324000" cy="286664"/>
                  <a:chOff x="1640759" y="2849876"/>
                  <a:chExt cx="324000" cy="286664"/>
                </a:xfrm>
              </p:grpSpPr>
              <p:sp>
                <p:nvSpPr>
                  <p:cNvPr id="69" name="TextBox 25"/>
                  <p:cNvSpPr txBox="1"/>
                  <p:nvPr/>
                </p:nvSpPr>
                <p:spPr>
                  <a:xfrm>
                    <a:off x="1643596" y="2998041"/>
                    <a:ext cx="318327" cy="13849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(190)</a:t>
                    </a:r>
                  </a:p>
                </p:txBody>
              </p:sp>
              <p:cxnSp>
                <p:nvCxnSpPr>
                  <p:cNvPr id="147" name="Connecteur droit 146"/>
                  <p:cNvCxnSpPr/>
                  <p:nvPr/>
                </p:nvCxnSpPr>
                <p:spPr>
                  <a:xfrm>
                    <a:off x="1640759" y="2849876"/>
                    <a:ext cx="324000" cy="0"/>
                  </a:xfrm>
                  <a:prstGeom prst="line">
                    <a:avLst/>
                  </a:prstGeom>
                  <a:ln>
                    <a:solidFill>
                      <a:srgbClr val="00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48" name="TextBox 25"/>
                  <p:cNvSpPr txBox="1"/>
                  <p:nvPr/>
                </p:nvSpPr>
                <p:spPr>
                  <a:xfrm>
                    <a:off x="1693672" y="2874071"/>
                    <a:ext cx="218174" cy="12311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2</a:t>
                    </a:r>
                  </a:p>
                </p:txBody>
              </p:sp>
            </p:grpSp>
            <p:sp>
              <p:nvSpPr>
                <p:cNvPr id="143" name="TextBox 25"/>
                <p:cNvSpPr txBox="1"/>
                <p:nvPr/>
              </p:nvSpPr>
              <p:spPr>
                <a:xfrm>
                  <a:off x="1968906" y="3230527"/>
                  <a:ext cx="218174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3</a:t>
                  </a:r>
                </a:p>
              </p:txBody>
            </p:sp>
            <p:sp>
              <p:nvSpPr>
                <p:cNvPr id="70" name="TextBox 25"/>
                <p:cNvSpPr txBox="1"/>
                <p:nvPr/>
              </p:nvSpPr>
              <p:spPr>
                <a:xfrm>
                  <a:off x="1918830" y="3353638"/>
                  <a:ext cx="318327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sz="900" b="1" dirty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(243)</a:t>
                  </a:r>
                </a:p>
              </p:txBody>
            </p:sp>
            <p:cxnSp>
              <p:nvCxnSpPr>
                <p:cNvPr id="149" name="Connecteur droit 148"/>
                <p:cNvCxnSpPr/>
                <p:nvPr/>
              </p:nvCxnSpPr>
              <p:spPr>
                <a:xfrm>
                  <a:off x="1897993" y="3196659"/>
                  <a:ext cx="360000" cy="0"/>
                </a:xfrm>
                <a:prstGeom prst="line">
                  <a:avLst/>
                </a:prstGeom>
                <a:ln>
                  <a:solidFill>
                    <a:srgbClr val="000000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7" name="Groupe 6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FC1C060-FA41-9846-B95C-6B42265F4B4E}"/>
                    </a:ext>
                  </a:extLst>
                </p:cNvPr>
                <p:cNvGrpSpPr/>
                <p:nvPr/>
              </p:nvGrpSpPr>
              <p:grpSpPr>
                <a:xfrm>
                  <a:off x="2220235" y="2845644"/>
                  <a:ext cx="349198" cy="296334"/>
                  <a:chOff x="2220235" y="2845644"/>
                  <a:chExt cx="349198" cy="296334"/>
                </a:xfrm>
              </p:grpSpPr>
              <p:sp>
                <p:nvSpPr>
                  <p:cNvPr id="141" name="TextBox 25"/>
                  <p:cNvSpPr txBox="1"/>
                  <p:nvPr/>
                </p:nvSpPr>
                <p:spPr>
                  <a:xfrm>
                    <a:off x="2285747" y="2871042"/>
                    <a:ext cx="218174" cy="12311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4</a:t>
                    </a:r>
                  </a:p>
                </p:txBody>
              </p:sp>
              <p:sp>
                <p:nvSpPr>
                  <p:cNvPr id="71" name="TextBox 25"/>
                  <p:cNvSpPr txBox="1"/>
                  <p:nvPr/>
                </p:nvSpPr>
                <p:spPr>
                  <a:xfrm>
                    <a:off x="2235671" y="3003479"/>
                    <a:ext cx="318327" cy="13849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(292)</a:t>
                    </a:r>
                  </a:p>
                </p:txBody>
              </p:sp>
              <p:cxnSp>
                <p:nvCxnSpPr>
                  <p:cNvPr id="150" name="Connecteur droit 149"/>
                  <p:cNvCxnSpPr/>
                  <p:nvPr/>
                </p:nvCxnSpPr>
                <p:spPr>
                  <a:xfrm flipV="1">
                    <a:off x="2220235" y="2845644"/>
                    <a:ext cx="349198" cy="8465"/>
                  </a:xfrm>
                  <a:prstGeom prst="line">
                    <a:avLst/>
                  </a:prstGeom>
                  <a:ln>
                    <a:solidFill>
                      <a:srgbClr val="00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8" name="Groupe 7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229C6C5-75C0-CC42-944E-78B2D6A55505}"/>
                    </a:ext>
                  </a:extLst>
                </p:cNvPr>
                <p:cNvGrpSpPr/>
                <p:nvPr/>
              </p:nvGrpSpPr>
              <p:grpSpPr>
                <a:xfrm>
                  <a:off x="2683472" y="2849876"/>
                  <a:ext cx="431999" cy="276684"/>
                  <a:chOff x="2683472" y="2849876"/>
                  <a:chExt cx="431999" cy="276684"/>
                </a:xfrm>
              </p:grpSpPr>
              <p:sp>
                <p:nvSpPr>
                  <p:cNvPr id="72" name="TextBox 25"/>
                  <p:cNvSpPr txBox="1"/>
                  <p:nvPr/>
                </p:nvSpPr>
                <p:spPr>
                  <a:xfrm>
                    <a:off x="2746755" y="2988061"/>
                    <a:ext cx="318327" cy="13849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(114)</a:t>
                    </a:r>
                  </a:p>
                </p:txBody>
              </p:sp>
              <p:sp>
                <p:nvSpPr>
                  <p:cNvPr id="43" name="TextBox 25"/>
                  <p:cNvSpPr txBox="1"/>
                  <p:nvPr/>
                </p:nvSpPr>
                <p:spPr>
                  <a:xfrm>
                    <a:off x="2795688" y="2887119"/>
                    <a:ext cx="218174" cy="12311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5</a:t>
                    </a:r>
                  </a:p>
                </p:txBody>
              </p:sp>
              <p:cxnSp>
                <p:nvCxnSpPr>
                  <p:cNvPr id="151" name="Connecteur droit 150"/>
                  <p:cNvCxnSpPr/>
                  <p:nvPr/>
                </p:nvCxnSpPr>
                <p:spPr>
                  <a:xfrm>
                    <a:off x="2683472" y="2849876"/>
                    <a:ext cx="431999" cy="0"/>
                  </a:xfrm>
                  <a:prstGeom prst="line">
                    <a:avLst/>
                  </a:prstGeom>
                  <a:ln>
                    <a:solidFill>
                      <a:srgbClr val="00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9" name="Groupe 8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069E2A3-256A-2040-98DF-9A5755C9C92F}"/>
                    </a:ext>
                  </a:extLst>
                </p:cNvPr>
                <p:cNvGrpSpPr/>
                <p:nvPr/>
              </p:nvGrpSpPr>
              <p:grpSpPr>
                <a:xfrm>
                  <a:off x="3146207" y="2849876"/>
                  <a:ext cx="359997" cy="296760"/>
                  <a:chOff x="3146207" y="2849876"/>
                  <a:chExt cx="359997" cy="296760"/>
                </a:xfrm>
              </p:grpSpPr>
              <p:sp>
                <p:nvSpPr>
                  <p:cNvPr id="73" name="TextBox 25"/>
                  <p:cNvSpPr txBox="1"/>
                  <p:nvPr/>
                </p:nvSpPr>
                <p:spPr>
                  <a:xfrm>
                    <a:off x="3167042" y="3008137"/>
                    <a:ext cx="318327" cy="13849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(191)</a:t>
                    </a:r>
                  </a:p>
                </p:txBody>
              </p:sp>
              <p:sp>
                <p:nvSpPr>
                  <p:cNvPr id="37" name="TextBox 25"/>
                  <p:cNvSpPr txBox="1"/>
                  <p:nvPr/>
                </p:nvSpPr>
                <p:spPr>
                  <a:xfrm>
                    <a:off x="3217118" y="2880368"/>
                    <a:ext cx="218174" cy="12311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6</a:t>
                    </a:r>
                  </a:p>
                </p:txBody>
              </p:sp>
              <p:cxnSp>
                <p:nvCxnSpPr>
                  <p:cNvPr id="152" name="Connecteur droit 151"/>
                  <p:cNvCxnSpPr/>
                  <p:nvPr/>
                </p:nvCxnSpPr>
                <p:spPr>
                  <a:xfrm>
                    <a:off x="3146207" y="2849876"/>
                    <a:ext cx="359997" cy="0"/>
                  </a:xfrm>
                  <a:prstGeom prst="line">
                    <a:avLst/>
                  </a:prstGeom>
                  <a:ln>
                    <a:solidFill>
                      <a:srgbClr val="00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0" name="Groupe 9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D3F0C98-5B73-2248-A6FB-02A86E42BD76}"/>
                    </a:ext>
                  </a:extLst>
                </p:cNvPr>
                <p:cNvGrpSpPr/>
                <p:nvPr/>
              </p:nvGrpSpPr>
              <p:grpSpPr>
                <a:xfrm>
                  <a:off x="3566231" y="2849876"/>
                  <a:ext cx="358241" cy="303510"/>
                  <a:chOff x="3566231" y="2849876"/>
                  <a:chExt cx="358241" cy="303510"/>
                </a:xfrm>
              </p:grpSpPr>
              <p:sp>
                <p:nvSpPr>
                  <p:cNvPr id="74" name="TextBox 25"/>
                  <p:cNvSpPr txBox="1"/>
                  <p:nvPr/>
                </p:nvSpPr>
                <p:spPr>
                  <a:xfrm>
                    <a:off x="3569754" y="3014887"/>
                    <a:ext cx="318327" cy="13849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(148)</a:t>
                    </a:r>
                  </a:p>
                </p:txBody>
              </p:sp>
              <p:sp>
                <p:nvSpPr>
                  <p:cNvPr id="41" name="TextBox 25"/>
                  <p:cNvSpPr txBox="1"/>
                  <p:nvPr/>
                </p:nvSpPr>
                <p:spPr>
                  <a:xfrm>
                    <a:off x="3619830" y="2887118"/>
                    <a:ext cx="218174" cy="12311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7</a:t>
                    </a:r>
                  </a:p>
                </p:txBody>
              </p:sp>
              <p:cxnSp>
                <p:nvCxnSpPr>
                  <p:cNvPr id="154" name="Connecteur droit 153"/>
                  <p:cNvCxnSpPr/>
                  <p:nvPr/>
                </p:nvCxnSpPr>
                <p:spPr>
                  <a:xfrm>
                    <a:off x="3566231" y="2849876"/>
                    <a:ext cx="358241" cy="0"/>
                  </a:xfrm>
                  <a:prstGeom prst="line">
                    <a:avLst/>
                  </a:prstGeom>
                  <a:ln>
                    <a:solidFill>
                      <a:srgbClr val="00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1" name="Groupe 10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BF4FCA7-A472-0842-BA12-C7170F1604A6}"/>
                    </a:ext>
                  </a:extLst>
                </p:cNvPr>
                <p:cNvGrpSpPr/>
                <p:nvPr/>
              </p:nvGrpSpPr>
              <p:grpSpPr>
                <a:xfrm>
                  <a:off x="4517645" y="2849876"/>
                  <a:ext cx="344095" cy="307320"/>
                  <a:chOff x="4517645" y="2849876"/>
                  <a:chExt cx="344095" cy="307320"/>
                </a:xfrm>
              </p:grpSpPr>
              <p:sp>
                <p:nvSpPr>
                  <p:cNvPr id="75" name="TextBox 25"/>
                  <p:cNvSpPr txBox="1"/>
                  <p:nvPr/>
                </p:nvSpPr>
                <p:spPr>
                  <a:xfrm>
                    <a:off x="4530529" y="3018697"/>
                    <a:ext cx="318327" cy="13849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(267)</a:t>
                    </a:r>
                  </a:p>
                </p:txBody>
              </p:sp>
              <p:sp>
                <p:nvSpPr>
                  <p:cNvPr id="39" name="TextBox 25"/>
                  <p:cNvSpPr txBox="1"/>
                  <p:nvPr/>
                </p:nvSpPr>
                <p:spPr>
                  <a:xfrm>
                    <a:off x="4580605" y="2895586"/>
                    <a:ext cx="218174" cy="12311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8</a:t>
                    </a:r>
                  </a:p>
                </p:txBody>
              </p:sp>
              <p:cxnSp>
                <p:nvCxnSpPr>
                  <p:cNvPr id="156" name="Connecteur droit 155"/>
                  <p:cNvCxnSpPr/>
                  <p:nvPr/>
                </p:nvCxnSpPr>
                <p:spPr>
                  <a:xfrm>
                    <a:off x="4517645" y="2849876"/>
                    <a:ext cx="344095" cy="0"/>
                  </a:xfrm>
                  <a:prstGeom prst="line">
                    <a:avLst/>
                  </a:prstGeom>
                  <a:ln>
                    <a:solidFill>
                      <a:srgbClr val="00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2" name="Groupe 11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1EEA70B-7BFC-9E40-B3CC-7F3F126C39DC}"/>
                    </a:ext>
                  </a:extLst>
                </p:cNvPr>
                <p:cNvGrpSpPr/>
                <p:nvPr/>
              </p:nvGrpSpPr>
              <p:grpSpPr>
                <a:xfrm>
                  <a:off x="4892712" y="2849876"/>
                  <a:ext cx="466241" cy="291986"/>
                  <a:chOff x="4892712" y="2849876"/>
                  <a:chExt cx="466241" cy="291986"/>
                </a:xfrm>
              </p:grpSpPr>
              <p:sp>
                <p:nvSpPr>
                  <p:cNvPr id="119" name="TextBox 25"/>
                  <p:cNvSpPr txBox="1"/>
                  <p:nvPr/>
                </p:nvSpPr>
                <p:spPr>
                  <a:xfrm flipH="1">
                    <a:off x="5031012" y="2880252"/>
                    <a:ext cx="167613" cy="12311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9</a:t>
                    </a:r>
                  </a:p>
                </p:txBody>
              </p:sp>
              <p:sp>
                <p:nvSpPr>
                  <p:cNvPr id="76" name="TextBox 25"/>
                  <p:cNvSpPr txBox="1"/>
                  <p:nvPr/>
                </p:nvSpPr>
                <p:spPr>
                  <a:xfrm>
                    <a:off x="4955655" y="3003363"/>
                    <a:ext cx="318327" cy="13849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(258)</a:t>
                    </a:r>
                  </a:p>
                </p:txBody>
              </p:sp>
              <p:cxnSp>
                <p:nvCxnSpPr>
                  <p:cNvPr id="160" name="Connecteur droit 159"/>
                  <p:cNvCxnSpPr/>
                  <p:nvPr/>
                </p:nvCxnSpPr>
                <p:spPr>
                  <a:xfrm>
                    <a:off x="4892712" y="2849876"/>
                    <a:ext cx="466241" cy="0"/>
                  </a:xfrm>
                  <a:prstGeom prst="line">
                    <a:avLst/>
                  </a:prstGeom>
                  <a:ln>
                    <a:solidFill>
                      <a:srgbClr val="00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3" name="Groupe 12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A3339DB-214F-AC4F-906A-D5D38B41F18D}"/>
                    </a:ext>
                  </a:extLst>
                </p:cNvPr>
                <p:cNvGrpSpPr/>
                <p:nvPr/>
              </p:nvGrpSpPr>
              <p:grpSpPr>
                <a:xfrm>
                  <a:off x="5473790" y="2849876"/>
                  <a:ext cx="466241" cy="298852"/>
                  <a:chOff x="5473790" y="2849876"/>
                  <a:chExt cx="466241" cy="298852"/>
                </a:xfrm>
              </p:grpSpPr>
              <p:sp>
                <p:nvSpPr>
                  <p:cNvPr id="121" name="TextBox 25"/>
                  <p:cNvSpPr txBox="1"/>
                  <p:nvPr/>
                </p:nvSpPr>
                <p:spPr>
                  <a:xfrm>
                    <a:off x="5590516" y="2887118"/>
                    <a:ext cx="218174" cy="12311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10</a:t>
                    </a:r>
                  </a:p>
                </p:txBody>
              </p:sp>
              <p:sp>
                <p:nvSpPr>
                  <p:cNvPr id="77" name="TextBox 25"/>
                  <p:cNvSpPr txBox="1"/>
                  <p:nvPr/>
                </p:nvSpPr>
                <p:spPr>
                  <a:xfrm>
                    <a:off x="5540440" y="3010229"/>
                    <a:ext cx="318327" cy="13849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(233)</a:t>
                    </a:r>
                  </a:p>
                </p:txBody>
              </p:sp>
              <p:cxnSp>
                <p:nvCxnSpPr>
                  <p:cNvPr id="162" name="Connecteur droit 161"/>
                  <p:cNvCxnSpPr/>
                  <p:nvPr/>
                </p:nvCxnSpPr>
                <p:spPr>
                  <a:xfrm>
                    <a:off x="5473790" y="2849876"/>
                    <a:ext cx="466241" cy="0"/>
                  </a:xfrm>
                  <a:prstGeom prst="line">
                    <a:avLst/>
                  </a:prstGeom>
                  <a:ln>
                    <a:solidFill>
                      <a:srgbClr val="00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4" name="Groupe 13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23C5DF8-B74B-E142-BDA1-064027DCDB91}"/>
                    </a:ext>
                  </a:extLst>
                </p:cNvPr>
                <p:cNvGrpSpPr/>
                <p:nvPr/>
              </p:nvGrpSpPr>
              <p:grpSpPr>
                <a:xfrm>
                  <a:off x="5966324" y="2950250"/>
                  <a:ext cx="430241" cy="265409"/>
                  <a:chOff x="5966324" y="2950250"/>
                  <a:chExt cx="430241" cy="265409"/>
                </a:xfrm>
              </p:grpSpPr>
              <p:sp>
                <p:nvSpPr>
                  <p:cNvPr id="137" name="TextBox 25"/>
                  <p:cNvSpPr txBox="1"/>
                  <p:nvPr/>
                </p:nvSpPr>
                <p:spPr>
                  <a:xfrm>
                    <a:off x="6072357" y="2950250"/>
                    <a:ext cx="218174" cy="12311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11</a:t>
                    </a:r>
                  </a:p>
                </p:txBody>
              </p:sp>
              <p:sp>
                <p:nvSpPr>
                  <p:cNvPr id="78" name="TextBox 25"/>
                  <p:cNvSpPr txBox="1"/>
                  <p:nvPr/>
                </p:nvSpPr>
                <p:spPr>
                  <a:xfrm>
                    <a:off x="6022281" y="3077160"/>
                    <a:ext cx="318327" cy="13849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(259)</a:t>
                    </a:r>
                  </a:p>
                </p:txBody>
              </p:sp>
              <p:cxnSp>
                <p:nvCxnSpPr>
                  <p:cNvPr id="163" name="Connecteur droit 162"/>
                  <p:cNvCxnSpPr/>
                  <p:nvPr/>
                </p:nvCxnSpPr>
                <p:spPr>
                  <a:xfrm>
                    <a:off x="5966324" y="2950250"/>
                    <a:ext cx="430241" cy="0"/>
                  </a:xfrm>
                  <a:prstGeom prst="line">
                    <a:avLst/>
                  </a:prstGeom>
                  <a:ln>
                    <a:solidFill>
                      <a:srgbClr val="00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479" name="ZoneTexte 478">
                <a:extLst>
                  <a:ext uri="{FF2B5EF4-FFF2-40B4-BE49-F238E27FC236}">
                    <a16:creationId xmlns:mc="http://schemas.openxmlformats.org/markup-compatibility/2006" xmlns:mv="urn:schemas-microsoft-com:mac:vml"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E93FB91A-18A8-AD4F-9214-A76DD0BC2D3E}"/>
                  </a:ext>
                </a:extLst>
              </p:cNvPr>
              <p:cNvSpPr txBox="1"/>
              <p:nvPr/>
            </p:nvSpPr>
            <p:spPr>
              <a:xfrm>
                <a:off x="243254" y="194768"/>
                <a:ext cx="33214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600" b="1" dirty="0">
                    <a:latin typeface="Arial"/>
                    <a:cs typeface="Arial"/>
                  </a:rPr>
                  <a:t>A</a:t>
                </a:r>
              </a:p>
            </p:txBody>
          </p:sp>
        </p:grpSp>
        <p:grpSp>
          <p:nvGrpSpPr>
            <p:cNvPr id="482" name="Grouper 481"/>
            <p:cNvGrpSpPr/>
            <p:nvPr/>
          </p:nvGrpSpPr>
          <p:grpSpPr>
            <a:xfrm>
              <a:off x="242903" y="2563156"/>
              <a:ext cx="6122108" cy="6580720"/>
              <a:chOff x="242903" y="2740956"/>
              <a:chExt cx="6122108" cy="6580720"/>
            </a:xfrm>
          </p:grpSpPr>
          <p:grpSp>
            <p:nvGrpSpPr>
              <p:cNvPr id="25" name="Groupe 24">
                <a:extLst>
                  <a:ext uri="{FF2B5EF4-FFF2-40B4-BE49-F238E27FC236}">
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3C74811-CF75-AA4A-A9EB-97241CC6A5AF}"/>
                  </a:ext>
                </a:extLst>
              </p:cNvPr>
              <p:cNvGrpSpPr/>
              <p:nvPr/>
            </p:nvGrpSpPr>
            <p:grpSpPr>
              <a:xfrm>
                <a:off x="413134" y="2840192"/>
                <a:ext cx="1568955" cy="2054469"/>
                <a:chOff x="-2065728" y="3052791"/>
                <a:chExt cx="1568955" cy="2054469"/>
              </a:xfrm>
            </p:grpSpPr>
            <p:sp>
              <p:nvSpPr>
                <p:cNvPr id="214" name="TextBox 25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69619DC-F6DB-CD43-9A0E-A915916CC779}"/>
                    </a:ext>
                  </a:extLst>
                </p:cNvPr>
                <p:cNvSpPr txBox="1"/>
                <p:nvPr/>
              </p:nvSpPr>
              <p:spPr>
                <a:xfrm>
                  <a:off x="-1366491" y="3052791"/>
                  <a:ext cx="841715" cy="2769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sz="900" b="1" dirty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1</a:t>
                  </a:r>
                </a:p>
                <a:p>
                  <a:pPr algn="ctr"/>
                  <a:r>
                    <a:rPr lang="en-US" sz="900" b="1" dirty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(303 </a:t>
                  </a:r>
                  <a:r>
                    <a:rPr lang="en-US" sz="900" b="1" dirty="0" err="1">
                      <a:solidFill>
                        <a:srgbClr val="000000"/>
                      </a:solidFill>
                      <a:latin typeface="Arial"/>
                      <a:cs typeface="Arial"/>
                    </a:rPr>
                    <a:t>bp</a:t>
                  </a:r>
                  <a:r>
                    <a:rPr lang="en-US" sz="900" b="1" dirty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)</a:t>
                  </a:r>
                </a:p>
              </p:txBody>
            </p:sp>
            <p:grpSp>
              <p:nvGrpSpPr>
                <p:cNvPr id="22" name="Groupe 21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6194EFC-F064-9F4D-82DA-984D2DE8F1EE}"/>
                    </a:ext>
                  </a:extLst>
                </p:cNvPr>
                <p:cNvGrpSpPr/>
                <p:nvPr/>
              </p:nvGrpSpPr>
              <p:grpSpPr>
                <a:xfrm>
                  <a:off x="-1394495" y="3398273"/>
                  <a:ext cx="897722" cy="233545"/>
                  <a:chOff x="-1394495" y="3398273"/>
                  <a:chExt cx="897722" cy="233545"/>
                </a:xfrm>
              </p:grpSpPr>
              <p:sp>
                <p:nvSpPr>
                  <p:cNvPr id="211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77E0513-BAEC-8C44-80AF-8BB0C4E2A9A9}"/>
                      </a:ext>
                    </a:extLst>
                  </p:cNvPr>
                  <p:cNvSpPr txBox="1"/>
                  <p:nvPr/>
                </p:nvSpPr>
                <p:spPr>
                  <a:xfrm>
                    <a:off x="-1135344" y="3398273"/>
                    <a:ext cx="391930" cy="12311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dirty="0" err="1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cDNA</a:t>
                    </a:r>
                    <a:endParaRPr lang="en-US" sz="800" b="1" dirty="0">
                      <a:solidFill>
                        <a:srgbClr val="000000"/>
                      </a:solidFill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13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50D40DB-EEA7-0D41-9630-20CF2D64A807}"/>
                      </a:ext>
                    </a:extLst>
                  </p:cNvPr>
                  <p:cNvSpPr txBox="1"/>
                  <p:nvPr/>
                </p:nvSpPr>
                <p:spPr>
                  <a:xfrm>
                    <a:off x="-1394495" y="3508707"/>
                    <a:ext cx="417823" cy="12311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dirty="0" err="1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gDNA</a:t>
                    </a:r>
                    <a:endParaRPr lang="en-US" sz="800" b="1" dirty="0">
                      <a:solidFill>
                        <a:srgbClr val="000000"/>
                      </a:solidFill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15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E7E27D4-FCAE-F646-914F-443650F680A1}"/>
                      </a:ext>
                    </a:extLst>
                  </p:cNvPr>
                  <p:cNvSpPr txBox="1"/>
                  <p:nvPr/>
                </p:nvSpPr>
                <p:spPr>
                  <a:xfrm>
                    <a:off x="-796058" y="3508707"/>
                    <a:ext cx="299285" cy="12311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RNA</a:t>
                    </a:r>
                  </a:p>
                </p:txBody>
              </p:sp>
            </p:grpSp>
            <p:sp>
              <p:nvSpPr>
                <p:cNvPr id="216" name="Parenthèse ouvrante 215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DA73185-70E5-1349-B7BC-7B227BB850C1}"/>
                    </a:ext>
                  </a:extLst>
                </p:cNvPr>
                <p:cNvSpPr/>
                <p:nvPr/>
              </p:nvSpPr>
              <p:spPr>
                <a:xfrm rot="5400000">
                  <a:off x="-968493" y="2970041"/>
                  <a:ext cx="45719" cy="800138"/>
                </a:xfrm>
                <a:prstGeom prst="leftBracket">
                  <a:avLst/>
                </a:prstGeom>
                <a:ln w="19050" cmpd="sng">
                  <a:solidFill>
                    <a:srgbClr val="000000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/>
                    <a:cs typeface="Arial"/>
                  </a:endParaRPr>
                </a:p>
              </p:txBody>
            </p:sp>
            <p:grpSp>
              <p:nvGrpSpPr>
                <p:cNvPr id="24" name="Groupe 23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48220B2-5088-6745-B055-6047C4494116}"/>
                    </a:ext>
                  </a:extLst>
                </p:cNvPr>
                <p:cNvGrpSpPr/>
                <p:nvPr/>
              </p:nvGrpSpPr>
              <p:grpSpPr>
                <a:xfrm>
                  <a:off x="-2065728" y="4254174"/>
                  <a:ext cx="411543" cy="853086"/>
                  <a:chOff x="-2065728" y="4254174"/>
                  <a:chExt cx="411543" cy="853086"/>
                </a:xfrm>
              </p:grpSpPr>
              <p:grpSp>
                <p:nvGrpSpPr>
                  <p:cNvPr id="19" name="Groupe 18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44E01C5-D3CF-314C-A098-B719D25E9DDA}"/>
                      </a:ext>
                    </a:extLst>
                  </p:cNvPr>
                  <p:cNvGrpSpPr/>
                  <p:nvPr/>
                </p:nvGrpSpPr>
                <p:grpSpPr>
                  <a:xfrm>
                    <a:off x="-2044088" y="4606906"/>
                    <a:ext cx="389903" cy="184666"/>
                    <a:chOff x="-2044088" y="4606906"/>
                    <a:chExt cx="389903" cy="184666"/>
                  </a:xfrm>
                </p:grpSpPr>
                <p:cxnSp>
                  <p:nvCxnSpPr>
                    <p:cNvPr id="221" name="Connecteur droit avec flèche 220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3A0B1C8-5E53-8D4E-8CB5-CCB17003087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-1762185" y="4699239"/>
                      <a:ext cx="10800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headEnd type="none"/>
                      <a:tailEnd type="none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22" name="Rectangle 221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40650C0-3211-6E41-8D8C-20D4FDA6C89D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-2044088" y="4606906"/>
                      <a:ext cx="314510" cy="184666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600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600</a:t>
                      </a:r>
                      <a:endParaRPr lang="fr-FR" sz="600" dirty="0">
                        <a:latin typeface="Arial"/>
                        <a:cs typeface="Arial"/>
                      </a:endParaRPr>
                    </a:p>
                  </p:txBody>
                </p:sp>
              </p:grpSp>
              <p:grpSp>
                <p:nvGrpSpPr>
                  <p:cNvPr id="23" name="Groupe 22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660023B-A169-074C-95D4-3D8AFCF401F9}"/>
                      </a:ext>
                    </a:extLst>
                  </p:cNvPr>
                  <p:cNvGrpSpPr/>
                  <p:nvPr/>
                </p:nvGrpSpPr>
                <p:grpSpPr>
                  <a:xfrm>
                    <a:off x="-2065728" y="4254174"/>
                    <a:ext cx="411543" cy="853086"/>
                    <a:chOff x="-2065728" y="4254174"/>
                    <a:chExt cx="411543" cy="853086"/>
                  </a:xfrm>
                </p:grpSpPr>
                <p:grpSp>
                  <p:nvGrpSpPr>
                    <p:cNvPr id="20" name="Groupe 19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D8BE810-B45C-D340-9312-DFC0094AF9BD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2044088" y="4729883"/>
                      <a:ext cx="389903" cy="184666"/>
                      <a:chOff x="-2044088" y="4729883"/>
                      <a:chExt cx="389903" cy="184666"/>
                    </a:xfrm>
                  </p:grpSpPr>
                  <p:cxnSp>
                    <p:nvCxnSpPr>
                      <p:cNvPr id="219" name="Connecteur droit avec flèche 218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639B67D-5F67-694D-BB28-65B04C0DF523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-1762185" y="4832458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220" name="Rectangle 219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5E6F48F-6198-1142-AAFF-ED7173DCF2EC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-2044088" y="4729883"/>
                        <a:ext cx="314510" cy="184666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600" dirty="0">
                            <a:solidFill>
                              <a:srgbClr val="000000"/>
                            </a:solidFill>
                            <a:latin typeface="Arial"/>
                            <a:cs typeface="Arial"/>
                          </a:rPr>
                          <a:t>400</a:t>
                        </a:r>
                        <a:endParaRPr lang="fr-FR" sz="600" dirty="0">
                          <a:latin typeface="Arial"/>
                          <a:cs typeface="Arial"/>
                        </a:endParaRPr>
                      </a:p>
                    </p:txBody>
                  </p:sp>
                </p:grpSp>
                <p:grpSp>
                  <p:nvGrpSpPr>
                    <p:cNvPr id="18" name="Groupe 17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168ED9B-6F6A-4E4C-B685-608EA4D0F445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2044088" y="4508044"/>
                      <a:ext cx="389903" cy="184666"/>
                      <a:chOff x="-2044088" y="4488994"/>
                      <a:chExt cx="389903" cy="184666"/>
                    </a:xfrm>
                  </p:grpSpPr>
                  <p:cxnSp>
                    <p:nvCxnSpPr>
                      <p:cNvPr id="223" name="Connecteur droit avec flèche 222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12FAA32-A41A-A643-BDCC-75B254A34CF9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-1762185" y="4585545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224" name="Rectangle 223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3924767-368D-0641-9995-0FC640E9083A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-2044088" y="4488994"/>
                        <a:ext cx="314510" cy="184666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600" dirty="0">
                            <a:solidFill>
                              <a:srgbClr val="000000"/>
                            </a:solidFill>
                            <a:latin typeface="Arial"/>
                            <a:cs typeface="Arial"/>
                          </a:rPr>
                          <a:t>800</a:t>
                        </a:r>
                        <a:endParaRPr lang="fr-FR" sz="600" dirty="0">
                          <a:latin typeface="Arial"/>
                          <a:cs typeface="Arial"/>
                        </a:endParaRPr>
                      </a:p>
                    </p:txBody>
                  </p:sp>
                </p:grpSp>
                <p:grpSp>
                  <p:nvGrpSpPr>
                    <p:cNvPr id="17" name="Groupe 16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4366C4E-A77B-B34C-B23B-5E3232979E4B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2065728" y="4382601"/>
                      <a:ext cx="411543" cy="184666"/>
                      <a:chOff x="-2065728" y="4382601"/>
                      <a:chExt cx="411543" cy="184666"/>
                    </a:xfrm>
                  </p:grpSpPr>
                  <p:sp>
                    <p:nvSpPr>
                      <p:cNvPr id="225" name="Rectangle 224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5205346-4BFA-9D43-87A1-CC50B4FE4164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-2065728" y="4382601"/>
                        <a:ext cx="357790" cy="184666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600" dirty="0">
                            <a:solidFill>
                              <a:srgbClr val="000000"/>
                            </a:solidFill>
                            <a:latin typeface="Arial"/>
                            <a:cs typeface="Arial"/>
                          </a:rPr>
                          <a:t>1000</a:t>
                        </a:r>
                        <a:endParaRPr lang="fr-FR" sz="600" dirty="0">
                          <a:latin typeface="Arial"/>
                          <a:cs typeface="Arial"/>
                        </a:endParaRPr>
                      </a:p>
                    </p:txBody>
                  </p:sp>
                  <p:grpSp>
                    <p:nvGrpSpPr>
                      <p:cNvPr id="226" name="Groupe 225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64427F7-80A0-6647-9FDD-EA3A4C54477C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1793708" y="4485071"/>
                        <a:ext cx="139523" cy="49020"/>
                        <a:chOff x="310274" y="3671798"/>
                        <a:chExt cx="139523" cy="49020"/>
                      </a:xfrm>
                    </p:grpSpPr>
                    <p:cxnSp>
                      <p:nvCxnSpPr>
                        <p:cNvPr id="231" name="Connecteur droit avec flèche 230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0C0BCD4-9EC1-0D42-8293-04DEC9DC1412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341797" y="3720769"/>
                          <a:ext cx="108000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232" name="Connecteur droit avec flèche 231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E3EC2D9-3CCE-C145-B325-AA02867014DD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 flipV="1">
                          <a:off x="310274" y="3671798"/>
                          <a:ext cx="36000" cy="4902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</p:grpSp>
                <p:grpSp>
                  <p:nvGrpSpPr>
                    <p:cNvPr id="16" name="Groupe 1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837D219-61D1-874D-8212-589E9F66B49B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2065728" y="4254174"/>
                      <a:ext cx="411543" cy="184666"/>
                      <a:chOff x="-2065728" y="4254174"/>
                      <a:chExt cx="411543" cy="184666"/>
                    </a:xfrm>
                  </p:grpSpPr>
                  <p:cxnSp>
                    <p:nvCxnSpPr>
                      <p:cNvPr id="227" name="Connecteur droit avec flèche 226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BCDAAB5-8D12-954B-9ADB-9248B6532C32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-1762185" y="4365674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228" name="Rectangle 227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CCB13D2-5759-4E4D-878A-90A087C43DEA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-2065728" y="4254174"/>
                        <a:ext cx="357790" cy="184666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600" dirty="0">
                            <a:solidFill>
                              <a:srgbClr val="000000"/>
                            </a:solidFill>
                            <a:latin typeface="Arial"/>
                            <a:cs typeface="Arial"/>
                          </a:rPr>
                          <a:t>1500</a:t>
                        </a:r>
                        <a:endParaRPr lang="fr-FR" sz="600" dirty="0">
                          <a:latin typeface="Arial"/>
                          <a:cs typeface="Arial"/>
                        </a:endParaRPr>
                      </a:p>
                    </p:txBody>
                  </p:sp>
                </p:grpSp>
                <p:grpSp>
                  <p:nvGrpSpPr>
                    <p:cNvPr id="21" name="Groupe 20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A477FF3-291F-B847-B8AE-C99D95635A5D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2044088" y="4922594"/>
                      <a:ext cx="389903" cy="184666"/>
                      <a:chOff x="-2044088" y="4922594"/>
                      <a:chExt cx="389903" cy="184666"/>
                    </a:xfrm>
                  </p:grpSpPr>
                  <p:cxnSp>
                    <p:nvCxnSpPr>
                      <p:cNvPr id="229" name="Connecteur droit avec flèche 228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0290D0A-2542-0B4E-A5FD-946CE54569F0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-1762185" y="5018445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230" name="Rectangle 229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6E66565-78E1-CA41-99F9-D13178D4839C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-2044088" y="4922594"/>
                        <a:ext cx="314510" cy="184666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600" dirty="0">
                            <a:solidFill>
                              <a:srgbClr val="000000"/>
                            </a:solidFill>
                            <a:latin typeface="Arial"/>
                            <a:cs typeface="Arial"/>
                          </a:rPr>
                          <a:t>200</a:t>
                        </a:r>
                        <a:endParaRPr lang="fr-FR" sz="600" dirty="0">
                          <a:latin typeface="Arial"/>
                          <a:cs typeface="Arial"/>
                        </a:endParaRPr>
                      </a:p>
                    </p:txBody>
                  </p:sp>
                </p:grpSp>
              </p:grpSp>
            </p:grpSp>
            <p:pic>
              <p:nvPicPr>
                <p:cNvPr id="118" name="Image 117"/>
                <p:cNvPicPr preferRelativeResize="0">
                  <a:picLocks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val="0"/>
                    </a:ext>
                  </a:extLst>
                </a:blip>
                <a:srcRect l="11333" t="32740" r="62667" b="8686"/>
                <a:stretch/>
              </p:blipFill>
              <p:spPr bwMode="auto">
                <a:xfrm>
                  <a:off x="-1654185" y="3679840"/>
                  <a:ext cx="1149189" cy="1396800"/>
                </a:xfrm>
                <a:prstGeom prst="rect">
                  <a:avLst/>
                </a:prstGeom>
                <a:ln>
                  <a:noFill/>
                </a:ln>
                <a:extLst>
                  <a:ext uri="{53640926-AAD7-44d8-BBD7-CCE9431645EC}">
                    <a14:shadowObscured xmlns:a="http://schemas.openxmlformats.org/drawingml/2006/main" xmlns:r="http://schemas.openxmlformats.org/officeDocument/2006/relationships" xmlns:p="http://schemas.openxmlformats.org/presentationml/2006/main" xmlns="" xmlns:a14="http://schemas.microsoft.com/office/drawing/2010/main" xmlns:mv="urn:schemas-microsoft-com:mac:vml" xmlns:mc="http://schemas.openxmlformats.org/markup-compatibility/2006"/>
                  </a:ext>
                </a:extLst>
              </p:spPr>
            </p:pic>
          </p:grpSp>
          <p:grpSp>
            <p:nvGrpSpPr>
              <p:cNvPr id="28" name="Groupe 27">
                <a:extLst>
                  <a:ext uri="{FF2B5EF4-FFF2-40B4-BE49-F238E27FC236}">
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CB91834-1D40-2445-8981-0EC8880A0EC3}"/>
                  </a:ext>
                </a:extLst>
              </p:cNvPr>
              <p:cNvGrpSpPr/>
              <p:nvPr/>
            </p:nvGrpSpPr>
            <p:grpSpPr>
              <a:xfrm>
                <a:off x="1897868" y="2821816"/>
                <a:ext cx="1492755" cy="2043439"/>
                <a:chOff x="1708977" y="2627536"/>
                <a:chExt cx="1492755" cy="2043439"/>
              </a:xfrm>
            </p:grpSpPr>
            <p:grpSp>
              <p:nvGrpSpPr>
                <p:cNvPr id="233" name="Groupe 232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31B06FD-154E-4448-942F-71BA157E98FB}"/>
                    </a:ext>
                  </a:extLst>
                </p:cNvPr>
                <p:cNvGrpSpPr/>
                <p:nvPr/>
              </p:nvGrpSpPr>
              <p:grpSpPr>
                <a:xfrm>
                  <a:off x="1708977" y="2627536"/>
                  <a:ext cx="1492755" cy="2016369"/>
                  <a:chOff x="-1989528" y="3059141"/>
                  <a:chExt cx="1492755" cy="2016369"/>
                </a:xfrm>
              </p:grpSpPr>
              <p:sp>
                <p:nvSpPr>
                  <p:cNvPr id="234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4947708-6352-C240-9E46-B2D654D71AE5}"/>
                      </a:ext>
                    </a:extLst>
                  </p:cNvPr>
                  <p:cNvSpPr txBox="1"/>
                  <p:nvPr/>
                </p:nvSpPr>
                <p:spPr>
                  <a:xfrm>
                    <a:off x="-1366491" y="3059141"/>
                    <a:ext cx="841715" cy="27699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2</a:t>
                    </a:r>
                  </a:p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(190 </a:t>
                    </a:r>
                    <a:r>
                      <a:rPr lang="en-US" sz="900" b="1" dirty="0" err="1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bp</a:t>
                    </a:r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)</a:t>
                    </a:r>
                  </a:p>
                </p:txBody>
              </p:sp>
              <p:grpSp>
                <p:nvGrpSpPr>
                  <p:cNvPr id="235" name="Groupe 23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C03F107-B6E5-854E-8727-260DF2E8E2B9}"/>
                      </a:ext>
                    </a:extLst>
                  </p:cNvPr>
                  <p:cNvGrpSpPr/>
                  <p:nvPr/>
                </p:nvGrpSpPr>
                <p:grpSpPr>
                  <a:xfrm>
                    <a:off x="-1394495" y="3398273"/>
                    <a:ext cx="897722" cy="233545"/>
                    <a:chOff x="-1394495" y="3398273"/>
                    <a:chExt cx="897722" cy="233545"/>
                  </a:xfrm>
                </p:grpSpPr>
                <p:sp>
                  <p:nvSpPr>
                    <p:cNvPr id="260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0C42EF8-0772-2A43-A4C7-B5A595114AB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1135344" y="3398273"/>
                      <a:ext cx="391930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 err="1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cDNA</a:t>
                      </a:r>
                      <a:endParaRPr lang="en-US" sz="8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261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51440E8-3A8B-E545-838D-3AA48F05CB1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1394495" y="3508707"/>
                      <a:ext cx="417823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 err="1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gDNA</a:t>
                      </a:r>
                      <a:endParaRPr lang="en-US" sz="8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262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F30F4B0-1CE6-7E47-A4FB-B962A4E15CC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796058" y="3508707"/>
                      <a:ext cx="299285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RNA</a:t>
                      </a:r>
                    </a:p>
                  </p:txBody>
                </p:sp>
              </p:grpSp>
              <p:sp>
                <p:nvSpPr>
                  <p:cNvPr id="236" name="Parenthèse ouvrante 23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167AD0D-B425-AA44-96BE-CEC82D781730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-968493" y="2982741"/>
                    <a:ext cx="45719" cy="800138"/>
                  </a:xfrm>
                  <a:prstGeom prst="leftBracket">
                    <a:avLst/>
                  </a:prstGeom>
                  <a:ln w="19050" cmpd="sng">
                    <a:solidFill>
                      <a:srgbClr val="00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>
                      <a:latin typeface="Arial"/>
                      <a:cs typeface="Arial"/>
                    </a:endParaRPr>
                  </a:p>
                </p:txBody>
              </p:sp>
              <p:grpSp>
                <p:nvGrpSpPr>
                  <p:cNvPr id="237" name="Groupe 236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33329D5-A19C-FF4C-AAC6-FE74B59E47C3}"/>
                      </a:ext>
                    </a:extLst>
                  </p:cNvPr>
                  <p:cNvGrpSpPr/>
                  <p:nvPr/>
                </p:nvGrpSpPr>
                <p:grpSpPr>
                  <a:xfrm>
                    <a:off x="-1989528" y="4133524"/>
                    <a:ext cx="417893" cy="941986"/>
                    <a:chOff x="-1989528" y="4133524"/>
                    <a:chExt cx="417893" cy="941986"/>
                  </a:xfrm>
                </p:grpSpPr>
                <p:grpSp>
                  <p:nvGrpSpPr>
                    <p:cNvPr id="239" name="Groupe 238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BBA7548-65EB-B848-AB04-5725778E41F5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1974238" y="4543406"/>
                      <a:ext cx="402603" cy="184666"/>
                      <a:chOff x="-1974238" y="4543406"/>
                      <a:chExt cx="402603" cy="184666"/>
                    </a:xfrm>
                  </p:grpSpPr>
                  <p:cxnSp>
                    <p:nvCxnSpPr>
                      <p:cNvPr id="258" name="Connecteur droit avec flèche 257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BBFB78A-4D2A-EC4C-958E-34D162005F85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-1679635" y="4635739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259" name="Rectangle 258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803BD29-26F0-104F-AD5E-3A71AAEC5122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-1974238" y="4543406"/>
                        <a:ext cx="314510" cy="184666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600" dirty="0">
                            <a:solidFill>
                              <a:srgbClr val="000000"/>
                            </a:solidFill>
                            <a:latin typeface="Arial"/>
                            <a:cs typeface="Arial"/>
                          </a:rPr>
                          <a:t>600</a:t>
                        </a:r>
                        <a:endParaRPr lang="fr-FR" sz="600" dirty="0">
                          <a:latin typeface="Arial"/>
                          <a:cs typeface="Arial"/>
                        </a:endParaRPr>
                      </a:p>
                    </p:txBody>
                  </p:sp>
                </p:grpSp>
                <p:grpSp>
                  <p:nvGrpSpPr>
                    <p:cNvPr id="240" name="Groupe 239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956C274-2520-D340-B923-04D8044CAED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1989528" y="4133524"/>
                      <a:ext cx="417893" cy="941986"/>
                      <a:chOff x="-1989528" y="4133524"/>
                      <a:chExt cx="417893" cy="941986"/>
                    </a:xfrm>
                  </p:grpSpPr>
                  <p:grpSp>
                    <p:nvGrpSpPr>
                      <p:cNvPr id="241" name="Groupe 240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F400C9D-5A61-DD4F-99BE-A0584F9D0CF2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1955188" y="4679083"/>
                        <a:ext cx="383553" cy="184666"/>
                        <a:chOff x="-1955188" y="4679083"/>
                        <a:chExt cx="383553" cy="184666"/>
                      </a:xfrm>
                    </p:grpSpPr>
                    <p:cxnSp>
                      <p:nvCxnSpPr>
                        <p:cNvPr id="256" name="Connecteur droit avec flèche 255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8C462D0-FFC4-8C4C-B96B-27A30572C22D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-1679635" y="4781658"/>
                          <a:ext cx="108000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257" name="Rectangle 256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859B0CB-F1AC-E940-B852-AB01B9D0B292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1955188" y="4679083"/>
                          <a:ext cx="31451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4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</p:grpSp>
                  <p:grpSp>
                    <p:nvGrpSpPr>
                      <p:cNvPr id="242" name="Groupe 241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343FB69-4EFF-EA47-84A5-3586F2675C9B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1974238" y="4412794"/>
                        <a:ext cx="402603" cy="184666"/>
                        <a:chOff x="-1974238" y="4393744"/>
                        <a:chExt cx="402603" cy="184666"/>
                      </a:xfrm>
                    </p:grpSpPr>
                    <p:cxnSp>
                      <p:nvCxnSpPr>
                        <p:cNvPr id="254" name="Connecteur droit avec flèche 253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891ECBD-93D4-ED42-B386-1A4E5E20FCF1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-1679635" y="4490295"/>
                          <a:ext cx="108000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255" name="Rectangle 254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3A4EE2C-7680-4347-A0BE-E030A6EAF712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1974238" y="4393744"/>
                          <a:ext cx="31451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8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</p:grpSp>
                  <p:grpSp>
                    <p:nvGrpSpPr>
                      <p:cNvPr id="243" name="Groupe 242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B336F6C-7F90-AD4B-8E4A-0BC3C68A6771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1989528" y="4261951"/>
                        <a:ext cx="417893" cy="184666"/>
                        <a:chOff x="-1989528" y="4261951"/>
                        <a:chExt cx="417893" cy="184666"/>
                      </a:xfrm>
                    </p:grpSpPr>
                    <p:sp>
                      <p:nvSpPr>
                        <p:cNvPr id="250" name="Rectangle 249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A5726C0-0B21-FD4D-A022-37BE1C0A343E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1989528" y="4261951"/>
                          <a:ext cx="35779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10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  <p:grpSp>
                      <p:nvGrpSpPr>
                        <p:cNvPr id="251" name="Groupe 250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95FF2AB-7201-2D49-949D-850B63E4D98C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-1711158" y="4354945"/>
                          <a:ext cx="139523" cy="49020"/>
                          <a:chOff x="392824" y="3541672"/>
                          <a:chExt cx="139523" cy="49020"/>
                        </a:xfrm>
                      </p:grpSpPr>
                      <p:cxnSp>
                        <p:nvCxnSpPr>
                          <p:cNvPr id="252" name="Connecteur droit avec flèche 251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A87B70A-396C-0D45-A3EB-65E849704C79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flipH="1">
                            <a:off x="424347" y="3590643"/>
                            <a:ext cx="108000" cy="0"/>
                          </a:xfrm>
                          <a:prstGeom prst="straightConnector1">
                            <a:avLst/>
                          </a:prstGeom>
                          <a:ln>
                            <a:solidFill>
                              <a:schemeClr val="tx1"/>
                            </a:solidFill>
                            <a:headEnd type="none"/>
                            <a:tailEnd type="none"/>
                          </a:ln>
                          <a:effectLst/>
                        </p:spPr>
                        <p:style>
                          <a:lnRef idx="2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1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253" name="Connecteur droit avec flèche 252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676B86D-9ABB-E646-938A-031706AD80A3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flipH="1" flipV="1">
                            <a:off x="392824" y="3541672"/>
                            <a:ext cx="36000" cy="49020"/>
                          </a:xfrm>
                          <a:prstGeom prst="straightConnector1">
                            <a:avLst/>
                          </a:prstGeom>
                          <a:ln>
                            <a:solidFill>
                              <a:schemeClr val="tx1"/>
                            </a:solidFill>
                            <a:headEnd type="none"/>
                            <a:tailEnd type="none"/>
                          </a:ln>
                          <a:effectLst/>
                        </p:spPr>
                        <p:style>
                          <a:lnRef idx="2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1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</p:grpSp>
                  <p:grpSp>
                    <p:nvGrpSpPr>
                      <p:cNvPr id="244" name="Groupe 243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6B7224F-BE19-2348-AC66-FFFCF3F4D45B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1989528" y="4133524"/>
                        <a:ext cx="417893" cy="184666"/>
                        <a:chOff x="-1989528" y="4133524"/>
                        <a:chExt cx="417893" cy="184666"/>
                      </a:xfrm>
                    </p:grpSpPr>
                    <p:cxnSp>
                      <p:nvCxnSpPr>
                        <p:cNvPr id="248" name="Connecteur droit avec flèche 247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23821EA-C067-F44D-BF02-89E72D5C9383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-1679635" y="4245024"/>
                          <a:ext cx="108000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249" name="Rectangle 248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8B9B7EB-7D9C-E043-8981-F5A1A0CBCF79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1989528" y="4133524"/>
                          <a:ext cx="35779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15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</p:grpSp>
                  <p:grpSp>
                    <p:nvGrpSpPr>
                      <p:cNvPr id="245" name="Groupe 244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92134D9-2366-044E-94DD-C4BDA4087228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1961538" y="4890844"/>
                        <a:ext cx="389903" cy="184666"/>
                        <a:chOff x="-1961538" y="4890844"/>
                        <a:chExt cx="389903" cy="184666"/>
                      </a:xfrm>
                    </p:grpSpPr>
                    <p:cxnSp>
                      <p:nvCxnSpPr>
                        <p:cNvPr id="246" name="Connecteur droit avec flèche 245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769AAE8-94F7-9849-8C65-967D712758CF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-1679635" y="4986695"/>
                          <a:ext cx="108000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247" name="Rectangle 246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EC7CBE8-56CC-1C4E-BC21-8652B13D193E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1961538" y="4890844"/>
                          <a:ext cx="31451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2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</p:grpSp>
                </p:grpSp>
              </p:grpSp>
            </p:grpSp>
            <p:pic>
              <p:nvPicPr>
                <p:cNvPr id="135" name="Image 134"/>
                <p:cNvPicPr/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val="0"/>
                    </a:ext>
                  </a:extLst>
                </a:blip>
                <a:srcRect l="29792" t="20571" r="49810" b="40087"/>
                <a:stretch/>
              </p:blipFill>
              <p:spPr bwMode="auto">
                <a:xfrm>
                  <a:off x="2114493" y="3275749"/>
                  <a:ext cx="1087239" cy="1395226"/>
                </a:xfrm>
                <a:prstGeom prst="rect">
                  <a:avLst/>
                </a:prstGeom>
                <a:ln>
                  <a:noFill/>
                </a:ln>
                <a:extLst>
                  <a:ext uri="{53640926-AAD7-44d8-BBD7-CCE9431645EC}">
                    <a14:shadowObscured xmlns:a="http://schemas.openxmlformats.org/drawingml/2006/main" xmlns:r="http://schemas.openxmlformats.org/officeDocument/2006/relationships" xmlns:p="http://schemas.openxmlformats.org/presentationml/2006/main" xmlns="" xmlns:a14="http://schemas.microsoft.com/office/drawing/2010/main" xmlns:mv="urn:schemas-microsoft-com:mac:vml" xmlns:mc="http://schemas.openxmlformats.org/markup-compatibility/2006"/>
                  </a:ext>
                </a:extLst>
              </p:spPr>
            </p:pic>
          </p:grpSp>
          <p:grpSp>
            <p:nvGrpSpPr>
              <p:cNvPr id="27" name="Groupe 26">
                <a:extLst>
                  <a:ext uri="{FF2B5EF4-FFF2-40B4-BE49-F238E27FC236}">
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7EFCB23-C740-034F-8042-3ED21635F538}"/>
                  </a:ext>
                </a:extLst>
              </p:cNvPr>
              <p:cNvGrpSpPr/>
              <p:nvPr/>
            </p:nvGrpSpPr>
            <p:grpSpPr>
              <a:xfrm>
                <a:off x="3334167" y="2846428"/>
                <a:ext cx="1493148" cy="2018827"/>
                <a:chOff x="3244017" y="2652148"/>
                <a:chExt cx="1493148" cy="2018827"/>
              </a:xfrm>
            </p:grpSpPr>
            <p:grpSp>
              <p:nvGrpSpPr>
                <p:cNvPr id="263" name="Groupe 262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4599DA4-C244-3A46-8355-4D1C1180DBC0}"/>
                    </a:ext>
                  </a:extLst>
                </p:cNvPr>
                <p:cNvGrpSpPr/>
                <p:nvPr/>
              </p:nvGrpSpPr>
              <p:grpSpPr>
                <a:xfrm>
                  <a:off x="3244017" y="2652148"/>
                  <a:ext cx="1493148" cy="1921808"/>
                  <a:chOff x="-2065728" y="3052791"/>
                  <a:chExt cx="1493148" cy="1921808"/>
                </a:xfrm>
              </p:grpSpPr>
              <p:sp>
                <p:nvSpPr>
                  <p:cNvPr id="264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9BA57FD-8515-6846-9ECF-0A592820C7ED}"/>
                      </a:ext>
                    </a:extLst>
                  </p:cNvPr>
                  <p:cNvSpPr txBox="1"/>
                  <p:nvPr/>
                </p:nvSpPr>
                <p:spPr>
                  <a:xfrm>
                    <a:off x="-1442298" y="3052791"/>
                    <a:ext cx="841715" cy="27699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3</a:t>
                    </a:r>
                  </a:p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(243 </a:t>
                    </a:r>
                    <a:r>
                      <a:rPr lang="en-US" sz="900" b="1" dirty="0" err="1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bp</a:t>
                    </a:r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)</a:t>
                    </a:r>
                  </a:p>
                </p:txBody>
              </p:sp>
              <p:grpSp>
                <p:nvGrpSpPr>
                  <p:cNvPr id="265" name="Groupe 26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2B2C687-76A4-FC46-B68C-11BA7CD28CF3}"/>
                      </a:ext>
                    </a:extLst>
                  </p:cNvPr>
                  <p:cNvGrpSpPr/>
                  <p:nvPr/>
                </p:nvGrpSpPr>
                <p:grpSpPr>
                  <a:xfrm>
                    <a:off x="-1470302" y="3398273"/>
                    <a:ext cx="897722" cy="233545"/>
                    <a:chOff x="-1470302" y="3398273"/>
                    <a:chExt cx="897722" cy="233545"/>
                  </a:xfrm>
                </p:grpSpPr>
                <p:sp>
                  <p:nvSpPr>
                    <p:cNvPr id="290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CB3C018-8449-DA4A-89C3-317F8BBBA74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1140084" y="3398273"/>
                      <a:ext cx="391930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 err="1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cDNA</a:t>
                      </a:r>
                      <a:endParaRPr lang="en-US" sz="8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291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6700FB8-281E-4E4E-B9F1-4E03F2940CC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1470302" y="3508707"/>
                      <a:ext cx="417823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 err="1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gDNA</a:t>
                      </a:r>
                      <a:endParaRPr lang="en-US" sz="8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292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62224DF-F781-6C42-99D2-D86E0561C49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871865" y="3508707"/>
                      <a:ext cx="299285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RNA</a:t>
                      </a:r>
                    </a:p>
                  </p:txBody>
                </p:sp>
              </p:grpSp>
              <p:sp>
                <p:nvSpPr>
                  <p:cNvPr id="266" name="Parenthèse ouvrante 26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7A74166-3860-9A4D-A944-F6F38C1F36DB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-1044300" y="2970041"/>
                    <a:ext cx="45719" cy="800138"/>
                  </a:xfrm>
                  <a:prstGeom prst="leftBracket">
                    <a:avLst/>
                  </a:prstGeom>
                  <a:ln w="19050" cmpd="sng">
                    <a:solidFill>
                      <a:srgbClr val="00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>
                      <a:latin typeface="Arial"/>
                      <a:cs typeface="Arial"/>
                    </a:endParaRPr>
                  </a:p>
                </p:txBody>
              </p:sp>
              <p:grpSp>
                <p:nvGrpSpPr>
                  <p:cNvPr id="267" name="Groupe 266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0AC7DED-CA85-F34A-9378-C7F4A067EB55}"/>
                      </a:ext>
                    </a:extLst>
                  </p:cNvPr>
                  <p:cNvGrpSpPr/>
                  <p:nvPr/>
                </p:nvGrpSpPr>
                <p:grpSpPr>
                  <a:xfrm>
                    <a:off x="-2065728" y="4216270"/>
                    <a:ext cx="411543" cy="758329"/>
                    <a:chOff x="-2065728" y="4216270"/>
                    <a:chExt cx="411543" cy="758329"/>
                  </a:xfrm>
                </p:grpSpPr>
                <p:grpSp>
                  <p:nvGrpSpPr>
                    <p:cNvPr id="269" name="Groupe 268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DEE3591-5353-3A44-BF9E-23DAE35A304D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2044088" y="4535838"/>
                      <a:ext cx="389903" cy="184666"/>
                      <a:chOff x="-2044088" y="4535838"/>
                      <a:chExt cx="389903" cy="184666"/>
                    </a:xfrm>
                  </p:grpSpPr>
                  <p:cxnSp>
                    <p:nvCxnSpPr>
                      <p:cNvPr id="288" name="Connecteur droit avec flèche 287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A0BF101-F5E9-C646-B3D2-CE48F36A9F86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-1762185" y="4628171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289" name="Rectangle 288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93B462A-A617-4A41-A7B9-5A1F3B97FBE9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-2044088" y="4535838"/>
                        <a:ext cx="314510" cy="184666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600" dirty="0">
                            <a:solidFill>
                              <a:srgbClr val="000000"/>
                            </a:solidFill>
                            <a:latin typeface="Arial"/>
                            <a:cs typeface="Arial"/>
                          </a:rPr>
                          <a:t>600</a:t>
                        </a:r>
                        <a:endParaRPr lang="fr-FR" sz="600" dirty="0">
                          <a:latin typeface="Arial"/>
                          <a:cs typeface="Arial"/>
                        </a:endParaRPr>
                      </a:p>
                    </p:txBody>
                  </p:sp>
                </p:grpSp>
                <p:grpSp>
                  <p:nvGrpSpPr>
                    <p:cNvPr id="270" name="Groupe 269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9A3950A-2675-0B47-A574-4DFC9095CA3B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2065728" y="4216270"/>
                      <a:ext cx="411543" cy="758329"/>
                      <a:chOff x="-2065728" y="4216270"/>
                      <a:chExt cx="411543" cy="758329"/>
                    </a:xfrm>
                  </p:grpSpPr>
                  <p:grpSp>
                    <p:nvGrpSpPr>
                      <p:cNvPr id="271" name="Groupe 270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F5F397F-0395-304E-B41D-99525C590BA4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2044088" y="4654077"/>
                        <a:ext cx="389903" cy="184666"/>
                        <a:chOff x="-2044088" y="4654077"/>
                        <a:chExt cx="389903" cy="184666"/>
                      </a:xfrm>
                    </p:grpSpPr>
                    <p:cxnSp>
                      <p:nvCxnSpPr>
                        <p:cNvPr id="286" name="Connecteur droit avec flèche 285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6368BA4-D255-BD41-8856-70FE5307C21B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-1762185" y="4756652"/>
                          <a:ext cx="108000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287" name="Rectangle 286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2C83C8F-3B67-0E42-A8F2-203359F02923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2044088" y="4654077"/>
                          <a:ext cx="31451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4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</p:grpSp>
                  <p:grpSp>
                    <p:nvGrpSpPr>
                      <p:cNvPr id="272" name="Groupe 271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23D8B35-167E-F443-B456-DA65088083D7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2044088" y="4446451"/>
                        <a:ext cx="389903" cy="184666"/>
                        <a:chOff x="-2044088" y="4427401"/>
                        <a:chExt cx="389903" cy="184666"/>
                      </a:xfrm>
                    </p:grpSpPr>
                    <p:cxnSp>
                      <p:nvCxnSpPr>
                        <p:cNvPr id="284" name="Connecteur droit avec flèche 283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1E23359-3748-C648-BFA7-9F4572B110D7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-1762185" y="4523952"/>
                          <a:ext cx="108000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285" name="Rectangle 284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10F7238-F444-6743-B01C-6F08DFE0346F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2044088" y="4427401"/>
                          <a:ext cx="31451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8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</p:grpSp>
                  <p:grpSp>
                    <p:nvGrpSpPr>
                      <p:cNvPr id="273" name="Groupe 272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FA534F4-652F-AD43-917A-17E96820B6E0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2065728" y="4306796"/>
                        <a:ext cx="411543" cy="184666"/>
                        <a:chOff x="-2065728" y="4306796"/>
                        <a:chExt cx="411543" cy="184666"/>
                      </a:xfrm>
                    </p:grpSpPr>
                    <p:sp>
                      <p:nvSpPr>
                        <p:cNvPr id="280" name="Rectangle 279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160CD82-3E20-154A-AA89-4336CE00C25A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2065728" y="4306796"/>
                          <a:ext cx="35779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10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  <p:grpSp>
                      <p:nvGrpSpPr>
                        <p:cNvPr id="281" name="Groupe 280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C8DB9F7-5296-4F4A-A013-21FD89580A7A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-1793708" y="4409266"/>
                          <a:ext cx="139523" cy="49020"/>
                          <a:chOff x="310274" y="3595993"/>
                          <a:chExt cx="139523" cy="49020"/>
                        </a:xfrm>
                      </p:grpSpPr>
                      <p:cxnSp>
                        <p:nvCxnSpPr>
                          <p:cNvPr id="282" name="Connecteur droit avec flèche 281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0E29B85-76CB-1A4D-92DB-E61D82CC9A84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flipH="1">
                            <a:off x="341797" y="3644964"/>
                            <a:ext cx="108000" cy="0"/>
                          </a:xfrm>
                          <a:prstGeom prst="straightConnector1">
                            <a:avLst/>
                          </a:prstGeom>
                          <a:ln>
                            <a:solidFill>
                              <a:schemeClr val="tx1"/>
                            </a:solidFill>
                            <a:headEnd type="none"/>
                            <a:tailEnd type="none"/>
                          </a:ln>
                          <a:effectLst/>
                        </p:spPr>
                        <p:style>
                          <a:lnRef idx="2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1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283" name="Connecteur droit avec flèche 282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CF8F591-646C-D74F-BE39-D10F8A76F3C4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flipH="1" flipV="1">
                            <a:off x="310274" y="3595993"/>
                            <a:ext cx="36000" cy="49020"/>
                          </a:xfrm>
                          <a:prstGeom prst="straightConnector1">
                            <a:avLst/>
                          </a:prstGeom>
                          <a:ln>
                            <a:solidFill>
                              <a:schemeClr val="tx1"/>
                            </a:solidFill>
                            <a:headEnd type="none"/>
                            <a:tailEnd type="none"/>
                          </a:ln>
                          <a:effectLst/>
                        </p:spPr>
                        <p:style>
                          <a:lnRef idx="2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1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</p:grpSp>
                  <p:grpSp>
                    <p:nvGrpSpPr>
                      <p:cNvPr id="274" name="Groupe 273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3B1490E-442C-114F-B7A1-4AD20B94FABB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2065728" y="4216270"/>
                        <a:ext cx="411543" cy="184666"/>
                        <a:chOff x="-2065728" y="4216270"/>
                        <a:chExt cx="411543" cy="184666"/>
                      </a:xfrm>
                    </p:grpSpPr>
                    <p:cxnSp>
                      <p:nvCxnSpPr>
                        <p:cNvPr id="278" name="Connecteur droit avec flèche 277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91D1387-8E3D-6F4F-9EC4-A571205AE235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-1762185" y="4327770"/>
                          <a:ext cx="108000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279" name="Rectangle 278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E184E6F-4050-9443-878B-EC1A399F12EE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2065728" y="4216270"/>
                          <a:ext cx="35779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15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</p:grpSp>
                  <p:grpSp>
                    <p:nvGrpSpPr>
                      <p:cNvPr id="275" name="Groupe 274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A822C3D-1103-654F-945C-5CDC24AFB11C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2044088" y="4789933"/>
                        <a:ext cx="389903" cy="184666"/>
                        <a:chOff x="-2044088" y="4789933"/>
                        <a:chExt cx="389903" cy="184666"/>
                      </a:xfrm>
                    </p:grpSpPr>
                    <p:cxnSp>
                      <p:nvCxnSpPr>
                        <p:cNvPr id="276" name="Connecteur droit avec flèche 275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B1244DE-AE1C-EE41-9479-8B205760E6F4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-1762185" y="4885784"/>
                          <a:ext cx="108000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277" name="Rectangle 276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B5E0C51-C8B8-1746-BE3A-FC23ABDBF781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2044088" y="4789933"/>
                          <a:ext cx="31451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2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</p:grpSp>
                </p:grpSp>
              </p:grpSp>
            </p:grpSp>
            <p:pic>
              <p:nvPicPr>
                <p:cNvPr id="158" name="Image 157"/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val="0"/>
                    </a:ext>
                  </a:extLst>
                </a:blip>
                <a:srcRect l="4833" t="30290" r="77382" b="30281"/>
                <a:stretch/>
              </p:blipFill>
              <p:spPr bwMode="auto">
                <a:xfrm>
                  <a:off x="3652309" y="3275749"/>
                  <a:ext cx="1084856" cy="1395226"/>
                </a:xfrm>
                <a:prstGeom prst="rect">
                  <a:avLst/>
                </a:prstGeom>
                <a:ln>
                  <a:noFill/>
                </a:ln>
                <a:extLst>
                  <a:ext uri="{53640926-AAD7-44d8-BBD7-CCE9431645EC}">
                    <a14:shadowObscured xmlns:a="http://schemas.openxmlformats.org/drawingml/2006/main" xmlns:r="http://schemas.openxmlformats.org/officeDocument/2006/relationships" xmlns:p="http://schemas.openxmlformats.org/presentationml/2006/main" xmlns="" xmlns:a14="http://schemas.microsoft.com/office/drawing/2010/main" xmlns:mv="urn:schemas-microsoft-com:mac:vml" xmlns:mc="http://schemas.openxmlformats.org/markup-compatibility/2006"/>
                  </a:ext>
                </a:extLst>
              </p:spPr>
            </p:pic>
          </p:grpSp>
          <p:grpSp>
            <p:nvGrpSpPr>
              <p:cNvPr id="26" name="Groupe 25">
                <a:extLst>
                  <a:ext uri="{FF2B5EF4-FFF2-40B4-BE49-F238E27FC236}">
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4DF9936-DDD8-D449-82CF-534D041A92CA}"/>
                  </a:ext>
                </a:extLst>
              </p:cNvPr>
              <p:cNvGrpSpPr/>
              <p:nvPr/>
            </p:nvGrpSpPr>
            <p:grpSpPr>
              <a:xfrm>
                <a:off x="4750019" y="2841770"/>
                <a:ext cx="1606150" cy="2005189"/>
                <a:chOff x="4664162" y="2647490"/>
                <a:chExt cx="1606150" cy="2005189"/>
              </a:xfrm>
            </p:grpSpPr>
            <p:pic>
              <p:nvPicPr>
                <p:cNvPr id="182" name="Image 181" descr="D:\Gel\GelDocXRPlus 2018-12-04 14hr 23min.jpg"/>
                <p:cNvPicPr preferRelativeResize="0">
                  <a:picLocks/>
                </p:cNvPicPr>
                <p:nvPr/>
              </p:nvPicPr>
              <p:blipFill rotWithShape="1">
                <a:blip r:embed="rId5">
                  <a:extLst>
                    <a:ext uri="{28A0092B-C50C-407E-A947-70E740481C1C}">
                      <a14:useLocalDpi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val="0"/>
                    </a:ext>
                  </a:extLst>
                </a:blip>
                <a:srcRect l="19028" t="24277" r="59743" b="30271"/>
                <a:stretch/>
              </p:blipFill>
              <p:spPr bwMode="auto">
                <a:xfrm>
                  <a:off x="5076374" y="3255879"/>
                  <a:ext cx="1151730" cy="13968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53640926-AAD7-44d8-BBD7-CCE9431645EC}">
                    <a14:shadowObscured xmlns:a="http://schemas.openxmlformats.org/drawingml/2006/main" xmlns:r="http://schemas.openxmlformats.org/officeDocument/2006/relationships" xmlns:p="http://schemas.openxmlformats.org/presentationml/2006/main" xmlns="" xmlns:a14="http://schemas.microsoft.com/office/drawing/2010/main" xmlns:mv="urn:schemas-microsoft-com:mac:vml" xmlns:mc="http://schemas.openxmlformats.org/markup-compatibility/2006"/>
                  </a:ext>
                </a:extLst>
              </p:spPr>
            </p:pic>
            <p:grpSp>
              <p:nvGrpSpPr>
                <p:cNvPr id="293" name="Groupe 292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21C3B59-4BC7-1E44-85A0-F1AA8B254C3F}"/>
                    </a:ext>
                  </a:extLst>
                </p:cNvPr>
                <p:cNvGrpSpPr/>
                <p:nvPr/>
              </p:nvGrpSpPr>
              <p:grpSpPr>
                <a:xfrm>
                  <a:off x="4664162" y="2647490"/>
                  <a:ext cx="1606150" cy="1881381"/>
                  <a:chOff x="-1945524" y="3052791"/>
                  <a:chExt cx="1606150" cy="1881381"/>
                </a:xfrm>
              </p:grpSpPr>
              <p:sp>
                <p:nvSpPr>
                  <p:cNvPr id="294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485A293-02F2-7B4B-9875-D82FB0AE95D2}"/>
                      </a:ext>
                    </a:extLst>
                  </p:cNvPr>
                  <p:cNvSpPr txBox="1"/>
                  <p:nvPr/>
                </p:nvSpPr>
                <p:spPr>
                  <a:xfrm>
                    <a:off x="-1190042" y="3052791"/>
                    <a:ext cx="841715" cy="27699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4</a:t>
                    </a:r>
                  </a:p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(292 </a:t>
                    </a:r>
                    <a:r>
                      <a:rPr lang="en-US" sz="900" b="1" dirty="0" err="1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bp</a:t>
                    </a:r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)</a:t>
                    </a:r>
                  </a:p>
                </p:txBody>
              </p:sp>
              <p:grpSp>
                <p:nvGrpSpPr>
                  <p:cNvPr id="295" name="Groupe 29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C06C30D-294C-F94B-A7C0-67A46D641250}"/>
                      </a:ext>
                    </a:extLst>
                  </p:cNvPr>
                  <p:cNvGrpSpPr/>
                  <p:nvPr/>
                </p:nvGrpSpPr>
                <p:grpSpPr>
                  <a:xfrm>
                    <a:off x="-1287896" y="3398273"/>
                    <a:ext cx="948522" cy="233545"/>
                    <a:chOff x="-1287896" y="3398273"/>
                    <a:chExt cx="948522" cy="233545"/>
                  </a:xfrm>
                </p:grpSpPr>
                <p:sp>
                  <p:nvSpPr>
                    <p:cNvPr id="319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D0FB8DF-244C-C843-B1D4-28FA5E90926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957678" y="3398273"/>
                      <a:ext cx="391930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 err="1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cDNA</a:t>
                      </a:r>
                      <a:endParaRPr lang="en-US" sz="8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320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0DAD38D-BBB9-3048-96CE-6B5EFBA73E2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1287896" y="3508707"/>
                      <a:ext cx="417823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 err="1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gDNA</a:t>
                      </a:r>
                      <a:endParaRPr lang="en-US" sz="8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321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20C0EE0-2D4E-AF46-9A0F-9496B195D34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638659" y="3508707"/>
                      <a:ext cx="299285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RNA</a:t>
                      </a:r>
                    </a:p>
                  </p:txBody>
                </p:sp>
              </p:grpSp>
              <p:sp>
                <p:nvSpPr>
                  <p:cNvPr id="296" name="Parenthèse ouvrante 29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38B4F62-AB51-D946-9A0A-C103BF60B635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-792044" y="2970041"/>
                    <a:ext cx="45719" cy="800138"/>
                  </a:xfrm>
                  <a:prstGeom prst="leftBracket">
                    <a:avLst/>
                  </a:prstGeom>
                  <a:ln w="19050" cmpd="sng">
                    <a:solidFill>
                      <a:srgbClr val="00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>
                      <a:latin typeface="Arial"/>
                      <a:cs typeface="Arial"/>
                    </a:endParaRPr>
                  </a:p>
                </p:txBody>
              </p:sp>
              <p:grpSp>
                <p:nvGrpSpPr>
                  <p:cNvPr id="297" name="Groupe 296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C3D04D6-062B-4845-9391-F2B9A01D09DF}"/>
                      </a:ext>
                    </a:extLst>
                  </p:cNvPr>
                  <p:cNvGrpSpPr/>
                  <p:nvPr/>
                </p:nvGrpSpPr>
                <p:grpSpPr>
                  <a:xfrm>
                    <a:off x="-1945524" y="4195342"/>
                    <a:ext cx="411543" cy="738830"/>
                    <a:chOff x="-1945524" y="4195342"/>
                    <a:chExt cx="411543" cy="738830"/>
                  </a:xfrm>
                </p:grpSpPr>
                <p:grpSp>
                  <p:nvGrpSpPr>
                    <p:cNvPr id="298" name="Groupe 297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A6809BC-0116-D846-A990-A2F4F20114C3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1923884" y="4599338"/>
                      <a:ext cx="389903" cy="184666"/>
                      <a:chOff x="-1923884" y="4599338"/>
                      <a:chExt cx="389903" cy="184666"/>
                    </a:xfrm>
                  </p:grpSpPr>
                  <p:cxnSp>
                    <p:nvCxnSpPr>
                      <p:cNvPr id="317" name="Connecteur droit avec flèche 316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121760C-B093-4848-B456-FDDED78FD3AB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-1641981" y="4691671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318" name="Rectangle 317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B5823D8-B906-A043-9CF7-BA2B6AFAC86D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-1923884" y="4599338"/>
                        <a:ext cx="314510" cy="184666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600" dirty="0">
                            <a:solidFill>
                              <a:srgbClr val="000000"/>
                            </a:solidFill>
                            <a:latin typeface="Arial"/>
                            <a:cs typeface="Arial"/>
                          </a:rPr>
                          <a:t>600</a:t>
                        </a:r>
                        <a:endParaRPr lang="fr-FR" sz="600" dirty="0">
                          <a:latin typeface="Arial"/>
                          <a:cs typeface="Arial"/>
                        </a:endParaRPr>
                      </a:p>
                    </p:txBody>
                  </p:sp>
                </p:grpSp>
                <p:grpSp>
                  <p:nvGrpSpPr>
                    <p:cNvPr id="299" name="Groupe 298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0CAAB70-8056-4040-BBD8-A349447E3DDF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1945524" y="4195342"/>
                      <a:ext cx="411543" cy="738830"/>
                      <a:chOff x="-1945524" y="4195342"/>
                      <a:chExt cx="411543" cy="738830"/>
                    </a:xfrm>
                  </p:grpSpPr>
                  <p:grpSp>
                    <p:nvGrpSpPr>
                      <p:cNvPr id="300" name="Groupe 299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5F8223B-FE5E-4941-A28F-D246DFB0370C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1923884" y="4749506"/>
                        <a:ext cx="389903" cy="184666"/>
                        <a:chOff x="-1923884" y="4749506"/>
                        <a:chExt cx="389903" cy="184666"/>
                      </a:xfrm>
                    </p:grpSpPr>
                    <p:cxnSp>
                      <p:nvCxnSpPr>
                        <p:cNvPr id="315" name="Connecteur droit avec flèche 314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660096B-F4AC-7445-972E-95A23B6E1697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-1641981" y="4852081"/>
                          <a:ext cx="108000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316" name="Rectangle 315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C4FB03A-C8DD-3046-9256-1BDA016FE848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1923884" y="4749506"/>
                          <a:ext cx="31451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4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</p:grpSp>
                  <p:grpSp>
                    <p:nvGrpSpPr>
                      <p:cNvPr id="301" name="Groupe 300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8933DFE-2D50-604C-844D-2664815087E8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1923884" y="4484730"/>
                        <a:ext cx="389903" cy="184666"/>
                        <a:chOff x="-1923884" y="4465680"/>
                        <a:chExt cx="389903" cy="184666"/>
                      </a:xfrm>
                    </p:grpSpPr>
                    <p:cxnSp>
                      <p:nvCxnSpPr>
                        <p:cNvPr id="313" name="Connecteur droit avec flèche 312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86327AC-96F9-BD40-8EDE-FBD94AB963F4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-1641981" y="4562231"/>
                          <a:ext cx="108000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314" name="Rectangle 313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C27FC4F-9B74-7146-BB6D-49C6556DB17B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1923884" y="4465680"/>
                          <a:ext cx="31451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8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</p:grpSp>
                  <p:grpSp>
                    <p:nvGrpSpPr>
                      <p:cNvPr id="302" name="Groupe 301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42F2B9B-7263-FA4E-99E0-B090D550ED95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1945524" y="4323968"/>
                        <a:ext cx="411543" cy="184666"/>
                        <a:chOff x="-1945524" y="4323968"/>
                        <a:chExt cx="411543" cy="184666"/>
                      </a:xfrm>
                    </p:grpSpPr>
                    <p:sp>
                      <p:nvSpPr>
                        <p:cNvPr id="309" name="Rectangle 308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6958E1B-DE2E-134F-8462-7F701E44B560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1945524" y="4323968"/>
                          <a:ext cx="35779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10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  <p:grpSp>
                      <p:nvGrpSpPr>
                        <p:cNvPr id="310" name="Groupe 309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0763C64-7813-DD42-B2E9-625940B61537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-1673504" y="4426438"/>
                          <a:ext cx="139523" cy="49020"/>
                          <a:chOff x="430478" y="3613165"/>
                          <a:chExt cx="139523" cy="49020"/>
                        </a:xfrm>
                      </p:grpSpPr>
                      <p:cxnSp>
                        <p:nvCxnSpPr>
                          <p:cNvPr id="311" name="Connecteur droit avec flèche 310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1DFDFE1-2B67-5345-8971-92577EC0EF99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flipH="1">
                            <a:off x="462001" y="3662136"/>
                            <a:ext cx="108000" cy="0"/>
                          </a:xfrm>
                          <a:prstGeom prst="straightConnector1">
                            <a:avLst/>
                          </a:prstGeom>
                          <a:ln>
                            <a:solidFill>
                              <a:schemeClr val="tx1"/>
                            </a:solidFill>
                            <a:headEnd type="none"/>
                            <a:tailEnd type="none"/>
                          </a:ln>
                          <a:effectLst/>
                        </p:spPr>
                        <p:style>
                          <a:lnRef idx="2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1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312" name="Connecteur droit avec flèche 311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B7CF657-38CF-B546-A918-FC85FB4F31B9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flipH="1" flipV="1">
                            <a:off x="430478" y="3613165"/>
                            <a:ext cx="36000" cy="49020"/>
                          </a:xfrm>
                          <a:prstGeom prst="straightConnector1">
                            <a:avLst/>
                          </a:prstGeom>
                          <a:ln>
                            <a:solidFill>
                              <a:schemeClr val="tx1"/>
                            </a:solidFill>
                            <a:headEnd type="none"/>
                            <a:tailEnd type="none"/>
                          </a:ln>
                          <a:effectLst/>
                        </p:spPr>
                        <p:style>
                          <a:lnRef idx="2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1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</p:grpSp>
                  <p:grpSp>
                    <p:nvGrpSpPr>
                      <p:cNvPr id="303" name="Groupe 302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C782DCF-1413-334D-ADD8-9CBC11BB30E1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1945524" y="4195342"/>
                        <a:ext cx="411543" cy="184666"/>
                        <a:chOff x="-1945524" y="4195342"/>
                        <a:chExt cx="411543" cy="184666"/>
                      </a:xfrm>
                    </p:grpSpPr>
                    <p:cxnSp>
                      <p:nvCxnSpPr>
                        <p:cNvPr id="307" name="Connecteur droit avec flèche 306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FA15723-AE1E-C145-94D0-DF2B4B23539E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-1641981" y="4306842"/>
                          <a:ext cx="108000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308" name="Rectangle 307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144BE38-F31B-B64B-ABCC-D0E34B1FAB55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1945524" y="4195342"/>
                          <a:ext cx="35779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15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</p:grpSp>
                </p:grpSp>
              </p:grpSp>
            </p:grpSp>
          </p:grpSp>
          <p:grpSp>
            <p:nvGrpSpPr>
              <p:cNvPr id="29" name="Groupe 28">
                <a:extLst>
                  <a:ext uri="{FF2B5EF4-FFF2-40B4-BE49-F238E27FC236}">
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5C99895-82E9-E047-90F4-D824AF6A6AFB}"/>
                  </a:ext>
                </a:extLst>
              </p:cNvPr>
              <p:cNvGrpSpPr/>
              <p:nvPr/>
            </p:nvGrpSpPr>
            <p:grpSpPr>
              <a:xfrm>
                <a:off x="435546" y="5040297"/>
                <a:ext cx="1557079" cy="2016923"/>
                <a:chOff x="435545" y="4407614"/>
                <a:chExt cx="1557079" cy="2016923"/>
              </a:xfrm>
            </p:grpSpPr>
            <p:grpSp>
              <p:nvGrpSpPr>
                <p:cNvPr id="323" name="Groupe 322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65D9CB1-AB1A-7B4D-B523-E538E5860C27}"/>
                    </a:ext>
                  </a:extLst>
                </p:cNvPr>
                <p:cNvGrpSpPr/>
                <p:nvPr/>
              </p:nvGrpSpPr>
              <p:grpSpPr>
                <a:xfrm>
                  <a:off x="435545" y="4407614"/>
                  <a:ext cx="1557079" cy="1917902"/>
                  <a:chOff x="-2065728" y="3052791"/>
                  <a:chExt cx="1557079" cy="1917902"/>
                </a:xfrm>
              </p:grpSpPr>
              <p:sp>
                <p:nvSpPr>
                  <p:cNvPr id="324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26B2CAB-7A91-344B-9E94-39CA1177CE3D}"/>
                      </a:ext>
                    </a:extLst>
                  </p:cNvPr>
                  <p:cNvSpPr txBox="1"/>
                  <p:nvPr/>
                </p:nvSpPr>
                <p:spPr>
                  <a:xfrm>
                    <a:off x="-1378367" y="3052791"/>
                    <a:ext cx="841715" cy="27699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5</a:t>
                    </a:r>
                  </a:p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(114 </a:t>
                    </a:r>
                    <a:r>
                      <a:rPr lang="en-US" sz="900" b="1" dirty="0" err="1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bp</a:t>
                    </a:r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)</a:t>
                    </a:r>
                  </a:p>
                </p:txBody>
              </p:sp>
              <p:grpSp>
                <p:nvGrpSpPr>
                  <p:cNvPr id="325" name="Groupe 32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85CB202-3BF3-614B-A8D8-ACA97D64EEED}"/>
                      </a:ext>
                    </a:extLst>
                  </p:cNvPr>
                  <p:cNvGrpSpPr/>
                  <p:nvPr/>
                </p:nvGrpSpPr>
                <p:grpSpPr>
                  <a:xfrm>
                    <a:off x="-1424185" y="3398273"/>
                    <a:ext cx="915536" cy="233545"/>
                    <a:chOff x="-1424185" y="3398273"/>
                    <a:chExt cx="915536" cy="233545"/>
                  </a:xfrm>
                </p:grpSpPr>
                <p:sp>
                  <p:nvSpPr>
                    <p:cNvPr id="350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29A43F4-FFDC-754E-98B3-FB42BB5F315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1147220" y="3398273"/>
                      <a:ext cx="391930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 err="1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cDNA</a:t>
                      </a:r>
                      <a:endParaRPr lang="en-US" sz="8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351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2C3F026-2134-9941-AC05-221D6CB5DE8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1424185" y="3508707"/>
                      <a:ext cx="417823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 err="1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gDNA</a:t>
                      </a:r>
                      <a:endParaRPr lang="en-US" sz="8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352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FE77979-3862-944F-A1E8-513AB815307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807934" y="3508707"/>
                      <a:ext cx="299285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RNA</a:t>
                      </a:r>
                    </a:p>
                  </p:txBody>
                </p:sp>
              </p:grpSp>
              <p:sp>
                <p:nvSpPr>
                  <p:cNvPr id="326" name="Parenthèse ouvrante 3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01CBBA1-558A-0A4D-B995-2C7FCD10893D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-980369" y="2970041"/>
                    <a:ext cx="45719" cy="800138"/>
                  </a:xfrm>
                  <a:prstGeom prst="leftBracket">
                    <a:avLst/>
                  </a:prstGeom>
                  <a:ln w="19050" cmpd="sng">
                    <a:solidFill>
                      <a:srgbClr val="00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>
                      <a:latin typeface="Arial"/>
                      <a:cs typeface="Arial"/>
                    </a:endParaRPr>
                  </a:p>
                </p:txBody>
              </p:sp>
              <p:grpSp>
                <p:nvGrpSpPr>
                  <p:cNvPr id="327" name="Groupe 326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CD8DD18-6EC0-F24B-A29D-9537027A1B7F}"/>
                      </a:ext>
                    </a:extLst>
                  </p:cNvPr>
                  <p:cNvGrpSpPr/>
                  <p:nvPr/>
                </p:nvGrpSpPr>
                <p:grpSpPr>
                  <a:xfrm>
                    <a:off x="-2065728" y="4210632"/>
                    <a:ext cx="411543" cy="760061"/>
                    <a:chOff x="-2065728" y="4210632"/>
                    <a:chExt cx="411543" cy="760061"/>
                  </a:xfrm>
                </p:grpSpPr>
                <p:grpSp>
                  <p:nvGrpSpPr>
                    <p:cNvPr id="329" name="Groupe 328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0373407-9342-F04A-BEF3-9DC37004CD5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2044088" y="4541590"/>
                      <a:ext cx="389903" cy="184666"/>
                      <a:chOff x="-2044088" y="4541590"/>
                      <a:chExt cx="389903" cy="184666"/>
                    </a:xfrm>
                  </p:grpSpPr>
                  <p:cxnSp>
                    <p:nvCxnSpPr>
                      <p:cNvPr id="348" name="Connecteur droit avec flèche 347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B365AF8-E9EE-034C-9DC8-D95777B692C0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-1762185" y="4633923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349" name="Rectangle 348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384B8FE-AD1B-0E40-B925-F66D38DC1999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-2044088" y="4541590"/>
                        <a:ext cx="314510" cy="184666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600" dirty="0">
                            <a:solidFill>
                              <a:srgbClr val="000000"/>
                            </a:solidFill>
                            <a:latin typeface="Arial"/>
                            <a:cs typeface="Arial"/>
                          </a:rPr>
                          <a:t>600</a:t>
                        </a:r>
                        <a:endParaRPr lang="fr-FR" sz="600" dirty="0">
                          <a:latin typeface="Arial"/>
                          <a:cs typeface="Arial"/>
                        </a:endParaRPr>
                      </a:p>
                    </p:txBody>
                  </p:sp>
                </p:grpSp>
                <p:grpSp>
                  <p:nvGrpSpPr>
                    <p:cNvPr id="330" name="Groupe 329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2CD302A-D6B1-4E4E-B024-537C7437443B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2065728" y="4210632"/>
                      <a:ext cx="411543" cy="760061"/>
                      <a:chOff x="-2065728" y="4210632"/>
                      <a:chExt cx="411543" cy="760061"/>
                    </a:xfrm>
                  </p:grpSpPr>
                  <p:grpSp>
                    <p:nvGrpSpPr>
                      <p:cNvPr id="331" name="Groupe 330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9CAA48C-3E69-0B4E-9C35-922FC174FC59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2044088" y="4640818"/>
                        <a:ext cx="389903" cy="184666"/>
                        <a:chOff x="-2044088" y="4640818"/>
                        <a:chExt cx="389903" cy="184666"/>
                      </a:xfrm>
                    </p:grpSpPr>
                    <p:cxnSp>
                      <p:nvCxnSpPr>
                        <p:cNvPr id="346" name="Connecteur droit avec flèche 345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A19932A-15EC-2946-9201-A83AD44E2C63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-1762185" y="4743393"/>
                          <a:ext cx="108000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347" name="Rectangle 346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5E1026A-298A-9946-8324-09DEE9833DAD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2044088" y="4640818"/>
                          <a:ext cx="31451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4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</p:grpSp>
                  <p:grpSp>
                    <p:nvGrpSpPr>
                      <p:cNvPr id="332" name="Groupe 331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860AF34-3AE3-5F42-9105-64B7F973ECB3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2044088" y="4436790"/>
                        <a:ext cx="389903" cy="184666"/>
                        <a:chOff x="-2044088" y="4417740"/>
                        <a:chExt cx="389903" cy="184666"/>
                      </a:xfrm>
                    </p:grpSpPr>
                    <p:cxnSp>
                      <p:nvCxnSpPr>
                        <p:cNvPr id="344" name="Connecteur droit avec flèche 343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53A8818-9123-7842-9BBB-CAB09D4C65A1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-1762185" y="4514291"/>
                          <a:ext cx="108000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345" name="Rectangle 344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B3F55FC-87B6-5344-905A-11295A79AD47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2044088" y="4417740"/>
                          <a:ext cx="31451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8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</p:grpSp>
                  <p:grpSp>
                    <p:nvGrpSpPr>
                      <p:cNvPr id="333" name="Groupe 332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E3E6176-D402-744D-AE6C-0CA48E84F090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2065728" y="4311350"/>
                        <a:ext cx="411543" cy="184666"/>
                        <a:chOff x="-2065728" y="4311350"/>
                        <a:chExt cx="411543" cy="184666"/>
                      </a:xfrm>
                    </p:grpSpPr>
                    <p:sp>
                      <p:nvSpPr>
                        <p:cNvPr id="340" name="Rectangle 339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57F5211-61FC-E145-B8C1-7EE5AE91AAAB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2065728" y="4311350"/>
                          <a:ext cx="35779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10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  <p:grpSp>
                      <p:nvGrpSpPr>
                        <p:cNvPr id="341" name="Groupe 340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853B156-5917-2746-89DD-6B7354033BC4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-1793708" y="4413820"/>
                          <a:ext cx="139523" cy="49020"/>
                          <a:chOff x="310274" y="3600547"/>
                          <a:chExt cx="139523" cy="49020"/>
                        </a:xfrm>
                      </p:grpSpPr>
                      <p:cxnSp>
                        <p:nvCxnSpPr>
                          <p:cNvPr id="342" name="Connecteur droit avec flèche 341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B75F24F-6739-A045-93E9-BD7D13009342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flipH="1">
                            <a:off x="341797" y="3649518"/>
                            <a:ext cx="108000" cy="0"/>
                          </a:xfrm>
                          <a:prstGeom prst="straightConnector1">
                            <a:avLst/>
                          </a:prstGeom>
                          <a:ln>
                            <a:solidFill>
                              <a:schemeClr val="tx1"/>
                            </a:solidFill>
                            <a:headEnd type="none"/>
                            <a:tailEnd type="none"/>
                          </a:ln>
                          <a:effectLst/>
                        </p:spPr>
                        <p:style>
                          <a:lnRef idx="2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1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343" name="Connecteur droit avec flèche 342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B5B1B74-1590-7241-808D-BA9F16601811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flipH="1" flipV="1">
                            <a:off x="310274" y="3600547"/>
                            <a:ext cx="36000" cy="49020"/>
                          </a:xfrm>
                          <a:prstGeom prst="straightConnector1">
                            <a:avLst/>
                          </a:prstGeom>
                          <a:ln>
                            <a:solidFill>
                              <a:schemeClr val="tx1"/>
                            </a:solidFill>
                            <a:headEnd type="none"/>
                            <a:tailEnd type="none"/>
                          </a:ln>
                          <a:effectLst/>
                        </p:spPr>
                        <p:style>
                          <a:lnRef idx="2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1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</p:grpSp>
                  <p:grpSp>
                    <p:nvGrpSpPr>
                      <p:cNvPr id="334" name="Groupe 333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DB0E65D-42A9-D24C-BA09-14AA21AEECF2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2065728" y="4210632"/>
                        <a:ext cx="411543" cy="184666"/>
                        <a:chOff x="-2065728" y="4210632"/>
                        <a:chExt cx="411543" cy="184666"/>
                      </a:xfrm>
                    </p:grpSpPr>
                    <p:cxnSp>
                      <p:nvCxnSpPr>
                        <p:cNvPr id="338" name="Connecteur droit avec flèche 337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8DB29AE-DE66-2A40-B130-88A776F1E480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-1762185" y="4322132"/>
                          <a:ext cx="108000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339" name="Rectangle 338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A46C95B-0644-6641-8407-10F004D7DBA5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2065728" y="4210632"/>
                          <a:ext cx="35779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15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</p:grpSp>
                  <p:grpSp>
                    <p:nvGrpSpPr>
                      <p:cNvPr id="335" name="Groupe 334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6ECFD43-C70B-9A47-A416-B34D500CC668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2044088" y="4786027"/>
                        <a:ext cx="389903" cy="184666"/>
                        <a:chOff x="-2044088" y="4786027"/>
                        <a:chExt cx="389903" cy="184666"/>
                      </a:xfrm>
                    </p:grpSpPr>
                    <p:cxnSp>
                      <p:nvCxnSpPr>
                        <p:cNvPr id="336" name="Connecteur droit avec flèche 335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1EEC71F-4D48-CE4F-BC95-B5F79D13420F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-1762185" y="4881878"/>
                          <a:ext cx="108000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337" name="Rectangle 336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84C87A9-3127-EA4A-850F-0C67D5EF1361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2044088" y="4786027"/>
                          <a:ext cx="31451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2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</p:grpSp>
                </p:grpSp>
              </p:grpSp>
            </p:grpSp>
            <p:pic>
              <p:nvPicPr>
                <p:cNvPr id="183" name="Image 182"/>
                <p:cNvPicPr preferRelativeResize="0">
                  <a:picLocks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val="0"/>
                    </a:ext>
                  </a:extLst>
                </a:blip>
                <a:srcRect l="35740" t="30765" r="46073" b="29806"/>
                <a:stretch/>
              </p:blipFill>
              <p:spPr bwMode="auto">
                <a:xfrm>
                  <a:off x="829790" y="5027737"/>
                  <a:ext cx="1152000" cy="1396800"/>
                </a:xfrm>
                <a:prstGeom prst="rect">
                  <a:avLst/>
                </a:prstGeom>
                <a:ln>
                  <a:noFill/>
                </a:ln>
                <a:extLst>
                  <a:ext uri="{53640926-AAD7-44d8-BBD7-CCE9431645EC}">
                    <a14:shadowObscured xmlns:a="http://schemas.openxmlformats.org/drawingml/2006/main" xmlns:r="http://schemas.openxmlformats.org/officeDocument/2006/relationships" xmlns:p="http://schemas.openxmlformats.org/presentationml/2006/main" xmlns="" xmlns:a14="http://schemas.microsoft.com/office/drawing/2010/main" xmlns:mv="urn:schemas-microsoft-com:mac:vml" xmlns:mc="http://schemas.openxmlformats.org/markup-compatibility/2006"/>
                  </a:ext>
                </a:extLst>
              </p:spPr>
            </p:pic>
          </p:grpSp>
          <p:grpSp>
            <p:nvGrpSpPr>
              <p:cNvPr id="30" name="Groupe 29">
                <a:extLst>
                  <a:ext uri="{FF2B5EF4-FFF2-40B4-BE49-F238E27FC236}">
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22E2B59-99CA-2942-A484-BD6A3EEDC6C7}"/>
                  </a:ext>
                </a:extLst>
              </p:cNvPr>
              <p:cNvGrpSpPr/>
              <p:nvPr/>
            </p:nvGrpSpPr>
            <p:grpSpPr>
              <a:xfrm>
                <a:off x="1919880" y="5043062"/>
                <a:ext cx="1545203" cy="2015010"/>
                <a:chOff x="1943157" y="4410380"/>
                <a:chExt cx="1545203" cy="2015010"/>
              </a:xfrm>
            </p:grpSpPr>
            <p:grpSp>
              <p:nvGrpSpPr>
                <p:cNvPr id="354" name="Groupe 353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FC7C7FC-5058-484C-86A5-EFC3835934E6}"/>
                    </a:ext>
                  </a:extLst>
                </p:cNvPr>
                <p:cNvGrpSpPr/>
                <p:nvPr/>
              </p:nvGrpSpPr>
              <p:grpSpPr>
                <a:xfrm>
                  <a:off x="1943157" y="4410380"/>
                  <a:ext cx="1545203" cy="1965403"/>
                  <a:chOff x="-2065728" y="3124042"/>
                  <a:chExt cx="1545203" cy="1965403"/>
                </a:xfrm>
              </p:grpSpPr>
              <p:sp>
                <p:nvSpPr>
                  <p:cNvPr id="356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421C8C2-1776-E246-99B2-AA0F56D1DB08}"/>
                      </a:ext>
                    </a:extLst>
                  </p:cNvPr>
                  <p:cNvSpPr txBox="1"/>
                  <p:nvPr/>
                </p:nvSpPr>
                <p:spPr>
                  <a:xfrm>
                    <a:off x="-1390243" y="3124042"/>
                    <a:ext cx="841715" cy="27699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6</a:t>
                    </a:r>
                  </a:p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(191 </a:t>
                    </a:r>
                    <a:r>
                      <a:rPr lang="en-US" sz="900" b="1" dirty="0" err="1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bp</a:t>
                    </a:r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)</a:t>
                    </a:r>
                  </a:p>
                </p:txBody>
              </p:sp>
              <p:grpSp>
                <p:nvGrpSpPr>
                  <p:cNvPr id="357" name="Groupe 356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5A81D80-0208-864B-8768-7B37FA9B043B}"/>
                      </a:ext>
                    </a:extLst>
                  </p:cNvPr>
                  <p:cNvGrpSpPr/>
                  <p:nvPr/>
                </p:nvGrpSpPr>
                <p:grpSpPr>
                  <a:xfrm>
                    <a:off x="-1436061" y="3469524"/>
                    <a:ext cx="915536" cy="233545"/>
                    <a:chOff x="-1436061" y="3469524"/>
                    <a:chExt cx="915536" cy="233545"/>
                  </a:xfrm>
                </p:grpSpPr>
                <p:sp>
                  <p:nvSpPr>
                    <p:cNvPr id="381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DF70B9B-76CC-BF46-B036-D097B736A1B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1159096" y="3469524"/>
                      <a:ext cx="391930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 err="1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cDNA</a:t>
                      </a:r>
                      <a:endParaRPr lang="en-US" sz="8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382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F5D2F1B-6F6D-5843-86B1-3C3AF84C432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1436061" y="3579958"/>
                      <a:ext cx="417823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 err="1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gDNA</a:t>
                      </a:r>
                      <a:endParaRPr lang="en-US" sz="8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383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AA6A4B7-34A4-7541-AA4A-038A0B21DF8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819810" y="3579958"/>
                      <a:ext cx="299285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RNA</a:t>
                      </a:r>
                    </a:p>
                  </p:txBody>
                </p:sp>
              </p:grpSp>
              <p:sp>
                <p:nvSpPr>
                  <p:cNvPr id="358" name="Parenthèse ouvrante 357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6039CE0-445E-934C-9EE1-9D522EFB3BDA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-992245" y="3041292"/>
                    <a:ext cx="45719" cy="800138"/>
                  </a:xfrm>
                  <a:prstGeom prst="leftBracket">
                    <a:avLst/>
                  </a:prstGeom>
                  <a:ln w="19050" cmpd="sng">
                    <a:solidFill>
                      <a:srgbClr val="00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>
                      <a:latin typeface="Arial"/>
                      <a:cs typeface="Arial"/>
                    </a:endParaRPr>
                  </a:p>
                </p:txBody>
              </p:sp>
              <p:grpSp>
                <p:nvGrpSpPr>
                  <p:cNvPr id="359" name="Groupe 358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A54FBF8-94FE-B74C-9717-F2DF097D0FB0}"/>
                      </a:ext>
                    </a:extLst>
                  </p:cNvPr>
                  <p:cNvGrpSpPr/>
                  <p:nvPr/>
                </p:nvGrpSpPr>
                <p:grpSpPr>
                  <a:xfrm>
                    <a:off x="-2065728" y="4180944"/>
                    <a:ext cx="411543" cy="908501"/>
                    <a:chOff x="-2065728" y="4180944"/>
                    <a:chExt cx="411543" cy="908501"/>
                  </a:xfrm>
                </p:grpSpPr>
                <p:grpSp>
                  <p:nvGrpSpPr>
                    <p:cNvPr id="360" name="Groupe 359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AB9AE3B-0E9E-0642-8E2F-D2A6DD414281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2044088" y="4577216"/>
                      <a:ext cx="389903" cy="184666"/>
                      <a:chOff x="-2044088" y="4577216"/>
                      <a:chExt cx="389903" cy="184666"/>
                    </a:xfrm>
                  </p:grpSpPr>
                  <p:cxnSp>
                    <p:nvCxnSpPr>
                      <p:cNvPr id="379" name="Connecteur droit avec flèche 378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356F059-8219-134F-A4D3-4F398D8163FA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-1762185" y="4669549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380" name="Rectangle 379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717A360-0B23-084E-99F3-B035E32EFF2D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-2044088" y="4577216"/>
                        <a:ext cx="314510" cy="184666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600" dirty="0">
                            <a:solidFill>
                              <a:srgbClr val="000000"/>
                            </a:solidFill>
                            <a:latin typeface="Arial"/>
                            <a:cs typeface="Arial"/>
                          </a:rPr>
                          <a:t>600</a:t>
                        </a:r>
                        <a:endParaRPr lang="fr-FR" sz="600" dirty="0">
                          <a:latin typeface="Arial"/>
                          <a:cs typeface="Arial"/>
                        </a:endParaRPr>
                      </a:p>
                    </p:txBody>
                  </p:sp>
                </p:grpSp>
                <p:grpSp>
                  <p:nvGrpSpPr>
                    <p:cNvPr id="361" name="Groupe 360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3CAF147-08A5-E44F-A599-09A3EF0A081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2065728" y="4180944"/>
                      <a:ext cx="411543" cy="908501"/>
                      <a:chOff x="-2065728" y="4180944"/>
                      <a:chExt cx="411543" cy="908501"/>
                    </a:xfrm>
                  </p:grpSpPr>
                  <p:grpSp>
                    <p:nvGrpSpPr>
                      <p:cNvPr id="362" name="Groupe 361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54635C9-DE84-2C43-8E80-33914A623017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2044088" y="4706133"/>
                        <a:ext cx="389903" cy="184666"/>
                        <a:chOff x="-2044088" y="4706133"/>
                        <a:chExt cx="389903" cy="184666"/>
                      </a:xfrm>
                    </p:grpSpPr>
                    <p:cxnSp>
                      <p:nvCxnSpPr>
                        <p:cNvPr id="377" name="Connecteur droit avec flèche 376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9C53C6F-83DC-6846-BA0F-7A8B3B741435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-1762185" y="4808708"/>
                          <a:ext cx="108000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378" name="Rectangle 377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6D4EB08-5912-ED49-A47E-7C7B8BB99A48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2044088" y="4706133"/>
                          <a:ext cx="31451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4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</p:grpSp>
                  <p:grpSp>
                    <p:nvGrpSpPr>
                      <p:cNvPr id="363" name="Groupe 362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D3F11BF-3A9F-EC4A-8321-E35E9BBA6A47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2044088" y="4460541"/>
                        <a:ext cx="389903" cy="184666"/>
                        <a:chOff x="-2044088" y="4441491"/>
                        <a:chExt cx="389903" cy="184666"/>
                      </a:xfrm>
                    </p:grpSpPr>
                    <p:cxnSp>
                      <p:nvCxnSpPr>
                        <p:cNvPr id="375" name="Connecteur droit avec flèche 374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60B2847-9CB3-094B-81AF-3EBA98BAE82A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-1762185" y="4538042"/>
                          <a:ext cx="108000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376" name="Rectangle 375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ACDD591-88F2-324F-B371-F829BFFF4D35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2044088" y="4441491"/>
                          <a:ext cx="31451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8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</p:grpSp>
                  <p:grpSp>
                    <p:nvGrpSpPr>
                      <p:cNvPr id="364" name="Groupe 363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F71A509-78B2-5F40-8505-A4C0E54DFD06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2065728" y="4305413"/>
                        <a:ext cx="411543" cy="184666"/>
                        <a:chOff x="-2065728" y="4305413"/>
                        <a:chExt cx="411543" cy="184666"/>
                      </a:xfrm>
                    </p:grpSpPr>
                    <p:sp>
                      <p:nvSpPr>
                        <p:cNvPr id="371" name="Rectangle 370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CBF2A99-166B-6E48-93AE-F9C57D45C20F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2065728" y="4305413"/>
                          <a:ext cx="35779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10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  <p:grpSp>
                      <p:nvGrpSpPr>
                        <p:cNvPr id="372" name="Groupe 371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01CE4E6-B087-1B49-94AF-BD6985D62C72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-1793708" y="4407883"/>
                          <a:ext cx="139523" cy="49020"/>
                          <a:chOff x="310274" y="3594610"/>
                          <a:chExt cx="139523" cy="49020"/>
                        </a:xfrm>
                      </p:grpSpPr>
                      <p:cxnSp>
                        <p:nvCxnSpPr>
                          <p:cNvPr id="373" name="Connecteur droit avec flèche 372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B858A6F-8A88-4B44-8B8C-957057BC2601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flipH="1">
                            <a:off x="341797" y="3643581"/>
                            <a:ext cx="108000" cy="0"/>
                          </a:xfrm>
                          <a:prstGeom prst="straightConnector1">
                            <a:avLst/>
                          </a:prstGeom>
                          <a:ln>
                            <a:solidFill>
                              <a:schemeClr val="tx1"/>
                            </a:solidFill>
                            <a:headEnd type="none"/>
                            <a:tailEnd type="none"/>
                          </a:ln>
                          <a:effectLst/>
                        </p:spPr>
                        <p:style>
                          <a:lnRef idx="2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1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374" name="Connecteur droit avec flèche 373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4472C1B-CCD3-6E49-981A-2DD424CBDB97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flipH="1" flipV="1">
                            <a:off x="310274" y="3594610"/>
                            <a:ext cx="36000" cy="49020"/>
                          </a:xfrm>
                          <a:prstGeom prst="straightConnector1">
                            <a:avLst/>
                          </a:prstGeom>
                          <a:ln>
                            <a:solidFill>
                              <a:schemeClr val="tx1"/>
                            </a:solidFill>
                            <a:headEnd type="none"/>
                            <a:tailEnd type="none"/>
                          </a:ln>
                          <a:effectLst/>
                        </p:spPr>
                        <p:style>
                          <a:lnRef idx="2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1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</p:grpSp>
                  <p:grpSp>
                    <p:nvGrpSpPr>
                      <p:cNvPr id="365" name="Groupe 364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7CAAC23-D636-7B42-AC9C-7F1D766A5878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2065728" y="4180944"/>
                        <a:ext cx="411543" cy="184666"/>
                        <a:chOff x="-2065728" y="4180944"/>
                        <a:chExt cx="411543" cy="184666"/>
                      </a:xfrm>
                    </p:grpSpPr>
                    <p:cxnSp>
                      <p:nvCxnSpPr>
                        <p:cNvPr id="369" name="Connecteur droit avec flèche 368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F094B96-3D8A-B547-87E6-67C82BAC30FA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-1762185" y="4292444"/>
                          <a:ext cx="108000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370" name="Rectangle 369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74AA984-D966-AB49-BCAC-9F94805A6503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2065728" y="4180944"/>
                          <a:ext cx="35779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15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</p:grpSp>
                  <p:grpSp>
                    <p:nvGrpSpPr>
                      <p:cNvPr id="366" name="Groupe 365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47BBD3F-BE6C-6A48-94F4-38F95817BCD5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2044088" y="4904779"/>
                        <a:ext cx="389903" cy="184666"/>
                        <a:chOff x="-2044088" y="4904779"/>
                        <a:chExt cx="389903" cy="184666"/>
                      </a:xfrm>
                    </p:grpSpPr>
                    <p:cxnSp>
                      <p:nvCxnSpPr>
                        <p:cNvPr id="367" name="Connecteur droit avec flèche 366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5A994BD-0736-1D40-96A0-00A4AD2C320B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-1762185" y="5000630"/>
                          <a:ext cx="108000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368" name="Rectangle 367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C96077A-8ED2-294B-8DA5-3BF532D8C8FD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2044088" y="4904779"/>
                          <a:ext cx="31451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2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</p:grpSp>
                </p:grpSp>
              </p:grpSp>
            </p:grpSp>
            <p:pic>
              <p:nvPicPr>
                <p:cNvPr id="200" name="Image 199"/>
                <p:cNvPicPr/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val="0"/>
                    </a:ext>
                  </a:extLst>
                </a:blip>
                <a:srcRect l="55848" t="20881" r="21319" b="40082"/>
                <a:stretch/>
              </p:blipFill>
              <p:spPr bwMode="auto">
                <a:xfrm>
                  <a:off x="2346797" y="5028590"/>
                  <a:ext cx="1087257" cy="1396800"/>
                </a:xfrm>
                <a:prstGeom prst="rect">
                  <a:avLst/>
                </a:prstGeom>
                <a:ln>
                  <a:noFill/>
                </a:ln>
                <a:extLst>
                  <a:ext uri="{53640926-AAD7-44d8-BBD7-CCE9431645EC}">
                    <a14:shadowObscured xmlns:a="http://schemas.openxmlformats.org/drawingml/2006/main" xmlns:r="http://schemas.openxmlformats.org/officeDocument/2006/relationships" xmlns:p="http://schemas.openxmlformats.org/presentationml/2006/main" xmlns="" xmlns:a14="http://schemas.microsoft.com/office/drawing/2010/main" xmlns:mv="urn:schemas-microsoft-com:mac:vml" xmlns:mc="http://schemas.openxmlformats.org/markup-compatibility/2006"/>
                  </a:ext>
                </a:extLst>
              </p:spPr>
            </p:pic>
          </p:grpSp>
          <p:grpSp>
            <p:nvGrpSpPr>
              <p:cNvPr id="31" name="Groupe 30">
                <a:extLst>
                  <a:ext uri="{FF2B5EF4-FFF2-40B4-BE49-F238E27FC236}">
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6113F41-C81E-2145-81E5-E400C648F18F}"/>
                  </a:ext>
                </a:extLst>
              </p:cNvPr>
              <p:cNvGrpSpPr/>
              <p:nvPr/>
            </p:nvGrpSpPr>
            <p:grpSpPr>
              <a:xfrm>
                <a:off x="3360120" y="5042166"/>
                <a:ext cx="1545201" cy="2015052"/>
                <a:chOff x="3341831" y="4409484"/>
                <a:chExt cx="1545201" cy="2015052"/>
              </a:xfrm>
            </p:grpSpPr>
            <p:grpSp>
              <p:nvGrpSpPr>
                <p:cNvPr id="385" name="Groupe 384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DC7CBFB-6ED2-B245-9D7E-7485D5A4FF97}"/>
                    </a:ext>
                  </a:extLst>
                </p:cNvPr>
                <p:cNvGrpSpPr/>
                <p:nvPr/>
              </p:nvGrpSpPr>
              <p:grpSpPr>
                <a:xfrm>
                  <a:off x="3341831" y="4409484"/>
                  <a:ext cx="1527389" cy="1911962"/>
                  <a:chOff x="-2065728" y="3147794"/>
                  <a:chExt cx="1527389" cy="1911962"/>
                </a:xfrm>
              </p:grpSpPr>
              <p:sp>
                <p:nvSpPr>
                  <p:cNvPr id="387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F6B1553-1DB7-4E41-8C0F-195218F0F7B2}"/>
                      </a:ext>
                    </a:extLst>
                  </p:cNvPr>
                  <p:cNvSpPr txBox="1"/>
                  <p:nvPr/>
                </p:nvSpPr>
                <p:spPr>
                  <a:xfrm>
                    <a:off x="-1408057" y="3147794"/>
                    <a:ext cx="841715" cy="27699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7</a:t>
                    </a:r>
                  </a:p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(148 </a:t>
                    </a:r>
                    <a:r>
                      <a:rPr lang="en-US" sz="900" b="1" dirty="0" err="1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bp</a:t>
                    </a:r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)</a:t>
                    </a:r>
                  </a:p>
                </p:txBody>
              </p:sp>
              <p:grpSp>
                <p:nvGrpSpPr>
                  <p:cNvPr id="388" name="Groupe 387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F402D8C-9640-7543-91DA-8B7F0B1D04C8}"/>
                      </a:ext>
                    </a:extLst>
                  </p:cNvPr>
                  <p:cNvGrpSpPr/>
                  <p:nvPr/>
                </p:nvGrpSpPr>
                <p:grpSpPr>
                  <a:xfrm>
                    <a:off x="-1453875" y="3493276"/>
                    <a:ext cx="915536" cy="233545"/>
                    <a:chOff x="-1453875" y="3493276"/>
                    <a:chExt cx="915536" cy="233545"/>
                  </a:xfrm>
                </p:grpSpPr>
                <p:sp>
                  <p:nvSpPr>
                    <p:cNvPr id="412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DEABAAB-9970-5346-BEBB-D195593AC92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1176910" y="3493276"/>
                      <a:ext cx="391930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 err="1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cDNA</a:t>
                      </a:r>
                      <a:endParaRPr lang="en-US" sz="8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413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862CB4A-68A6-B84F-AA01-658031685AA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1453875" y="3603710"/>
                      <a:ext cx="417823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 err="1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gDNA</a:t>
                      </a:r>
                      <a:endParaRPr lang="en-US" sz="8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414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CAE436C-CD46-F341-93FE-EF672959AA6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837624" y="3603710"/>
                      <a:ext cx="299285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RNA</a:t>
                      </a:r>
                    </a:p>
                  </p:txBody>
                </p:sp>
              </p:grpSp>
              <p:sp>
                <p:nvSpPr>
                  <p:cNvPr id="389" name="Parenthèse ouvrante 388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FDC9CA7-9820-2841-8630-67E94C438D8F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-1010059" y="3065044"/>
                    <a:ext cx="45719" cy="800138"/>
                  </a:xfrm>
                  <a:prstGeom prst="leftBracket">
                    <a:avLst/>
                  </a:prstGeom>
                  <a:ln w="19050" cmpd="sng">
                    <a:solidFill>
                      <a:srgbClr val="00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>
                      <a:latin typeface="Arial"/>
                      <a:cs typeface="Arial"/>
                    </a:endParaRPr>
                  </a:p>
                </p:txBody>
              </p:sp>
              <p:grpSp>
                <p:nvGrpSpPr>
                  <p:cNvPr id="390" name="Groupe 389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BF69557-B4FF-2749-B4E0-A02D1A4330E2}"/>
                      </a:ext>
                    </a:extLst>
                  </p:cNvPr>
                  <p:cNvGrpSpPr/>
                  <p:nvPr/>
                </p:nvGrpSpPr>
                <p:grpSpPr>
                  <a:xfrm>
                    <a:off x="-2065728" y="4317513"/>
                    <a:ext cx="411543" cy="742243"/>
                    <a:chOff x="-2065728" y="4317513"/>
                    <a:chExt cx="411543" cy="742243"/>
                  </a:xfrm>
                </p:grpSpPr>
                <p:grpSp>
                  <p:nvGrpSpPr>
                    <p:cNvPr id="391" name="Groupe 390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79DB5BE-4EE1-0648-AEA9-1EBE0DE24722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2044088" y="4648468"/>
                      <a:ext cx="389903" cy="184666"/>
                      <a:chOff x="-2044088" y="4648468"/>
                      <a:chExt cx="389903" cy="184666"/>
                    </a:xfrm>
                  </p:grpSpPr>
                  <p:cxnSp>
                    <p:nvCxnSpPr>
                      <p:cNvPr id="410" name="Connecteur droit avec flèche 409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FF522FD-F7B5-C940-9A7E-F9E4B643998A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-1762185" y="4740801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411" name="Rectangle 410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7764EB2-B1AA-0943-A99A-EEE8C6AED1E9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-2044088" y="4648468"/>
                        <a:ext cx="314510" cy="184666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600" dirty="0">
                            <a:solidFill>
                              <a:srgbClr val="000000"/>
                            </a:solidFill>
                            <a:latin typeface="Arial"/>
                            <a:cs typeface="Arial"/>
                          </a:rPr>
                          <a:t>600</a:t>
                        </a:r>
                        <a:endParaRPr lang="fr-FR" sz="600" dirty="0">
                          <a:latin typeface="Arial"/>
                          <a:cs typeface="Arial"/>
                        </a:endParaRPr>
                      </a:p>
                    </p:txBody>
                  </p:sp>
                </p:grpSp>
                <p:grpSp>
                  <p:nvGrpSpPr>
                    <p:cNvPr id="392" name="Groupe 391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F4CFCF8-0933-E84F-993E-5CFB133B1B49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2065728" y="4317513"/>
                      <a:ext cx="411543" cy="742243"/>
                      <a:chOff x="-2065728" y="4317513"/>
                      <a:chExt cx="411543" cy="742243"/>
                    </a:xfrm>
                  </p:grpSpPr>
                  <p:grpSp>
                    <p:nvGrpSpPr>
                      <p:cNvPr id="393" name="Groupe 392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CB19D98-4BEC-564F-A35D-E816D589F02E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2044088" y="4747698"/>
                        <a:ext cx="389903" cy="184666"/>
                        <a:chOff x="-2044088" y="4747698"/>
                        <a:chExt cx="389903" cy="184666"/>
                      </a:xfrm>
                    </p:grpSpPr>
                    <p:cxnSp>
                      <p:nvCxnSpPr>
                        <p:cNvPr id="408" name="Connecteur droit avec flèche 407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270F4DE-A6EA-864D-851E-722982514B3D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-1762185" y="4850273"/>
                          <a:ext cx="108000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409" name="Rectangle 408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A6032E6-CA58-3245-A74A-A98C82D93DAC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2044088" y="4747698"/>
                          <a:ext cx="31451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4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</p:grpSp>
                  <p:grpSp>
                    <p:nvGrpSpPr>
                      <p:cNvPr id="394" name="Groupe 393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9EBFFA9-DB8F-0746-B63E-69B2E91051C7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2044088" y="4549606"/>
                        <a:ext cx="389903" cy="184666"/>
                        <a:chOff x="-2044088" y="4530556"/>
                        <a:chExt cx="389903" cy="184666"/>
                      </a:xfrm>
                    </p:grpSpPr>
                    <p:cxnSp>
                      <p:nvCxnSpPr>
                        <p:cNvPr id="406" name="Connecteur droit avec flèche 405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FB022E5-8DC7-FC41-9897-248AEF3EBDEA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-1762185" y="4627107"/>
                          <a:ext cx="108000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407" name="Rectangle 406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DB21A5D-3951-BB48-869C-BF69A071CE86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2044088" y="4530556"/>
                          <a:ext cx="31451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8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</p:grpSp>
                  <p:grpSp>
                    <p:nvGrpSpPr>
                      <p:cNvPr id="395" name="Groupe 394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A054B20-687E-224F-807E-8555EB90E908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2065728" y="4418228"/>
                        <a:ext cx="411543" cy="184666"/>
                        <a:chOff x="-2065728" y="4418228"/>
                        <a:chExt cx="411543" cy="184666"/>
                      </a:xfrm>
                    </p:grpSpPr>
                    <p:sp>
                      <p:nvSpPr>
                        <p:cNvPr id="402" name="Rectangle 401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2FD886D-7800-8949-B589-9B7740D6CA82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2065728" y="4418228"/>
                          <a:ext cx="35779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10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  <p:grpSp>
                      <p:nvGrpSpPr>
                        <p:cNvPr id="403" name="Groupe 402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678A1FC-C587-B446-8379-1D3D1551B495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-1793708" y="4520698"/>
                          <a:ext cx="139523" cy="49020"/>
                          <a:chOff x="310274" y="3707425"/>
                          <a:chExt cx="139523" cy="49020"/>
                        </a:xfrm>
                      </p:grpSpPr>
                      <p:cxnSp>
                        <p:nvCxnSpPr>
                          <p:cNvPr id="404" name="Connecteur droit avec flèche 403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2462F97-EEEF-F54F-BD2E-3B61C8A758F0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flipH="1">
                            <a:off x="341797" y="3756396"/>
                            <a:ext cx="108000" cy="0"/>
                          </a:xfrm>
                          <a:prstGeom prst="straightConnector1">
                            <a:avLst/>
                          </a:prstGeom>
                          <a:ln>
                            <a:solidFill>
                              <a:schemeClr val="tx1"/>
                            </a:solidFill>
                            <a:headEnd type="none"/>
                            <a:tailEnd type="none"/>
                          </a:ln>
                          <a:effectLst/>
                        </p:spPr>
                        <p:style>
                          <a:lnRef idx="2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1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405" name="Connecteur droit avec flèche 404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626B061-8974-8945-A90C-386BEF7A03CF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flipH="1" flipV="1">
                            <a:off x="310274" y="3707425"/>
                            <a:ext cx="36000" cy="49020"/>
                          </a:xfrm>
                          <a:prstGeom prst="straightConnector1">
                            <a:avLst/>
                          </a:prstGeom>
                          <a:ln>
                            <a:solidFill>
                              <a:schemeClr val="tx1"/>
                            </a:solidFill>
                            <a:headEnd type="none"/>
                            <a:tailEnd type="none"/>
                          </a:ln>
                          <a:effectLst/>
                        </p:spPr>
                        <p:style>
                          <a:lnRef idx="2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1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</p:grpSp>
                  <p:grpSp>
                    <p:nvGrpSpPr>
                      <p:cNvPr id="396" name="Groupe 395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6790C68-142C-7D45-8F62-B6CD1D9EA584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2065728" y="4317513"/>
                        <a:ext cx="411543" cy="184666"/>
                        <a:chOff x="-2065728" y="4317513"/>
                        <a:chExt cx="411543" cy="184666"/>
                      </a:xfrm>
                    </p:grpSpPr>
                    <p:cxnSp>
                      <p:nvCxnSpPr>
                        <p:cNvPr id="400" name="Connecteur droit avec flèche 399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2BF7DD8-DB62-F44A-BE2A-5D0CFEA74A99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-1762185" y="4429013"/>
                          <a:ext cx="108000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401" name="Rectangle 400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1E8546C-90E6-2948-8719-F05A5C236D27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2065728" y="4317513"/>
                          <a:ext cx="35779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15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</p:grpSp>
                  <p:grpSp>
                    <p:nvGrpSpPr>
                      <p:cNvPr id="397" name="Groupe 396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1B92BF3-FCA0-894D-A6C2-F06B078EC414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2044088" y="4875090"/>
                        <a:ext cx="389903" cy="184666"/>
                        <a:chOff x="-2044088" y="4875090"/>
                        <a:chExt cx="389903" cy="184666"/>
                      </a:xfrm>
                    </p:grpSpPr>
                    <p:cxnSp>
                      <p:nvCxnSpPr>
                        <p:cNvPr id="398" name="Connecteur droit avec flèche 397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53FDC0D-7ABD-664A-AFE0-C9797C44CDF1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-1762185" y="4970941"/>
                          <a:ext cx="108000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399" name="Rectangle 398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4CAAC11-EA9C-3D44-B803-59A0075FC651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2044088" y="4875090"/>
                          <a:ext cx="31451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2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</p:grpSp>
                </p:grpSp>
              </p:grpSp>
            </p:grpSp>
            <p:pic>
              <p:nvPicPr>
                <p:cNvPr id="415" name="Image 414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D812501-3111-2445-B70B-20315B11F1FE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val="0"/>
                    </a:ext>
                  </a:extLst>
                </a:blip>
                <a:srcRect l="71279" t="30319" r="10534" b="30252"/>
                <a:stretch/>
              </p:blipFill>
              <p:spPr bwMode="auto">
                <a:xfrm>
                  <a:off x="3735032" y="5027736"/>
                  <a:ext cx="1152000" cy="1396800"/>
                </a:xfrm>
                <a:prstGeom prst="rect">
                  <a:avLst/>
                </a:prstGeom>
                <a:ln>
                  <a:noFill/>
                </a:ln>
                <a:extLst>
                  <a:ext uri="{53640926-AAD7-44d8-BBD7-CCE9431645EC}">
                    <a14:shadowObscured xmlns:a="http://schemas.openxmlformats.org/drawingml/2006/main" xmlns:r="http://schemas.openxmlformats.org/officeDocument/2006/relationships" xmlns:p="http://schemas.openxmlformats.org/presentationml/2006/main" xmlns="" xmlns:a14="http://schemas.microsoft.com/office/drawing/2010/main" xmlns:mv="urn:schemas-microsoft-com:mac:vml" xmlns:mc="http://schemas.openxmlformats.org/markup-compatibility/2006"/>
                  </a:ext>
                </a:extLst>
              </p:spPr>
            </p:pic>
          </p:grpSp>
          <p:grpSp>
            <p:nvGrpSpPr>
              <p:cNvPr id="33" name="Groupe 32">
                <a:extLst>
                  <a:ext uri="{FF2B5EF4-FFF2-40B4-BE49-F238E27FC236}">
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944368C-AD3A-BE4C-9E49-BD41EA91EEF5}"/>
                  </a:ext>
                </a:extLst>
              </p:cNvPr>
              <p:cNvGrpSpPr/>
              <p:nvPr/>
            </p:nvGrpSpPr>
            <p:grpSpPr>
              <a:xfrm>
                <a:off x="4809975" y="5041506"/>
                <a:ext cx="1555036" cy="2012529"/>
                <a:chOff x="4791687" y="4408823"/>
                <a:chExt cx="1555036" cy="2012529"/>
              </a:xfrm>
            </p:grpSpPr>
            <p:sp>
              <p:nvSpPr>
                <p:cNvPr id="419" name="TextBox 25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2D0EE81-0F82-2640-A791-59C6AEB690AE}"/>
                    </a:ext>
                  </a:extLst>
                </p:cNvPr>
                <p:cNvSpPr txBox="1"/>
                <p:nvPr/>
              </p:nvSpPr>
              <p:spPr>
                <a:xfrm>
                  <a:off x="5437482" y="4408823"/>
                  <a:ext cx="841715" cy="2769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sz="900" b="1" dirty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8</a:t>
                  </a:r>
                </a:p>
                <a:p>
                  <a:pPr algn="ctr"/>
                  <a:r>
                    <a:rPr lang="en-US" sz="900" b="1" dirty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(267 </a:t>
                  </a:r>
                  <a:r>
                    <a:rPr lang="en-US" sz="900" b="1" dirty="0" err="1">
                      <a:solidFill>
                        <a:srgbClr val="000000"/>
                      </a:solidFill>
                      <a:latin typeface="Arial"/>
                      <a:cs typeface="Arial"/>
                    </a:rPr>
                    <a:t>bp</a:t>
                  </a:r>
                  <a:r>
                    <a:rPr lang="en-US" sz="900" b="1" dirty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)</a:t>
                  </a:r>
                </a:p>
              </p:txBody>
            </p:sp>
            <p:grpSp>
              <p:nvGrpSpPr>
                <p:cNvPr id="420" name="Groupe 419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C9AF80F-DB34-354E-A5A9-24CA97CC83C9}"/>
                    </a:ext>
                  </a:extLst>
                </p:cNvPr>
                <p:cNvGrpSpPr/>
                <p:nvPr/>
              </p:nvGrpSpPr>
              <p:grpSpPr>
                <a:xfrm>
                  <a:off x="5391664" y="4772119"/>
                  <a:ext cx="915536" cy="233545"/>
                  <a:chOff x="-1465751" y="3493276"/>
                  <a:chExt cx="915536" cy="233545"/>
                </a:xfrm>
              </p:grpSpPr>
              <p:sp>
                <p:nvSpPr>
                  <p:cNvPr id="444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62686B7-FF3E-FE42-BED9-C5D45693F801}"/>
                      </a:ext>
                    </a:extLst>
                  </p:cNvPr>
                  <p:cNvSpPr txBox="1"/>
                  <p:nvPr/>
                </p:nvSpPr>
                <p:spPr>
                  <a:xfrm>
                    <a:off x="-1188786" y="3493276"/>
                    <a:ext cx="391930" cy="12311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dirty="0" err="1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cDNA</a:t>
                    </a:r>
                    <a:endParaRPr lang="en-US" sz="800" b="1" dirty="0">
                      <a:solidFill>
                        <a:srgbClr val="000000"/>
                      </a:solidFill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445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93839E3-0773-0340-B43E-6B6B11FB3C4D}"/>
                      </a:ext>
                    </a:extLst>
                  </p:cNvPr>
                  <p:cNvSpPr txBox="1"/>
                  <p:nvPr/>
                </p:nvSpPr>
                <p:spPr>
                  <a:xfrm>
                    <a:off x="-1465751" y="3603710"/>
                    <a:ext cx="417823" cy="12311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dirty="0" err="1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gDNA</a:t>
                    </a:r>
                    <a:endParaRPr lang="en-US" sz="800" b="1" dirty="0">
                      <a:solidFill>
                        <a:srgbClr val="000000"/>
                      </a:solidFill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446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260C02F-CF8B-C54F-B17E-CC85C8F8B9DF}"/>
                      </a:ext>
                    </a:extLst>
                  </p:cNvPr>
                  <p:cNvSpPr txBox="1"/>
                  <p:nvPr/>
                </p:nvSpPr>
                <p:spPr>
                  <a:xfrm>
                    <a:off x="-849500" y="3603710"/>
                    <a:ext cx="299285" cy="12311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RNA</a:t>
                    </a:r>
                  </a:p>
                </p:txBody>
              </p:sp>
            </p:grpSp>
            <p:sp>
              <p:nvSpPr>
                <p:cNvPr id="421" name="Parenthèse ouvrante 420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B38333D-8CA0-EA4F-8904-4F56A49AFAEC}"/>
                    </a:ext>
                  </a:extLst>
                </p:cNvPr>
                <p:cNvSpPr/>
                <p:nvPr/>
              </p:nvSpPr>
              <p:spPr>
                <a:xfrm rot="5400000">
                  <a:off x="5835480" y="4326073"/>
                  <a:ext cx="45719" cy="800138"/>
                </a:xfrm>
                <a:prstGeom prst="leftBracket">
                  <a:avLst/>
                </a:prstGeom>
                <a:ln w="19050" cmpd="sng">
                  <a:solidFill>
                    <a:srgbClr val="000000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/>
                    <a:cs typeface="Arial"/>
                  </a:endParaRPr>
                </a:p>
              </p:txBody>
            </p:sp>
            <p:grpSp>
              <p:nvGrpSpPr>
                <p:cNvPr id="422" name="Groupe 421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5CC89DF-8D83-3348-950D-BA3CA3CFB52F}"/>
                    </a:ext>
                  </a:extLst>
                </p:cNvPr>
                <p:cNvGrpSpPr/>
                <p:nvPr/>
              </p:nvGrpSpPr>
              <p:grpSpPr>
                <a:xfrm>
                  <a:off x="4791687" y="5483539"/>
                  <a:ext cx="411543" cy="872874"/>
                  <a:chOff x="-2065728" y="4204696"/>
                  <a:chExt cx="411543" cy="872874"/>
                </a:xfrm>
              </p:grpSpPr>
              <p:grpSp>
                <p:nvGrpSpPr>
                  <p:cNvPr id="423" name="Groupe 422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FDE137D-0B75-0E4B-8B1E-D259D7F0851E}"/>
                      </a:ext>
                    </a:extLst>
                  </p:cNvPr>
                  <p:cNvGrpSpPr/>
                  <p:nvPr/>
                </p:nvGrpSpPr>
                <p:grpSpPr>
                  <a:xfrm>
                    <a:off x="-2044088" y="4589091"/>
                    <a:ext cx="389903" cy="184666"/>
                    <a:chOff x="-2044088" y="4589091"/>
                    <a:chExt cx="389903" cy="184666"/>
                  </a:xfrm>
                </p:grpSpPr>
                <p:cxnSp>
                  <p:nvCxnSpPr>
                    <p:cNvPr id="442" name="Connecteur droit avec flèche 441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91AE8DB-6BFA-584B-B623-008AFF07FA6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-1762185" y="4681424"/>
                      <a:ext cx="10800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headEnd type="none"/>
                      <a:tailEnd type="none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43" name="Rectangle 442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22C77D0-F3D0-1947-9038-B96BA51A8C1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-2044088" y="4589091"/>
                      <a:ext cx="314510" cy="184666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600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600</a:t>
                      </a:r>
                      <a:endParaRPr lang="fr-FR" sz="600" dirty="0">
                        <a:latin typeface="Arial"/>
                        <a:cs typeface="Arial"/>
                      </a:endParaRPr>
                    </a:p>
                  </p:txBody>
                </p:sp>
              </p:grpSp>
              <p:grpSp>
                <p:nvGrpSpPr>
                  <p:cNvPr id="424" name="Groupe 423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3431DCC-FEFD-C045-B340-54ABFC6FC9FA}"/>
                      </a:ext>
                    </a:extLst>
                  </p:cNvPr>
                  <p:cNvGrpSpPr/>
                  <p:nvPr/>
                </p:nvGrpSpPr>
                <p:grpSpPr>
                  <a:xfrm>
                    <a:off x="-2065728" y="4204696"/>
                    <a:ext cx="411543" cy="872874"/>
                    <a:chOff x="-2065728" y="4204696"/>
                    <a:chExt cx="411543" cy="872874"/>
                  </a:xfrm>
                </p:grpSpPr>
                <p:grpSp>
                  <p:nvGrpSpPr>
                    <p:cNvPr id="425" name="Groupe 424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88A9494-6C35-2B4E-92C5-1F0C8D88C977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2044088" y="4729884"/>
                      <a:ext cx="389903" cy="184666"/>
                      <a:chOff x="-2044088" y="4729884"/>
                      <a:chExt cx="389903" cy="184666"/>
                    </a:xfrm>
                  </p:grpSpPr>
                  <p:cxnSp>
                    <p:nvCxnSpPr>
                      <p:cNvPr id="440" name="Connecteur droit avec flèche 439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DE8A414-3A54-424D-98DF-087F557CA1A3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-1762185" y="4832459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441" name="Rectangle 440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8CBF27A-E47B-DB43-A2FE-8998D6D80DAB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-2044088" y="4729884"/>
                        <a:ext cx="314510" cy="184666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600" dirty="0">
                            <a:solidFill>
                              <a:srgbClr val="000000"/>
                            </a:solidFill>
                            <a:latin typeface="Arial"/>
                            <a:cs typeface="Arial"/>
                          </a:rPr>
                          <a:t>400</a:t>
                        </a:r>
                        <a:endParaRPr lang="fr-FR" sz="600" dirty="0">
                          <a:latin typeface="Arial"/>
                          <a:cs typeface="Arial"/>
                        </a:endParaRPr>
                      </a:p>
                    </p:txBody>
                  </p:sp>
                </p:grpSp>
                <p:grpSp>
                  <p:nvGrpSpPr>
                    <p:cNvPr id="426" name="Groupe 4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C585E42-8742-D247-B12A-A5CC32E81BFD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2044088" y="4472416"/>
                      <a:ext cx="389903" cy="184666"/>
                      <a:chOff x="-2044088" y="4453366"/>
                      <a:chExt cx="389903" cy="184666"/>
                    </a:xfrm>
                  </p:grpSpPr>
                  <p:cxnSp>
                    <p:nvCxnSpPr>
                      <p:cNvPr id="438" name="Connecteur droit avec flèche 437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E13088C-D575-E142-AD1C-7966AADF126F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-1762185" y="4549917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439" name="Rectangle 438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E23BA2D-F24B-EB45-A0DA-7D14C522BD7C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-2044088" y="4453366"/>
                        <a:ext cx="314510" cy="184666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600" dirty="0">
                            <a:solidFill>
                              <a:srgbClr val="000000"/>
                            </a:solidFill>
                            <a:latin typeface="Arial"/>
                            <a:cs typeface="Arial"/>
                          </a:rPr>
                          <a:t>800</a:t>
                        </a:r>
                        <a:endParaRPr lang="fr-FR" sz="600" dirty="0">
                          <a:latin typeface="Arial"/>
                          <a:cs typeface="Arial"/>
                        </a:endParaRPr>
                      </a:p>
                    </p:txBody>
                  </p:sp>
                </p:grpSp>
                <p:grpSp>
                  <p:nvGrpSpPr>
                    <p:cNvPr id="427" name="Groupe 426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D8914CE-7D13-4C43-977F-7924E3058BF2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2065728" y="4323225"/>
                      <a:ext cx="411543" cy="184666"/>
                      <a:chOff x="-2065728" y="4323225"/>
                      <a:chExt cx="411543" cy="184666"/>
                    </a:xfrm>
                  </p:grpSpPr>
                  <p:sp>
                    <p:nvSpPr>
                      <p:cNvPr id="434" name="Rectangle 433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BD6E5DF-C301-BC4B-9CC0-560873746C78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-2065728" y="4323225"/>
                        <a:ext cx="357790" cy="184666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600" dirty="0">
                            <a:solidFill>
                              <a:srgbClr val="000000"/>
                            </a:solidFill>
                            <a:latin typeface="Arial"/>
                            <a:cs typeface="Arial"/>
                          </a:rPr>
                          <a:t>1000</a:t>
                        </a:r>
                        <a:endParaRPr lang="fr-FR" sz="600" dirty="0">
                          <a:latin typeface="Arial"/>
                          <a:cs typeface="Arial"/>
                        </a:endParaRPr>
                      </a:p>
                    </p:txBody>
                  </p:sp>
                  <p:grpSp>
                    <p:nvGrpSpPr>
                      <p:cNvPr id="435" name="Groupe 434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7E707CA-531C-6243-A9BC-01DB6DB4026A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1793708" y="4425695"/>
                        <a:ext cx="139523" cy="49020"/>
                        <a:chOff x="310274" y="3612422"/>
                        <a:chExt cx="139523" cy="49020"/>
                      </a:xfrm>
                    </p:grpSpPr>
                    <p:cxnSp>
                      <p:nvCxnSpPr>
                        <p:cNvPr id="436" name="Connecteur droit avec flèche 435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B4A25EF-74C4-A945-9B31-81D0CDA6739C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341797" y="3661393"/>
                          <a:ext cx="108000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437" name="Connecteur droit avec flèche 436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E495E00-421D-964E-9FD3-9A05DFC602A2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 flipV="1">
                          <a:off x="310274" y="3612422"/>
                          <a:ext cx="36000" cy="4902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</p:grpSp>
                <p:grpSp>
                  <p:nvGrpSpPr>
                    <p:cNvPr id="428" name="Groupe 427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685CF79-F29F-544E-93F3-8F57B0758497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2065728" y="4204696"/>
                      <a:ext cx="411543" cy="184666"/>
                      <a:chOff x="-2065728" y="4204696"/>
                      <a:chExt cx="411543" cy="184666"/>
                    </a:xfrm>
                  </p:grpSpPr>
                  <p:cxnSp>
                    <p:nvCxnSpPr>
                      <p:cNvPr id="432" name="Connecteur droit avec flèche 431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A520211-525E-964C-91B4-6DF47C220C4D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-1762185" y="4316196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433" name="Rectangle 432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C8D3191-6137-CF42-A1D7-48DF3D0602E5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-2065728" y="4204696"/>
                        <a:ext cx="357790" cy="184666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600" dirty="0">
                            <a:solidFill>
                              <a:srgbClr val="000000"/>
                            </a:solidFill>
                            <a:latin typeface="Arial"/>
                            <a:cs typeface="Arial"/>
                          </a:rPr>
                          <a:t>1500</a:t>
                        </a:r>
                        <a:endParaRPr lang="fr-FR" sz="600" dirty="0">
                          <a:latin typeface="Arial"/>
                          <a:cs typeface="Arial"/>
                        </a:endParaRPr>
                      </a:p>
                    </p:txBody>
                  </p:sp>
                </p:grpSp>
                <p:grpSp>
                  <p:nvGrpSpPr>
                    <p:cNvPr id="429" name="Groupe 428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A88C010-92EC-5B4E-964C-7D292509BFF0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2044088" y="4892904"/>
                      <a:ext cx="389903" cy="184666"/>
                      <a:chOff x="-2044088" y="4892904"/>
                      <a:chExt cx="389903" cy="184666"/>
                    </a:xfrm>
                  </p:grpSpPr>
                  <p:cxnSp>
                    <p:nvCxnSpPr>
                      <p:cNvPr id="430" name="Connecteur droit avec flèche 429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1ED56B1-7151-A845-BC66-22C898547FCE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-1762185" y="4988755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431" name="Rectangle 430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0A65C98-3EA0-3940-964C-13750FDF0A8B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-2044088" y="4892904"/>
                        <a:ext cx="314510" cy="184666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600" dirty="0">
                            <a:solidFill>
                              <a:srgbClr val="000000"/>
                            </a:solidFill>
                            <a:latin typeface="Arial"/>
                            <a:cs typeface="Arial"/>
                          </a:rPr>
                          <a:t>200</a:t>
                        </a:r>
                        <a:endParaRPr lang="fr-FR" sz="600" dirty="0">
                          <a:latin typeface="Arial"/>
                          <a:cs typeface="Arial"/>
                        </a:endParaRPr>
                      </a:p>
                    </p:txBody>
                  </p:sp>
                </p:grpSp>
              </p:grpSp>
            </p:grpSp>
            <p:pic>
              <p:nvPicPr>
                <p:cNvPr id="447" name="Image 446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CCB2DD8-ABC5-5745-99AB-1F0BADC630A3}"/>
                    </a:ext>
                  </a:extLst>
                </p:cNvPr>
                <p:cNvPicPr/>
                <p:nvPr/>
              </p:nvPicPr>
              <p:blipFill rotWithShape="1">
                <a:blip r:embed="rId7">
                  <a:extLst>
                    <a:ext uri="{28A0092B-C50C-407E-A947-70E740481C1C}">
                      <a14:useLocalDpi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val="0"/>
                    </a:ext>
                  </a:extLst>
                </a:blip>
                <a:srcRect l="40148" t="31581" r="42183" b="24306"/>
                <a:stretch/>
              </p:blipFill>
              <p:spPr bwMode="auto">
                <a:xfrm>
                  <a:off x="5194723" y="5024552"/>
                  <a:ext cx="1152000" cy="1396800"/>
                </a:xfrm>
                <a:prstGeom prst="rect">
                  <a:avLst/>
                </a:prstGeom>
                <a:ln>
                  <a:noFill/>
                </a:ln>
                <a:extLst>
                  <a:ext uri="{53640926-AAD7-44d8-BBD7-CCE9431645EC}">
                    <a14:shadowObscured xmlns:a="http://schemas.openxmlformats.org/drawingml/2006/main" xmlns:r="http://schemas.openxmlformats.org/officeDocument/2006/relationships" xmlns:p="http://schemas.openxmlformats.org/presentationml/2006/main" xmlns="" xmlns:a14="http://schemas.microsoft.com/office/drawing/2010/main" xmlns:mv="urn:schemas-microsoft-com:mac:vml" xmlns:mc="http://schemas.openxmlformats.org/markup-compatibility/2006"/>
                  </a:ext>
                </a:extLst>
              </p:spPr>
            </p:pic>
          </p:grpSp>
          <p:grpSp>
            <p:nvGrpSpPr>
              <p:cNvPr id="36" name="Groupe 35">
                <a:extLst>
                  <a:ext uri="{FF2B5EF4-FFF2-40B4-BE49-F238E27FC236}">
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915632A-EBC6-E64B-9D72-543114607EC0}"/>
                  </a:ext>
                </a:extLst>
              </p:cNvPr>
              <p:cNvGrpSpPr/>
              <p:nvPr/>
            </p:nvGrpSpPr>
            <p:grpSpPr>
              <a:xfrm>
                <a:off x="396112" y="7252745"/>
                <a:ext cx="1563638" cy="2058970"/>
                <a:chOff x="469264" y="5477063"/>
                <a:chExt cx="1563638" cy="2058970"/>
              </a:xfrm>
            </p:grpSpPr>
            <p:grpSp>
              <p:nvGrpSpPr>
                <p:cNvPr id="448" name="Groupe 447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91D6371-2F78-CD4A-BC30-4E7C69F0AB59}"/>
                    </a:ext>
                  </a:extLst>
                </p:cNvPr>
                <p:cNvGrpSpPr/>
                <p:nvPr/>
              </p:nvGrpSpPr>
              <p:grpSpPr>
                <a:xfrm>
                  <a:off x="469264" y="5477063"/>
                  <a:ext cx="1563638" cy="2058970"/>
                  <a:chOff x="4819187" y="4422573"/>
                  <a:chExt cx="1563638" cy="2058970"/>
                </a:xfrm>
              </p:grpSpPr>
              <p:sp>
                <p:nvSpPr>
                  <p:cNvPr id="449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AC4049F-42EF-1E40-8E7D-672706F25A2A}"/>
                      </a:ext>
                    </a:extLst>
                  </p:cNvPr>
                  <p:cNvSpPr txBox="1"/>
                  <p:nvPr/>
                </p:nvSpPr>
                <p:spPr>
                  <a:xfrm>
                    <a:off x="5513107" y="4422573"/>
                    <a:ext cx="841715" cy="27699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9</a:t>
                    </a:r>
                  </a:p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(258 </a:t>
                    </a:r>
                    <a:r>
                      <a:rPr lang="en-US" sz="900" b="1" dirty="0" err="1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bp</a:t>
                    </a:r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)</a:t>
                    </a:r>
                  </a:p>
                </p:txBody>
              </p:sp>
              <p:grpSp>
                <p:nvGrpSpPr>
                  <p:cNvPr id="450" name="Groupe 449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59B3DD3-7923-4546-9410-A6C8F1EFCB52}"/>
                      </a:ext>
                    </a:extLst>
                  </p:cNvPr>
                  <p:cNvGrpSpPr/>
                  <p:nvPr/>
                </p:nvGrpSpPr>
                <p:grpSpPr>
                  <a:xfrm>
                    <a:off x="5467289" y="4785869"/>
                    <a:ext cx="915536" cy="233545"/>
                    <a:chOff x="-1390126" y="3507026"/>
                    <a:chExt cx="915536" cy="233545"/>
                  </a:xfrm>
                </p:grpSpPr>
                <p:sp>
                  <p:nvSpPr>
                    <p:cNvPr id="475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C463842-1DA7-AA42-B8B9-5BECD28F162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1113161" y="3507026"/>
                      <a:ext cx="391930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 err="1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cDNA</a:t>
                      </a:r>
                      <a:endParaRPr lang="en-US" sz="8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476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9109D97-5F8B-8840-9C7F-8B08641B243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1390126" y="3617460"/>
                      <a:ext cx="417823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 err="1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gDNA</a:t>
                      </a:r>
                      <a:endParaRPr lang="en-US" sz="8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477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2E38B92-73C5-714C-AC75-C7D6127E9D9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773875" y="3617460"/>
                      <a:ext cx="299285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RNA</a:t>
                      </a:r>
                    </a:p>
                  </p:txBody>
                </p:sp>
              </p:grpSp>
              <p:sp>
                <p:nvSpPr>
                  <p:cNvPr id="451" name="Parenthèse ouvrante 450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3ACB052-1B33-A146-888A-94D972DB176A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5911105" y="4339823"/>
                    <a:ext cx="45719" cy="800138"/>
                  </a:xfrm>
                  <a:prstGeom prst="leftBracket">
                    <a:avLst/>
                  </a:prstGeom>
                  <a:ln w="19050" cmpd="sng">
                    <a:solidFill>
                      <a:srgbClr val="00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>
                      <a:latin typeface="Arial"/>
                      <a:cs typeface="Arial"/>
                    </a:endParaRPr>
                  </a:p>
                </p:txBody>
              </p:sp>
              <p:grpSp>
                <p:nvGrpSpPr>
                  <p:cNvPr id="452" name="Groupe 451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EAA619B-69B0-9547-9CEB-A7C745FEE43A}"/>
                      </a:ext>
                    </a:extLst>
                  </p:cNvPr>
                  <p:cNvGrpSpPr/>
                  <p:nvPr/>
                </p:nvGrpSpPr>
                <p:grpSpPr>
                  <a:xfrm>
                    <a:off x="4819187" y="5586666"/>
                    <a:ext cx="411543" cy="894877"/>
                    <a:chOff x="-2038228" y="4307823"/>
                    <a:chExt cx="411543" cy="894877"/>
                  </a:xfrm>
                </p:grpSpPr>
                <p:grpSp>
                  <p:nvGrpSpPr>
                    <p:cNvPr id="454" name="Groupe 453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8245426-4510-8246-B662-568BEF684A05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2016588" y="4712844"/>
                      <a:ext cx="389903" cy="184666"/>
                      <a:chOff x="-2016588" y="4712844"/>
                      <a:chExt cx="389903" cy="184666"/>
                    </a:xfrm>
                  </p:grpSpPr>
                  <p:cxnSp>
                    <p:nvCxnSpPr>
                      <p:cNvPr id="473" name="Connecteur droit avec flèche 472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80D4521-98F1-C548-9181-35B7447F1297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-1734685" y="4805177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474" name="Rectangle 473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3F2FE8C-E3CE-4A40-A4F2-A730FECFA16F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-2016588" y="4712844"/>
                        <a:ext cx="314510" cy="184666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600" dirty="0">
                            <a:solidFill>
                              <a:srgbClr val="000000"/>
                            </a:solidFill>
                            <a:latin typeface="Arial"/>
                            <a:cs typeface="Arial"/>
                          </a:rPr>
                          <a:t>600</a:t>
                        </a:r>
                        <a:endParaRPr lang="fr-FR" sz="600" dirty="0">
                          <a:latin typeface="Arial"/>
                          <a:cs typeface="Arial"/>
                        </a:endParaRPr>
                      </a:p>
                    </p:txBody>
                  </p:sp>
                </p:grpSp>
                <p:grpSp>
                  <p:nvGrpSpPr>
                    <p:cNvPr id="455" name="Groupe 454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57A855C-BA30-6141-8B5A-63BD66681521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2038228" y="4307823"/>
                      <a:ext cx="411543" cy="894877"/>
                      <a:chOff x="-2038228" y="4307823"/>
                      <a:chExt cx="411543" cy="894877"/>
                    </a:xfrm>
                  </p:grpSpPr>
                  <p:grpSp>
                    <p:nvGrpSpPr>
                      <p:cNvPr id="456" name="Groupe 455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551F953-BB2C-2B4A-8040-792FBFE15C31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2016588" y="4839887"/>
                        <a:ext cx="389903" cy="184666"/>
                        <a:chOff x="-2016588" y="4839887"/>
                        <a:chExt cx="389903" cy="184666"/>
                      </a:xfrm>
                    </p:grpSpPr>
                    <p:cxnSp>
                      <p:nvCxnSpPr>
                        <p:cNvPr id="471" name="Connecteur droit avec flèche 470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A1D824A-7B06-674B-9C08-6BCD5AE4EB7D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-1734685" y="4942462"/>
                          <a:ext cx="108000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472" name="Rectangle 471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46F27A3-A0F4-1545-9D66-0A1418FDE0D1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2016588" y="4839887"/>
                          <a:ext cx="31451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4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</p:grpSp>
                  <p:grpSp>
                    <p:nvGrpSpPr>
                      <p:cNvPr id="457" name="Groupe 456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8D09E4E-4666-6A47-B1B6-5A5C7BEDA37F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2016588" y="4582417"/>
                        <a:ext cx="389903" cy="184666"/>
                        <a:chOff x="-2016588" y="4563367"/>
                        <a:chExt cx="389903" cy="184666"/>
                      </a:xfrm>
                    </p:grpSpPr>
                    <p:cxnSp>
                      <p:nvCxnSpPr>
                        <p:cNvPr id="469" name="Connecteur droit avec flèche 468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2229BD2-7E48-EB47-BEA6-473D8F91E781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-1734685" y="4659918"/>
                          <a:ext cx="108000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470" name="Rectangle 469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C5EBCB3-67D2-2141-94C8-FF6A94AE311B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2016588" y="4563367"/>
                          <a:ext cx="31451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8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</p:grpSp>
                  <p:grpSp>
                    <p:nvGrpSpPr>
                      <p:cNvPr id="458" name="Groupe 457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2EEA6FA-A567-374C-997D-D0BBA29193B7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2038228" y="4440102"/>
                        <a:ext cx="411543" cy="184666"/>
                        <a:chOff x="-2038228" y="4440102"/>
                        <a:chExt cx="411543" cy="184666"/>
                      </a:xfrm>
                    </p:grpSpPr>
                    <p:sp>
                      <p:nvSpPr>
                        <p:cNvPr id="465" name="Rectangle 464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8294367-C8D1-874C-8C37-0BAB84F5A14D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2038228" y="4440102"/>
                          <a:ext cx="35779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10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  <p:grpSp>
                      <p:nvGrpSpPr>
                        <p:cNvPr id="466" name="Groupe 465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96F4BA0-1945-444C-A5A1-C1F71CD36A15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-1766208" y="4542572"/>
                          <a:ext cx="139523" cy="49020"/>
                          <a:chOff x="337774" y="3729299"/>
                          <a:chExt cx="139523" cy="49020"/>
                        </a:xfrm>
                      </p:grpSpPr>
                      <p:cxnSp>
                        <p:nvCxnSpPr>
                          <p:cNvPr id="467" name="Connecteur droit avec flèche 466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CEBB936-FEB9-CB46-8093-BA91FBE30908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flipH="1">
                            <a:off x="369297" y="3778270"/>
                            <a:ext cx="108000" cy="0"/>
                          </a:xfrm>
                          <a:prstGeom prst="straightConnector1">
                            <a:avLst/>
                          </a:prstGeom>
                          <a:ln>
                            <a:solidFill>
                              <a:schemeClr val="tx1"/>
                            </a:solidFill>
                            <a:headEnd type="none"/>
                            <a:tailEnd type="none"/>
                          </a:ln>
                          <a:effectLst/>
                        </p:spPr>
                        <p:style>
                          <a:lnRef idx="2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1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468" name="Connecteur droit avec flèche 467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E87E552-CB5B-564E-8C59-A96FD9DF71A8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flipH="1" flipV="1">
                            <a:off x="337774" y="3729299"/>
                            <a:ext cx="36000" cy="49020"/>
                          </a:xfrm>
                          <a:prstGeom prst="straightConnector1">
                            <a:avLst/>
                          </a:prstGeom>
                          <a:ln>
                            <a:solidFill>
                              <a:schemeClr val="tx1"/>
                            </a:solidFill>
                            <a:headEnd type="none"/>
                            <a:tailEnd type="none"/>
                          </a:ln>
                          <a:effectLst/>
                        </p:spPr>
                        <p:style>
                          <a:lnRef idx="2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1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</p:grpSp>
                  <p:grpSp>
                    <p:nvGrpSpPr>
                      <p:cNvPr id="459" name="Groupe 458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CFBEF3A-2865-3A48-B08B-C6A1E7B282B6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2038228" y="4307823"/>
                        <a:ext cx="411543" cy="184666"/>
                        <a:chOff x="-2038228" y="4307823"/>
                        <a:chExt cx="411543" cy="184666"/>
                      </a:xfrm>
                    </p:grpSpPr>
                    <p:cxnSp>
                      <p:nvCxnSpPr>
                        <p:cNvPr id="463" name="Connecteur droit avec flèche 462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6FC52A3-192E-7A4F-AA58-7B31DD94630A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-1734685" y="4419323"/>
                          <a:ext cx="108000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464" name="Rectangle 463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7294D01-859C-5D4E-939D-9F97E1AFFA83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2038228" y="4307823"/>
                          <a:ext cx="35779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15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</p:grpSp>
                  <p:grpSp>
                    <p:nvGrpSpPr>
                      <p:cNvPr id="460" name="Groupe 459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0912F9B-DE3B-FD44-9986-F573163EAFE4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2016588" y="5018034"/>
                        <a:ext cx="389903" cy="184666"/>
                        <a:chOff x="-2016588" y="5018034"/>
                        <a:chExt cx="389903" cy="184666"/>
                      </a:xfrm>
                    </p:grpSpPr>
                    <p:cxnSp>
                      <p:nvCxnSpPr>
                        <p:cNvPr id="461" name="Connecteur droit avec flèche 460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B5A14BC-A916-7E45-A36B-2ABC554D7714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-1734685" y="5113885"/>
                          <a:ext cx="108000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462" name="Rectangle 461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C2B345E-7818-904B-83A1-A96F5270BA25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2016588" y="5018034"/>
                          <a:ext cx="31451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2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</p:grpSp>
                </p:grpSp>
              </p:grpSp>
            </p:grpSp>
            <p:pic>
              <p:nvPicPr>
                <p:cNvPr id="478" name="Image 477" descr="D:\Gel\GelDocXRPlus 2018-12-04 14hr 13min.jpg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37CF80D-7DA3-CC48-B778-1C94365A9C42}"/>
                    </a:ext>
                  </a:extLst>
                </p:cNvPr>
                <p:cNvPicPr/>
                <p:nvPr/>
              </p:nvPicPr>
              <p:blipFill rotWithShape="1">
                <a:blip r:embed="rId8">
                  <a:extLst>
                    <a:ext uri="{28A0092B-C50C-407E-A947-70E740481C1C}">
                      <a14:useLocalDpi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val="0"/>
                    </a:ext>
                  </a:extLst>
                </a:blip>
                <a:srcRect l="38495" t="36303" r="43339" b="6369"/>
                <a:stretch/>
              </p:blipFill>
              <p:spPr bwMode="auto">
                <a:xfrm>
                  <a:off x="873797" y="6120314"/>
                  <a:ext cx="1152000" cy="13968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53640926-AAD7-44D8-BBD7-CCE9431645EC}">
                    <a14:shadowObscured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/>
                  </a:ext>
                </a:extLst>
              </p:spPr>
            </p:pic>
          </p:grpSp>
          <p:grpSp>
            <p:nvGrpSpPr>
              <p:cNvPr id="35" name="Groupe 34">
                <a:extLst>
                  <a:ext uri="{FF2B5EF4-FFF2-40B4-BE49-F238E27FC236}">
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8373D4D-924E-634A-9FE0-7866DCECDBD8}"/>
                  </a:ext>
                </a:extLst>
              </p:cNvPr>
              <p:cNvGrpSpPr/>
              <p:nvPr/>
            </p:nvGrpSpPr>
            <p:grpSpPr>
              <a:xfrm>
                <a:off x="3365388" y="7243140"/>
                <a:ext cx="1577706" cy="2066004"/>
                <a:chOff x="3859164" y="6610458"/>
                <a:chExt cx="1577706" cy="2066004"/>
              </a:xfrm>
            </p:grpSpPr>
            <p:grpSp>
              <p:nvGrpSpPr>
                <p:cNvPr id="510" name="Groupe 509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8F9260C-5984-024A-8A29-87072C0CB67D}"/>
                    </a:ext>
                  </a:extLst>
                </p:cNvPr>
                <p:cNvGrpSpPr/>
                <p:nvPr/>
              </p:nvGrpSpPr>
              <p:grpSpPr>
                <a:xfrm>
                  <a:off x="3859164" y="6610458"/>
                  <a:ext cx="1577706" cy="2066004"/>
                  <a:chOff x="4819187" y="4528083"/>
                  <a:chExt cx="1577706" cy="2066004"/>
                </a:xfrm>
              </p:grpSpPr>
              <p:sp>
                <p:nvSpPr>
                  <p:cNvPr id="511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00D30ED-29E8-F045-8794-866F63CB3D59}"/>
                      </a:ext>
                    </a:extLst>
                  </p:cNvPr>
                  <p:cNvSpPr txBox="1"/>
                  <p:nvPr/>
                </p:nvSpPr>
                <p:spPr>
                  <a:xfrm>
                    <a:off x="5527175" y="4528083"/>
                    <a:ext cx="841715" cy="27699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11</a:t>
                    </a:r>
                  </a:p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(259 </a:t>
                    </a:r>
                    <a:r>
                      <a:rPr lang="en-US" sz="900" b="1" dirty="0" err="1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bp</a:t>
                    </a:r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)</a:t>
                    </a:r>
                  </a:p>
                </p:txBody>
              </p:sp>
              <p:grpSp>
                <p:nvGrpSpPr>
                  <p:cNvPr id="512" name="Groupe 511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BFECA06-C2E3-5F47-A920-0A8D91BE2F34}"/>
                      </a:ext>
                    </a:extLst>
                  </p:cNvPr>
                  <p:cNvGrpSpPr/>
                  <p:nvPr/>
                </p:nvGrpSpPr>
                <p:grpSpPr>
                  <a:xfrm>
                    <a:off x="5481357" y="4898413"/>
                    <a:ext cx="915536" cy="233545"/>
                    <a:chOff x="-1376058" y="3619570"/>
                    <a:chExt cx="915536" cy="233545"/>
                  </a:xfrm>
                </p:grpSpPr>
                <p:sp>
                  <p:nvSpPr>
                    <p:cNvPr id="536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91D083D-3233-7246-B018-F61EBB973CF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1099093" y="3619570"/>
                      <a:ext cx="391930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 err="1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cDNA</a:t>
                      </a:r>
                      <a:endParaRPr lang="en-US" sz="8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537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53FCEC5-984D-A74A-A96D-CB95C02F365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1376058" y="3730004"/>
                      <a:ext cx="417823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 err="1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gDNA</a:t>
                      </a:r>
                      <a:endParaRPr lang="en-US" sz="8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538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7669209-C021-5A41-99F6-4A98C979A78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759807" y="3730004"/>
                      <a:ext cx="299285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RNA</a:t>
                      </a:r>
                    </a:p>
                  </p:txBody>
                </p:sp>
              </p:grpSp>
              <p:sp>
                <p:nvSpPr>
                  <p:cNvPr id="513" name="Parenthèse ouvrante 512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AF2AC2E-9E76-124F-B0EA-C3C92500A31B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5925173" y="4445333"/>
                    <a:ext cx="45719" cy="800138"/>
                  </a:xfrm>
                  <a:prstGeom prst="leftBracket">
                    <a:avLst/>
                  </a:prstGeom>
                  <a:ln w="19050" cmpd="sng">
                    <a:solidFill>
                      <a:srgbClr val="00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>
                      <a:latin typeface="Arial"/>
                      <a:cs typeface="Arial"/>
                    </a:endParaRPr>
                  </a:p>
                </p:txBody>
              </p:sp>
              <p:grpSp>
                <p:nvGrpSpPr>
                  <p:cNvPr id="514" name="Groupe 513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A8F586E-9EF3-1D45-8E23-E4B8DEE032E3}"/>
                      </a:ext>
                    </a:extLst>
                  </p:cNvPr>
                  <p:cNvGrpSpPr/>
                  <p:nvPr/>
                </p:nvGrpSpPr>
                <p:grpSpPr>
                  <a:xfrm>
                    <a:off x="4819187" y="5734380"/>
                    <a:ext cx="411543" cy="859707"/>
                    <a:chOff x="-2038228" y="4455537"/>
                    <a:chExt cx="411543" cy="859707"/>
                  </a:xfrm>
                </p:grpSpPr>
                <p:grpSp>
                  <p:nvGrpSpPr>
                    <p:cNvPr id="515" name="Groupe 514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7E11AD0-97A1-594A-9C91-778AAA64DE12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2016588" y="4832422"/>
                      <a:ext cx="389903" cy="184666"/>
                      <a:chOff x="-2016588" y="4832422"/>
                      <a:chExt cx="389903" cy="184666"/>
                    </a:xfrm>
                  </p:grpSpPr>
                  <p:cxnSp>
                    <p:nvCxnSpPr>
                      <p:cNvPr id="534" name="Connecteur droit avec flèche 533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9663303-EABA-2C49-9CD0-BDF3BD0F2C57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-1734685" y="4924755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535" name="Rectangle 534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D08FD95-BE9A-3C48-86D5-A00502C900A8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-2016588" y="4832422"/>
                        <a:ext cx="314510" cy="184666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600" dirty="0">
                            <a:solidFill>
                              <a:srgbClr val="000000"/>
                            </a:solidFill>
                            <a:latin typeface="Arial"/>
                            <a:cs typeface="Arial"/>
                          </a:rPr>
                          <a:t>600</a:t>
                        </a:r>
                        <a:endParaRPr lang="fr-FR" sz="600" dirty="0">
                          <a:latin typeface="Arial"/>
                          <a:cs typeface="Arial"/>
                        </a:endParaRPr>
                      </a:p>
                    </p:txBody>
                  </p:sp>
                </p:grpSp>
                <p:grpSp>
                  <p:nvGrpSpPr>
                    <p:cNvPr id="516" name="Groupe 51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5627DD0-18ED-D941-B844-5AA94EEC8876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2038228" y="4455537"/>
                      <a:ext cx="411543" cy="859707"/>
                      <a:chOff x="-2038228" y="4455537"/>
                      <a:chExt cx="411543" cy="859707"/>
                    </a:xfrm>
                  </p:grpSpPr>
                  <p:grpSp>
                    <p:nvGrpSpPr>
                      <p:cNvPr id="517" name="Groupe 516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371C3E3-F512-9E47-8FCB-0E36587BEA2C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2016588" y="4952431"/>
                        <a:ext cx="389903" cy="184666"/>
                        <a:chOff x="-2016588" y="4952431"/>
                        <a:chExt cx="389903" cy="184666"/>
                      </a:xfrm>
                    </p:grpSpPr>
                    <p:cxnSp>
                      <p:nvCxnSpPr>
                        <p:cNvPr id="532" name="Connecteur droit avec flèche 531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902822F-B536-364E-B92B-1C457BF01358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-1734685" y="5055006"/>
                          <a:ext cx="108000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533" name="Rectangle 532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E572FFF-8870-334D-95E0-47779A7C7E70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2016588" y="4952431"/>
                          <a:ext cx="31451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4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</p:grpSp>
                  <p:grpSp>
                    <p:nvGrpSpPr>
                      <p:cNvPr id="518" name="Groupe 517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40F4D7A-C0CA-C94D-9A8E-B0C17D95A76E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2016588" y="4730131"/>
                        <a:ext cx="389903" cy="184666"/>
                        <a:chOff x="-2016588" y="4711081"/>
                        <a:chExt cx="389903" cy="184666"/>
                      </a:xfrm>
                    </p:grpSpPr>
                    <p:cxnSp>
                      <p:nvCxnSpPr>
                        <p:cNvPr id="530" name="Connecteur droit avec flèche 529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43F9A3F-FD06-E643-9723-2C06D8C2D93C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-1734685" y="4807632"/>
                          <a:ext cx="108000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531" name="Rectangle 530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3CEC7A4-4926-E645-95CD-4C52932B6E12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2016588" y="4711081"/>
                          <a:ext cx="31451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8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</p:grpSp>
                  <p:grpSp>
                    <p:nvGrpSpPr>
                      <p:cNvPr id="519" name="Groupe 518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91E3EDF-EB1D-6542-88B6-F775DCC3E5BC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2038228" y="4580782"/>
                        <a:ext cx="411543" cy="184666"/>
                        <a:chOff x="-2038228" y="4580782"/>
                        <a:chExt cx="411543" cy="184666"/>
                      </a:xfrm>
                    </p:grpSpPr>
                    <p:sp>
                      <p:nvSpPr>
                        <p:cNvPr id="526" name="Rectangle 525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B56A874-0733-F349-8A30-9D46E51BDA7E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2038228" y="4580782"/>
                          <a:ext cx="35779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10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  <p:grpSp>
                      <p:nvGrpSpPr>
                        <p:cNvPr id="527" name="Groupe 526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097A01C-4552-904B-BA0C-BC95B67892E3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-1766208" y="4683252"/>
                          <a:ext cx="139523" cy="49020"/>
                          <a:chOff x="337774" y="3869979"/>
                          <a:chExt cx="139523" cy="49020"/>
                        </a:xfrm>
                      </p:grpSpPr>
                      <p:cxnSp>
                        <p:nvCxnSpPr>
                          <p:cNvPr id="528" name="Connecteur droit avec flèche 527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9DE5DDA-5D97-7548-AF51-9BEBEE03FD8E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flipH="1">
                            <a:off x="369297" y="3918950"/>
                            <a:ext cx="108000" cy="0"/>
                          </a:xfrm>
                          <a:prstGeom prst="straightConnector1">
                            <a:avLst/>
                          </a:prstGeom>
                          <a:ln>
                            <a:solidFill>
                              <a:schemeClr val="tx1"/>
                            </a:solidFill>
                            <a:headEnd type="none"/>
                            <a:tailEnd type="none"/>
                          </a:ln>
                          <a:effectLst/>
                        </p:spPr>
                        <p:style>
                          <a:lnRef idx="2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1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529" name="Connecteur droit avec flèche 528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3E40DB5-6277-6E4F-AE7A-B6F6587DCDD0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flipH="1" flipV="1">
                            <a:off x="337774" y="3869979"/>
                            <a:ext cx="36000" cy="49020"/>
                          </a:xfrm>
                          <a:prstGeom prst="straightConnector1">
                            <a:avLst/>
                          </a:prstGeom>
                          <a:ln>
                            <a:solidFill>
                              <a:schemeClr val="tx1"/>
                            </a:solidFill>
                            <a:headEnd type="none"/>
                            <a:tailEnd type="none"/>
                          </a:ln>
                          <a:effectLst/>
                        </p:spPr>
                        <p:style>
                          <a:lnRef idx="2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1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</p:grpSp>
                  <p:grpSp>
                    <p:nvGrpSpPr>
                      <p:cNvPr id="520" name="Groupe 519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E4379C0-A0A7-FF4B-9F91-3674DE976A00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2038228" y="4455537"/>
                        <a:ext cx="411543" cy="184666"/>
                        <a:chOff x="-2038228" y="4455537"/>
                        <a:chExt cx="411543" cy="184666"/>
                      </a:xfrm>
                    </p:grpSpPr>
                    <p:cxnSp>
                      <p:nvCxnSpPr>
                        <p:cNvPr id="524" name="Connecteur droit avec flèche 523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09102B3-CFA2-7940-884E-90E5E5441CA3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-1734685" y="4567037"/>
                          <a:ext cx="108000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525" name="Rectangle 524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94660C6-4B5F-8649-9071-AE848363589A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2038228" y="4455537"/>
                          <a:ext cx="35779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15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</p:grpSp>
                  <p:grpSp>
                    <p:nvGrpSpPr>
                      <p:cNvPr id="521" name="Groupe 520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ED2E3FF-E426-FA49-A1E6-078052BF02FE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2016588" y="5130578"/>
                        <a:ext cx="389903" cy="184666"/>
                        <a:chOff x="-2016588" y="5130578"/>
                        <a:chExt cx="389903" cy="184666"/>
                      </a:xfrm>
                    </p:grpSpPr>
                    <p:cxnSp>
                      <p:nvCxnSpPr>
                        <p:cNvPr id="522" name="Connecteur droit avec flèche 521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1E7E052-13C1-5142-AC80-A149D6D14FC4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-1734685" y="5226429"/>
                          <a:ext cx="108000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523" name="Rectangle 522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08FE80A-463B-D441-AC96-D3230CE75FA0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2016588" y="5130578"/>
                          <a:ext cx="31451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2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</p:grpSp>
                </p:grpSp>
              </p:grpSp>
            </p:grpSp>
            <p:pic>
              <p:nvPicPr>
                <p:cNvPr id="540" name="Image 539" descr="D:\Gel\GelDocXRPlus 2018-12-04 14hr 13min.jpg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1BAF5B6-8A54-1E4E-9E7A-33A632BEADE2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 rotWithShape="1">
                <a:blip r:embed="rId8">
                  <a:extLst>
                    <a:ext uri="{28A0092B-C50C-407E-A947-70E740481C1C}">
                      <a14:useLocalDpi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val="0"/>
                    </a:ext>
                  </a:extLst>
                </a:blip>
                <a:srcRect l="73379" t="36530" r="9019" b="6142"/>
                <a:stretch/>
              </p:blipFill>
              <p:spPr bwMode="auto">
                <a:xfrm>
                  <a:off x="4266909" y="7265003"/>
                  <a:ext cx="1152000" cy="13968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53640926-AAD7-44d8-BBD7-CCE9431645EC}">
                    <a14:shadowObscured xmlns:a="http://schemas.openxmlformats.org/drawingml/2006/main" xmlns:r="http://schemas.openxmlformats.org/officeDocument/2006/relationships" xmlns:p="http://schemas.openxmlformats.org/presentationml/2006/main" xmlns="" xmlns:a14="http://schemas.microsoft.com/office/drawing/2010/main" xmlns:mv="urn:schemas-microsoft-com:mac:vml" xmlns:mc="http://schemas.openxmlformats.org/markup-compatibility/2006"/>
                  </a:ext>
                </a:extLst>
              </p:spPr>
            </p:pic>
          </p:grpSp>
          <p:grpSp>
            <p:nvGrpSpPr>
              <p:cNvPr id="541" name="Groupe 540">
                <a:extLst>
                  <a:ext uri="{FF2B5EF4-FFF2-40B4-BE49-F238E27FC236}">
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D499F01-51E0-C646-835E-84E517A95B32}"/>
                  </a:ext>
                </a:extLst>
              </p:cNvPr>
              <p:cNvGrpSpPr/>
              <p:nvPr/>
            </p:nvGrpSpPr>
            <p:grpSpPr>
              <a:xfrm>
                <a:off x="1898007" y="7255672"/>
                <a:ext cx="1562029" cy="2066004"/>
                <a:chOff x="2129654" y="6414318"/>
                <a:chExt cx="1562029" cy="2066004"/>
              </a:xfrm>
            </p:grpSpPr>
            <p:pic>
              <p:nvPicPr>
                <p:cNvPr id="542" name="Image 541" descr="D:\Gel\GelDocXRPlus 2018-12-04 14hr 13min.jpg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CF453C4-425A-EF4A-8EB1-57948130674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>
                  <a:extLst>
                    <a:ext uri="{28A0092B-C50C-407E-A947-70E740481C1C}">
                      <a14:useLocalDpi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val="0"/>
                    </a:ext>
                  </a:extLst>
                </a:blip>
                <a:srcRect l="55655" t="36530" r="26179" b="6142"/>
                <a:stretch/>
              </p:blipFill>
              <p:spPr bwMode="auto">
                <a:xfrm>
                  <a:off x="2539683" y="7066362"/>
                  <a:ext cx="1152000" cy="138925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53640926-AAD7-44d8-BBD7-CCE9431645EC}">
                    <a14:shadowObscured xmlns:a="http://schemas.openxmlformats.org/drawingml/2006/main" xmlns:r="http://schemas.openxmlformats.org/officeDocument/2006/relationships" xmlns:p="http://schemas.openxmlformats.org/presentationml/2006/main" xmlns="" xmlns:a14="http://schemas.microsoft.com/office/drawing/2010/main" xmlns:mv="urn:schemas-microsoft-com:mac:vml" xmlns:mc="http://schemas.openxmlformats.org/markup-compatibility/2006"/>
                  </a:ext>
                </a:extLst>
              </p:spPr>
            </p:pic>
            <p:grpSp>
              <p:nvGrpSpPr>
                <p:cNvPr id="543" name="Groupe 542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C8E638E-9BA2-7543-A807-DAA67D91B6AA}"/>
                    </a:ext>
                  </a:extLst>
                </p:cNvPr>
                <p:cNvGrpSpPr/>
                <p:nvPr/>
              </p:nvGrpSpPr>
              <p:grpSpPr>
                <a:xfrm>
                  <a:off x="2129654" y="6414318"/>
                  <a:ext cx="1542536" cy="2066004"/>
                  <a:chOff x="4819187" y="4415539"/>
                  <a:chExt cx="1542536" cy="2066004"/>
                </a:xfrm>
              </p:grpSpPr>
              <p:sp>
                <p:nvSpPr>
                  <p:cNvPr id="544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17FC27B-235D-0246-B30C-E689F6C19053}"/>
                      </a:ext>
                    </a:extLst>
                  </p:cNvPr>
                  <p:cNvSpPr txBox="1"/>
                  <p:nvPr/>
                </p:nvSpPr>
                <p:spPr>
                  <a:xfrm>
                    <a:off x="5492005" y="4415539"/>
                    <a:ext cx="841715" cy="27699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10</a:t>
                    </a:r>
                  </a:p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(233 </a:t>
                    </a:r>
                    <a:r>
                      <a:rPr lang="en-US" sz="900" b="1" dirty="0" err="1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bp</a:t>
                    </a:r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)</a:t>
                    </a:r>
                  </a:p>
                </p:txBody>
              </p:sp>
              <p:grpSp>
                <p:nvGrpSpPr>
                  <p:cNvPr id="545" name="Groupe 54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92F73BE-D637-6141-A863-2A5EC531C87F}"/>
                      </a:ext>
                    </a:extLst>
                  </p:cNvPr>
                  <p:cNvGrpSpPr/>
                  <p:nvPr/>
                </p:nvGrpSpPr>
                <p:grpSpPr>
                  <a:xfrm>
                    <a:off x="5446187" y="4785869"/>
                    <a:ext cx="915536" cy="233545"/>
                    <a:chOff x="-1411228" y="3507026"/>
                    <a:chExt cx="915536" cy="233545"/>
                  </a:xfrm>
                </p:grpSpPr>
                <p:sp>
                  <p:nvSpPr>
                    <p:cNvPr id="569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564A439-D5B9-774D-A5FF-CB26D5EA9C5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1134263" y="3507026"/>
                      <a:ext cx="391930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 err="1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cDNA</a:t>
                      </a:r>
                      <a:endParaRPr lang="en-US" sz="8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570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6862434-BF0B-294A-9476-DE289E3FE3B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1411228" y="3617460"/>
                      <a:ext cx="417823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 err="1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gDNA</a:t>
                      </a:r>
                      <a:endParaRPr lang="en-US" sz="8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571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DAAB283-050B-B442-AEE2-1587EDC5A93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794977" y="3617460"/>
                      <a:ext cx="299285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RNA</a:t>
                      </a:r>
                    </a:p>
                  </p:txBody>
                </p:sp>
              </p:grpSp>
              <p:sp>
                <p:nvSpPr>
                  <p:cNvPr id="546" name="Parenthèse ouvrante 54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0B03C7E-A74F-8F4B-A37B-A047EC180DCF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5890003" y="4332789"/>
                    <a:ext cx="45719" cy="800138"/>
                  </a:xfrm>
                  <a:prstGeom prst="leftBracket">
                    <a:avLst/>
                  </a:prstGeom>
                  <a:ln w="19050" cmpd="sng">
                    <a:solidFill>
                      <a:srgbClr val="00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>
                      <a:latin typeface="Arial"/>
                      <a:cs typeface="Arial"/>
                    </a:endParaRPr>
                  </a:p>
                </p:txBody>
              </p:sp>
              <p:grpSp>
                <p:nvGrpSpPr>
                  <p:cNvPr id="547" name="Groupe 546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9577801-F1BB-FF4F-8613-911CCF93DC83}"/>
                      </a:ext>
                    </a:extLst>
                  </p:cNvPr>
                  <p:cNvGrpSpPr/>
                  <p:nvPr/>
                </p:nvGrpSpPr>
                <p:grpSpPr>
                  <a:xfrm>
                    <a:off x="4819187" y="5621836"/>
                    <a:ext cx="411543" cy="859707"/>
                    <a:chOff x="-2038228" y="4342993"/>
                    <a:chExt cx="411543" cy="859707"/>
                  </a:xfrm>
                </p:grpSpPr>
                <p:grpSp>
                  <p:nvGrpSpPr>
                    <p:cNvPr id="548" name="Groupe 547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65AF4B5-38A1-094C-BE0E-5A5A4A4B85AC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2016588" y="4712844"/>
                      <a:ext cx="389903" cy="184666"/>
                      <a:chOff x="-2016588" y="4712844"/>
                      <a:chExt cx="389903" cy="184666"/>
                    </a:xfrm>
                  </p:grpSpPr>
                  <p:cxnSp>
                    <p:nvCxnSpPr>
                      <p:cNvPr id="567" name="Connecteur droit avec flèche 566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10CFD71-6D1E-1D49-9967-193EB38F3FFB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-1734685" y="4805177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568" name="Rectangle 567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5CF895A-82AE-AB4E-AE87-9FC3688581C5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-2016588" y="4712844"/>
                        <a:ext cx="314510" cy="184666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600" dirty="0">
                            <a:solidFill>
                              <a:srgbClr val="000000"/>
                            </a:solidFill>
                            <a:latin typeface="Arial"/>
                            <a:cs typeface="Arial"/>
                          </a:rPr>
                          <a:t>600</a:t>
                        </a:r>
                        <a:endParaRPr lang="fr-FR" sz="600" dirty="0">
                          <a:latin typeface="Arial"/>
                          <a:cs typeface="Arial"/>
                        </a:endParaRPr>
                      </a:p>
                    </p:txBody>
                  </p:sp>
                </p:grpSp>
                <p:grpSp>
                  <p:nvGrpSpPr>
                    <p:cNvPr id="549" name="Groupe 548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1591B54-5380-9B4E-AAE4-11DF28FE914D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2038228" y="4342993"/>
                      <a:ext cx="411543" cy="859707"/>
                      <a:chOff x="-2038228" y="4342993"/>
                      <a:chExt cx="411543" cy="859707"/>
                    </a:xfrm>
                  </p:grpSpPr>
                  <p:grpSp>
                    <p:nvGrpSpPr>
                      <p:cNvPr id="550" name="Groupe 549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5B89D54-05EE-4848-A3E9-0B1CF495EE18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2016588" y="4846921"/>
                        <a:ext cx="389903" cy="184666"/>
                        <a:chOff x="-2016588" y="4846921"/>
                        <a:chExt cx="389903" cy="184666"/>
                      </a:xfrm>
                    </p:grpSpPr>
                    <p:cxnSp>
                      <p:nvCxnSpPr>
                        <p:cNvPr id="565" name="Connecteur droit avec flèche 564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5D7E113-AD72-8947-A433-08D7EE9B2A71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-1734685" y="4949496"/>
                          <a:ext cx="108000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566" name="Rectangle 565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4764AC9-D4FD-FC47-A6B4-25B658EFD8A8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2016588" y="4846921"/>
                          <a:ext cx="31451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4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</p:grpSp>
                  <p:grpSp>
                    <p:nvGrpSpPr>
                      <p:cNvPr id="551" name="Groupe 550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B9BD35B-7B9C-BC48-A6FC-79E44771049E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2016588" y="4596485"/>
                        <a:ext cx="389903" cy="184666"/>
                        <a:chOff x="-2016588" y="4577435"/>
                        <a:chExt cx="389903" cy="184666"/>
                      </a:xfrm>
                    </p:grpSpPr>
                    <p:cxnSp>
                      <p:nvCxnSpPr>
                        <p:cNvPr id="563" name="Connecteur droit avec flèche 562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AD475FB-CE83-934D-BC40-069B4FEE541A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-1734685" y="4673986"/>
                          <a:ext cx="108000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564" name="Rectangle 563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BFA69F8-319A-904E-A14E-6918BA471DE1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2016588" y="4577435"/>
                          <a:ext cx="31451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8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</p:grpSp>
                  <p:grpSp>
                    <p:nvGrpSpPr>
                      <p:cNvPr id="552" name="Groupe 551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080C47E-F6EE-8D44-8169-90279A146FF0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2038228" y="4447136"/>
                        <a:ext cx="411543" cy="184666"/>
                        <a:chOff x="-2038228" y="4447136"/>
                        <a:chExt cx="411543" cy="184666"/>
                      </a:xfrm>
                    </p:grpSpPr>
                    <p:sp>
                      <p:nvSpPr>
                        <p:cNvPr id="559" name="Rectangle 558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41D1229-60A3-7D44-8C8D-4F7DC771C628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2038228" y="4447136"/>
                          <a:ext cx="35779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10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  <p:grpSp>
                      <p:nvGrpSpPr>
                        <p:cNvPr id="560" name="Groupe 559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8445800-FFF7-5A47-BEF7-2CE34E9B013C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-1766208" y="4549606"/>
                          <a:ext cx="139523" cy="49020"/>
                          <a:chOff x="337774" y="3736333"/>
                          <a:chExt cx="139523" cy="49020"/>
                        </a:xfrm>
                      </p:grpSpPr>
                      <p:cxnSp>
                        <p:nvCxnSpPr>
                          <p:cNvPr id="561" name="Connecteur droit avec flèche 560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E6F5AC9-8375-084D-A7EB-70F8239E4098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flipH="1">
                            <a:off x="369297" y="3785304"/>
                            <a:ext cx="108000" cy="0"/>
                          </a:xfrm>
                          <a:prstGeom prst="straightConnector1">
                            <a:avLst/>
                          </a:prstGeom>
                          <a:ln>
                            <a:solidFill>
                              <a:schemeClr val="tx1"/>
                            </a:solidFill>
                            <a:headEnd type="none"/>
                            <a:tailEnd type="none"/>
                          </a:ln>
                          <a:effectLst/>
                        </p:spPr>
                        <p:style>
                          <a:lnRef idx="2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1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562" name="Connecteur droit avec flèche 561">
                            <a:extLst>
                              <a:ext uri="{FF2B5EF4-FFF2-40B4-BE49-F238E27FC236}">
  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08F43FB-DDEA-A047-BA3E-05C16EA8050D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 flipH="1" flipV="1">
                            <a:off x="337774" y="3736333"/>
                            <a:ext cx="36000" cy="49020"/>
                          </a:xfrm>
                          <a:prstGeom prst="straightConnector1">
                            <a:avLst/>
                          </a:prstGeom>
                          <a:ln>
                            <a:solidFill>
                              <a:schemeClr val="tx1"/>
                            </a:solidFill>
                            <a:headEnd type="none"/>
                            <a:tailEnd type="none"/>
                          </a:ln>
                          <a:effectLst/>
                        </p:spPr>
                        <p:style>
                          <a:lnRef idx="2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1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</p:grpSp>
                  <p:grpSp>
                    <p:nvGrpSpPr>
                      <p:cNvPr id="553" name="Groupe 552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E9DD17C-712D-5B4D-AD77-96AF8C92135A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2038228" y="4342993"/>
                        <a:ext cx="411543" cy="184666"/>
                        <a:chOff x="-2038228" y="4342993"/>
                        <a:chExt cx="411543" cy="184666"/>
                      </a:xfrm>
                    </p:grpSpPr>
                    <p:cxnSp>
                      <p:nvCxnSpPr>
                        <p:cNvPr id="557" name="Connecteur droit avec flèche 556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B1E9226-A091-8241-A59C-757DC06122C3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-1734685" y="4454493"/>
                          <a:ext cx="108000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558" name="Rectangle 557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9C71ECB-A370-564C-83E0-A9F8C7307A6E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2038228" y="4342993"/>
                          <a:ext cx="35779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15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</p:grpSp>
                  <p:grpSp>
                    <p:nvGrpSpPr>
                      <p:cNvPr id="554" name="Groupe 553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5EBEF6A-665D-5B44-A524-308A0352D15B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2016588" y="5018034"/>
                        <a:ext cx="389903" cy="184666"/>
                        <a:chOff x="-2016588" y="5018034"/>
                        <a:chExt cx="389903" cy="184666"/>
                      </a:xfrm>
                    </p:grpSpPr>
                    <p:cxnSp>
                      <p:nvCxnSpPr>
                        <p:cNvPr id="555" name="Connecteur droit avec flèche 554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F34B291-852A-A749-8077-F3104F4FDD04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-1734685" y="5113885"/>
                          <a:ext cx="108000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556" name="Rectangle 555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81715CF-F89A-5D4C-9C9A-2864D5CB29ED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-2016588" y="5018034"/>
                          <a:ext cx="314510" cy="184666"/>
                        </a:xfrm>
                        <a:prstGeom prst="rect">
                          <a:avLst/>
                        </a:prstGeom>
                      </p:spPr>
                      <p:txBody>
                        <a:bodyPr wrap="none">
                          <a:spAutoFit/>
                        </a:bodyPr>
                        <a:lstStyle/>
                        <a:p>
                          <a:r>
                            <a:rPr lang="en-US" sz="600" dirty="0">
                              <a:solidFill>
                                <a:srgbClr val="000000"/>
                              </a:solidFill>
                              <a:latin typeface="Arial"/>
                              <a:cs typeface="Arial"/>
                            </a:rPr>
                            <a:t>200</a:t>
                          </a:r>
                          <a:endParaRPr lang="fr-FR" sz="600" dirty="0">
                            <a:latin typeface="Arial"/>
                            <a:cs typeface="Arial"/>
                          </a:endParaRPr>
                        </a:p>
                      </p:txBody>
                    </p:sp>
                  </p:grpSp>
                </p:grpSp>
              </p:grpSp>
            </p:grpSp>
          </p:grpSp>
          <p:sp>
            <p:nvSpPr>
              <p:cNvPr id="480" name="ZoneTexte 479">
                <a:extLst>
                  <a:ext uri="{FF2B5EF4-FFF2-40B4-BE49-F238E27FC236}">
                    <a16:creationId xmlns:mc="http://schemas.openxmlformats.org/markup-compatibility/2006" xmlns:mv="urn:schemas-microsoft-com:mac:vml"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E93FB91A-18A8-AD4F-9214-A76DD0BC2D3E}"/>
                  </a:ext>
                </a:extLst>
              </p:cNvPr>
              <p:cNvSpPr txBox="1"/>
              <p:nvPr/>
            </p:nvSpPr>
            <p:spPr>
              <a:xfrm>
                <a:off x="242903" y="2740956"/>
                <a:ext cx="33284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600" b="1" dirty="0">
                    <a:latin typeface="Arial"/>
                    <a:cs typeface="Arial"/>
                  </a:rPr>
                  <a:t>B</a:t>
                </a:r>
              </a:p>
            </p:txBody>
          </p:sp>
        </p:grpSp>
      </p:grp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85074661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a="http://schemas.openxmlformats.org/drawingml/2006/main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4</TotalTime>
  <Words>260</Words>
  <Application>Microsoft Macintosh PowerPoint</Application>
  <PresentationFormat>Format A4 (210 x 297 mm)</PresentationFormat>
  <Paragraphs>186</Paragraphs>
  <Slides>1</Slides>
  <Notes>0</Notes>
  <HiddenSlides>0</HiddenSlides>
  <MMClips>0</MMClips>
  <ScaleCrop>false</ScaleCrop>
  <HeadingPairs>
    <vt:vector size="4" baseType="variant">
      <vt:variant>
        <vt:lpstr>Modèle de conception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rosoft Office User</dc:creator>
  <cp:lastModifiedBy>nadia benaroudj</cp:lastModifiedBy>
  <cp:revision>22</cp:revision>
  <cp:lastPrinted>2020-03-17T20:47:57Z</cp:lastPrinted>
  <dcterms:created xsi:type="dcterms:W3CDTF">2020-04-03T13:27:38Z</dcterms:created>
  <dcterms:modified xsi:type="dcterms:W3CDTF">2020-04-03T13:32:47Z</dcterms:modified>
</cp:coreProperties>
</file>